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7" r:id="rId3"/>
    <p:sldId id="258" r:id="rId4"/>
    <p:sldId id="262" r:id="rId5"/>
    <p:sldId id="264" r:id="rId6"/>
    <p:sldId id="261" r:id="rId7"/>
    <p:sldId id="265" r:id="rId8"/>
    <p:sldId id="266" r:id="rId9"/>
    <p:sldId id="259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7386" autoAdjust="0"/>
  </p:normalViewPr>
  <p:slideViewPr>
    <p:cSldViewPr snapToGrid="0">
      <p:cViewPr varScale="1">
        <p:scale>
          <a:sx n="108" d="100"/>
          <a:sy n="108" d="100"/>
        </p:scale>
        <p:origin x="1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3">
  <dgm:title val=""/>
  <dgm:desc val=""/>
  <dgm:catLst>
    <dgm:cat type="accent1" pri="11300"/>
  </dgm:catLst>
  <dgm:styleLbl name="node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1">
        <a:shade val="80000"/>
      </a:schemeClr>
      <a:schemeClr val="accent1">
        <a:tint val="7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/>
    <dgm:txEffectClrLst/>
  </dgm:styleLbl>
  <dgm:styleLbl name="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1">
        <a:shade val="80000"/>
        <a:alpha val="50000"/>
      </a:schemeClr>
      <a:schemeClr val="accent1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/>
    <dgm:txEffectClrLst/>
  </dgm:styleLbl>
  <dgm:styleLbl name="f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>
        <a:tint val="90000"/>
      </a:schemeClr>
    </dgm:fillClrLst>
    <dgm:linClrLst meth="repeat">
      <a:schemeClr val="accent1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1">
        <a:tint val="5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>
        <a:shade val="8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>
        <a:tint val="99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>
        <a:tint val="8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3">
  <dgm:title val=""/>
  <dgm:desc val=""/>
  <dgm:catLst>
    <dgm:cat type="accent1" pri="11300"/>
  </dgm:catLst>
  <dgm:styleLbl name="node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1">
        <a:shade val="80000"/>
      </a:schemeClr>
      <a:schemeClr val="accent1">
        <a:tint val="7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/>
    <dgm:txEffectClrLst/>
  </dgm:styleLbl>
  <dgm:styleLbl name="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1">
        <a:shade val="80000"/>
        <a:alpha val="50000"/>
      </a:schemeClr>
      <a:schemeClr val="accent1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/>
    <dgm:txEffectClrLst/>
  </dgm:styleLbl>
  <dgm:styleLbl name="f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>
        <a:tint val="90000"/>
      </a:schemeClr>
    </dgm:fillClrLst>
    <dgm:linClrLst meth="repeat">
      <a:schemeClr val="accent1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1">
        <a:tint val="5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>
        <a:shade val="8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>
        <a:tint val="99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>
        <a:tint val="8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3">
  <dgm:title val=""/>
  <dgm:desc val=""/>
  <dgm:catLst>
    <dgm:cat type="accent1" pri="11300"/>
  </dgm:catLst>
  <dgm:styleLbl name="node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1">
        <a:shade val="80000"/>
      </a:schemeClr>
      <a:schemeClr val="accent1">
        <a:tint val="7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/>
    <dgm:txEffectClrLst/>
  </dgm:styleLbl>
  <dgm:styleLbl name="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>
      <a:schemeClr val="accent1">
        <a:shade val="80000"/>
      </a:schemeClr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1">
        <a:shade val="80000"/>
        <a:alpha val="50000"/>
      </a:schemeClr>
      <a:schemeClr val="accent1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/>
    <dgm:txEffectClrLst/>
  </dgm:styleLbl>
  <dgm:styleLbl name="f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1">
        <a:shade val="90000"/>
      </a:schemeClr>
      <a:schemeClr val="accent1">
        <a:tint val="70000"/>
      </a:schemeClr>
    </dgm:fillClrLst>
    <dgm:linClrLst>
      <a:schemeClr val="accent1">
        <a:shade val="90000"/>
      </a:schemeClr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1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1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>
        <a:tint val="90000"/>
      </a:schemeClr>
    </dgm:fillClrLst>
    <dgm:linClrLst meth="repeat">
      <a:schemeClr val="accent1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1">
        <a:tint val="50000"/>
      </a:schemeClr>
    </dgm:fillClrLst>
    <dgm:linClrLst meth="repeat">
      <a:schemeClr val="accent1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>
        <a:shade val="8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>
        <a:tint val="99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>
        <a:tint val="8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>
        <a:tint val="7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1">
        <a:shade val="80000"/>
      </a:schemeClr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9C10906-047C-4A20-B7CC-D7B612F29870}" type="doc">
      <dgm:prSet loTypeId="urn:microsoft.com/office/officeart/2005/8/layout/list1" loCatId="list" qsTypeId="urn:microsoft.com/office/officeart/2005/8/quickstyle/simple1" qsCatId="simple" csTypeId="urn:microsoft.com/office/officeart/2005/8/colors/accent1_3" csCatId="accent1" phldr="1"/>
      <dgm:spPr/>
      <dgm:t>
        <a:bodyPr/>
        <a:lstStyle/>
        <a:p>
          <a:endParaRPr lang="en-GB"/>
        </a:p>
      </dgm:t>
    </dgm:pt>
    <dgm:pt modelId="{550EA637-AD9F-42B5-BBBB-4B73E4C10781}">
      <dgm:prSet phldrT="[Text]"/>
      <dgm:spPr/>
      <dgm:t>
        <a:bodyPr/>
        <a:lstStyle/>
        <a:p>
          <a:r>
            <a:rPr lang="en-GB" dirty="0"/>
            <a:t>Literature identification</a:t>
          </a:r>
        </a:p>
      </dgm:t>
    </dgm:pt>
    <dgm:pt modelId="{3D80FDCF-71FE-4E66-8EE9-E701EA585B31}" type="parTrans" cxnId="{278C68F6-FDEA-4A88-BEFC-205F19C6AEBC}">
      <dgm:prSet/>
      <dgm:spPr/>
      <dgm:t>
        <a:bodyPr/>
        <a:lstStyle/>
        <a:p>
          <a:endParaRPr lang="en-GB"/>
        </a:p>
      </dgm:t>
    </dgm:pt>
    <dgm:pt modelId="{70E3E5C5-D16B-4C54-A259-08DF85FBBC44}" type="sibTrans" cxnId="{278C68F6-FDEA-4A88-BEFC-205F19C6AEBC}">
      <dgm:prSet/>
      <dgm:spPr/>
      <dgm:t>
        <a:bodyPr/>
        <a:lstStyle/>
        <a:p>
          <a:endParaRPr lang="en-GB"/>
        </a:p>
      </dgm:t>
    </dgm:pt>
    <dgm:pt modelId="{1B417A69-3206-4CF4-816E-8EA683D4618E}">
      <dgm:prSet/>
      <dgm:spPr/>
      <dgm:t>
        <a:bodyPr/>
        <a:lstStyle/>
        <a:p>
          <a:r>
            <a:rPr lang="en-GB" dirty="0"/>
            <a:t> Representative algorithmic works selected</a:t>
          </a:r>
        </a:p>
      </dgm:t>
    </dgm:pt>
    <dgm:pt modelId="{9268355D-CFCF-43B1-A747-0B870EA3308B}" type="parTrans" cxnId="{8EA08460-D485-4C74-943D-67CC26E54F6A}">
      <dgm:prSet/>
      <dgm:spPr/>
      <dgm:t>
        <a:bodyPr/>
        <a:lstStyle/>
        <a:p>
          <a:endParaRPr lang="en-GB"/>
        </a:p>
      </dgm:t>
    </dgm:pt>
    <dgm:pt modelId="{82135650-E26B-4ECE-9626-930474642EF0}" type="sibTrans" cxnId="{8EA08460-D485-4C74-943D-67CC26E54F6A}">
      <dgm:prSet/>
      <dgm:spPr/>
      <dgm:t>
        <a:bodyPr/>
        <a:lstStyle/>
        <a:p>
          <a:endParaRPr lang="en-GB"/>
        </a:p>
      </dgm:t>
    </dgm:pt>
    <dgm:pt modelId="{3E0C2CF0-ADAE-48EB-989D-92C19067DA89}">
      <dgm:prSet/>
      <dgm:spPr/>
      <dgm:t>
        <a:bodyPr/>
        <a:lstStyle/>
        <a:p>
          <a:r>
            <a:rPr lang="en-GB" dirty="0"/>
            <a:t> Seminal contributions identified</a:t>
          </a:r>
        </a:p>
      </dgm:t>
    </dgm:pt>
    <dgm:pt modelId="{578652F7-9140-4F49-9668-1E9CDE9943FE}" type="parTrans" cxnId="{69993FEA-EA9C-4EE4-B87E-738E8EA0D624}">
      <dgm:prSet/>
      <dgm:spPr/>
      <dgm:t>
        <a:bodyPr/>
        <a:lstStyle/>
        <a:p>
          <a:endParaRPr lang="en-GB"/>
        </a:p>
      </dgm:t>
    </dgm:pt>
    <dgm:pt modelId="{A8ED7824-1302-421A-8725-C9E78EBAD7A9}" type="sibTrans" cxnId="{69993FEA-EA9C-4EE4-B87E-738E8EA0D624}">
      <dgm:prSet/>
      <dgm:spPr/>
      <dgm:t>
        <a:bodyPr/>
        <a:lstStyle/>
        <a:p>
          <a:endParaRPr lang="en-GB"/>
        </a:p>
      </dgm:t>
    </dgm:pt>
    <dgm:pt modelId="{9152CD79-FEA3-4308-AB9D-9E922B7B37D7}">
      <dgm:prSet/>
      <dgm:spPr/>
      <dgm:t>
        <a:bodyPr/>
        <a:lstStyle/>
        <a:p>
          <a:r>
            <a:rPr lang="en-GB" dirty="0"/>
            <a:t> Recent </a:t>
          </a:r>
          <a:r>
            <a:rPr lang="en-GB"/>
            <a:t>developments reviewed</a:t>
          </a:r>
          <a:endParaRPr lang="en-GB" dirty="0"/>
        </a:p>
      </dgm:t>
    </dgm:pt>
    <dgm:pt modelId="{01A98B21-0BB3-4887-86DD-97B087373EB4}" type="parTrans" cxnId="{76CA9CAB-5FDC-404F-A2F5-5642F512CDB2}">
      <dgm:prSet/>
      <dgm:spPr/>
      <dgm:t>
        <a:bodyPr/>
        <a:lstStyle/>
        <a:p>
          <a:endParaRPr lang="en-GB"/>
        </a:p>
      </dgm:t>
    </dgm:pt>
    <dgm:pt modelId="{634CC958-BBCE-4188-9428-164095F483E1}" type="sibTrans" cxnId="{76CA9CAB-5FDC-404F-A2F5-5642F512CDB2}">
      <dgm:prSet/>
      <dgm:spPr/>
      <dgm:t>
        <a:bodyPr/>
        <a:lstStyle/>
        <a:p>
          <a:endParaRPr lang="en-GB"/>
        </a:p>
      </dgm:t>
    </dgm:pt>
    <dgm:pt modelId="{535122B6-9A0E-496B-B404-5EF3CE95F9C3}">
      <dgm:prSet/>
      <dgm:spPr/>
      <dgm:t>
        <a:bodyPr/>
        <a:lstStyle/>
        <a:p>
          <a:r>
            <a:rPr lang="en-GB" dirty="0"/>
            <a:t>Screening and selection</a:t>
          </a:r>
        </a:p>
      </dgm:t>
    </dgm:pt>
    <dgm:pt modelId="{B89C9D5E-A5CF-420C-8177-DA574E2266CA}" type="parTrans" cxnId="{697FD59A-AAE1-4D45-B4CA-3204605CB7AB}">
      <dgm:prSet/>
      <dgm:spPr/>
      <dgm:t>
        <a:bodyPr/>
        <a:lstStyle/>
        <a:p>
          <a:endParaRPr lang="en-GB"/>
        </a:p>
      </dgm:t>
    </dgm:pt>
    <dgm:pt modelId="{46E9E02C-B82D-4683-BE72-DD31F749B279}" type="sibTrans" cxnId="{697FD59A-AAE1-4D45-B4CA-3204605CB7AB}">
      <dgm:prSet/>
      <dgm:spPr/>
      <dgm:t>
        <a:bodyPr/>
        <a:lstStyle/>
        <a:p>
          <a:endParaRPr lang="en-GB"/>
        </a:p>
      </dgm:t>
    </dgm:pt>
    <dgm:pt modelId="{9AE4E0D8-F09D-4FB7-9A33-578EC530389D}">
      <dgm:prSet/>
      <dgm:spPr/>
      <dgm:t>
        <a:bodyPr/>
        <a:lstStyle/>
        <a:p>
          <a:r>
            <a:rPr lang="en-GB" dirty="0"/>
            <a:t> Relevance to sequence alignment theory</a:t>
          </a:r>
        </a:p>
      </dgm:t>
    </dgm:pt>
    <dgm:pt modelId="{E11A2D0C-6EE7-41CD-9C57-034278C505D4}" type="parTrans" cxnId="{A624DB5A-4CE2-4CD6-A1E3-9E6C5A3E0704}">
      <dgm:prSet/>
      <dgm:spPr/>
      <dgm:t>
        <a:bodyPr/>
        <a:lstStyle/>
        <a:p>
          <a:endParaRPr lang="en-GB"/>
        </a:p>
      </dgm:t>
    </dgm:pt>
    <dgm:pt modelId="{6A4F3DE0-684D-422C-A523-B012BBF83BE2}" type="sibTrans" cxnId="{A624DB5A-4CE2-4CD6-A1E3-9E6C5A3E0704}">
      <dgm:prSet/>
      <dgm:spPr/>
      <dgm:t>
        <a:bodyPr/>
        <a:lstStyle/>
        <a:p>
          <a:endParaRPr lang="en-GB"/>
        </a:p>
      </dgm:t>
    </dgm:pt>
    <dgm:pt modelId="{98EAF298-342B-4E2E-9156-D3DA266D2CE2}">
      <dgm:prSet/>
      <dgm:spPr/>
      <dgm:t>
        <a:bodyPr/>
        <a:lstStyle/>
        <a:p>
          <a:r>
            <a:rPr lang="en-GB" dirty="0"/>
            <a:t> Methodological contribution</a:t>
          </a:r>
        </a:p>
      </dgm:t>
    </dgm:pt>
    <dgm:pt modelId="{80D9F7F3-A595-45D8-A9FC-C9C0EFAFE336}" type="parTrans" cxnId="{C89B2F16-CD72-4976-B8BA-97CF44E82154}">
      <dgm:prSet/>
      <dgm:spPr/>
      <dgm:t>
        <a:bodyPr/>
        <a:lstStyle/>
        <a:p>
          <a:endParaRPr lang="en-GB"/>
        </a:p>
      </dgm:t>
    </dgm:pt>
    <dgm:pt modelId="{003A763D-CC08-49C4-8F14-82DAA53573A2}" type="sibTrans" cxnId="{C89B2F16-CD72-4976-B8BA-97CF44E82154}">
      <dgm:prSet/>
      <dgm:spPr/>
      <dgm:t>
        <a:bodyPr/>
        <a:lstStyle/>
        <a:p>
          <a:endParaRPr lang="en-GB"/>
        </a:p>
      </dgm:t>
    </dgm:pt>
    <dgm:pt modelId="{C383EDF1-9177-4E34-A883-2F2744117E20}">
      <dgm:prSet/>
      <dgm:spPr/>
      <dgm:t>
        <a:bodyPr/>
        <a:lstStyle/>
        <a:p>
          <a:r>
            <a:rPr lang="en-GB" dirty="0"/>
            <a:t> </a:t>
          </a:r>
          <a:r>
            <a:rPr lang="en-GB"/>
            <a:t>Conceptual significance</a:t>
          </a:r>
          <a:endParaRPr lang="en-GB" dirty="0"/>
        </a:p>
      </dgm:t>
    </dgm:pt>
    <dgm:pt modelId="{563F6F50-76AC-4C52-8A7E-AC7F73BFEBF4}" type="parTrans" cxnId="{CFC9FB91-730F-4829-958E-0B72F03B63E0}">
      <dgm:prSet/>
      <dgm:spPr/>
      <dgm:t>
        <a:bodyPr/>
        <a:lstStyle/>
        <a:p>
          <a:endParaRPr lang="en-GB"/>
        </a:p>
      </dgm:t>
    </dgm:pt>
    <dgm:pt modelId="{72725168-48CC-485F-93F4-ECE5C051DE70}" type="sibTrans" cxnId="{CFC9FB91-730F-4829-958E-0B72F03B63E0}">
      <dgm:prSet/>
      <dgm:spPr/>
      <dgm:t>
        <a:bodyPr/>
        <a:lstStyle/>
        <a:p>
          <a:endParaRPr lang="en-GB"/>
        </a:p>
      </dgm:t>
    </dgm:pt>
    <dgm:pt modelId="{FB306B47-7A1F-43AF-94F9-22F8D864BE96}">
      <dgm:prSet/>
      <dgm:spPr/>
      <dgm:t>
        <a:bodyPr/>
        <a:lstStyle/>
        <a:p>
          <a:r>
            <a:rPr lang="en-GB"/>
            <a:t>Final inclusion</a:t>
          </a:r>
        </a:p>
      </dgm:t>
    </dgm:pt>
    <dgm:pt modelId="{1FCEDA4A-7A09-4663-83A9-351D59F11D6C}" type="parTrans" cxnId="{5DC5F958-44AD-4929-9BB8-B18767174989}">
      <dgm:prSet/>
      <dgm:spPr/>
      <dgm:t>
        <a:bodyPr/>
        <a:lstStyle/>
        <a:p>
          <a:endParaRPr lang="en-GB"/>
        </a:p>
      </dgm:t>
    </dgm:pt>
    <dgm:pt modelId="{22857879-A1F0-41DB-B562-353D0E791BB7}" type="sibTrans" cxnId="{5DC5F958-44AD-4929-9BB8-B18767174989}">
      <dgm:prSet/>
      <dgm:spPr/>
      <dgm:t>
        <a:bodyPr/>
        <a:lstStyle/>
        <a:p>
          <a:endParaRPr lang="en-GB"/>
        </a:p>
      </dgm:t>
    </dgm:pt>
    <dgm:pt modelId="{015DD2B7-6722-4B24-8731-9419D41B502C}">
      <dgm:prSet/>
      <dgm:spPr/>
      <dgm:t>
        <a:bodyPr/>
        <a:lstStyle/>
        <a:p>
          <a:r>
            <a:rPr lang="en-GB" dirty="0"/>
            <a:t> Foundational methods</a:t>
          </a:r>
        </a:p>
      </dgm:t>
    </dgm:pt>
    <dgm:pt modelId="{3D9BEE63-8AD9-458B-A1C0-9362D8FD8227}" type="parTrans" cxnId="{B4566C71-1BA3-439F-A1F9-BEAB2EE960F7}">
      <dgm:prSet/>
      <dgm:spPr/>
      <dgm:t>
        <a:bodyPr/>
        <a:lstStyle/>
        <a:p>
          <a:endParaRPr lang="en-GB"/>
        </a:p>
      </dgm:t>
    </dgm:pt>
    <dgm:pt modelId="{E851744E-C5B3-47C0-80A6-D29D49F05CAB}" type="sibTrans" cxnId="{B4566C71-1BA3-439F-A1F9-BEAB2EE960F7}">
      <dgm:prSet/>
      <dgm:spPr/>
      <dgm:t>
        <a:bodyPr/>
        <a:lstStyle/>
        <a:p>
          <a:endParaRPr lang="en-GB"/>
        </a:p>
      </dgm:t>
    </dgm:pt>
    <dgm:pt modelId="{AF31BFBE-B995-4290-BDBF-EBF98E797AFE}">
      <dgm:prSet/>
      <dgm:spPr/>
      <dgm:t>
        <a:bodyPr/>
        <a:lstStyle/>
        <a:p>
          <a:r>
            <a:rPr lang="en-GB" dirty="0"/>
            <a:t> Algorithmic variants</a:t>
          </a:r>
        </a:p>
      </dgm:t>
    </dgm:pt>
    <dgm:pt modelId="{A01A124C-D8EE-4263-A5B9-A334FB57906D}" type="parTrans" cxnId="{74941878-FC9B-47E3-952C-184F729426E5}">
      <dgm:prSet/>
      <dgm:spPr/>
      <dgm:t>
        <a:bodyPr/>
        <a:lstStyle/>
        <a:p>
          <a:endParaRPr lang="en-GB"/>
        </a:p>
      </dgm:t>
    </dgm:pt>
    <dgm:pt modelId="{14FCEBDC-9E72-4D29-9B0D-BC504B3AAF02}" type="sibTrans" cxnId="{74941878-FC9B-47E3-952C-184F729426E5}">
      <dgm:prSet/>
      <dgm:spPr/>
      <dgm:t>
        <a:bodyPr/>
        <a:lstStyle/>
        <a:p>
          <a:endParaRPr lang="en-GB"/>
        </a:p>
      </dgm:t>
    </dgm:pt>
    <dgm:pt modelId="{FEDE2FBE-79CE-4C16-8861-7089D2FBBC5D}">
      <dgm:prSet/>
      <dgm:spPr/>
      <dgm:t>
        <a:bodyPr/>
        <a:lstStyle/>
        <a:p>
          <a:r>
            <a:rPr lang="en-GB" dirty="0"/>
            <a:t> </a:t>
          </a:r>
          <a:r>
            <a:rPr lang="en-GB"/>
            <a:t>Modern developments</a:t>
          </a:r>
          <a:endParaRPr lang="en-GB" dirty="0"/>
        </a:p>
      </dgm:t>
    </dgm:pt>
    <dgm:pt modelId="{FA7B2EB4-F402-46BE-AB9D-2BCAF2309205}" type="parTrans" cxnId="{8075C62F-E502-4FA3-AC5E-8CAF4EF2607C}">
      <dgm:prSet/>
      <dgm:spPr/>
      <dgm:t>
        <a:bodyPr/>
        <a:lstStyle/>
        <a:p>
          <a:endParaRPr lang="en-GB"/>
        </a:p>
      </dgm:t>
    </dgm:pt>
    <dgm:pt modelId="{B59AF0FC-3823-4507-9390-7EA20E3D7F6D}" type="sibTrans" cxnId="{8075C62F-E502-4FA3-AC5E-8CAF4EF2607C}">
      <dgm:prSet/>
      <dgm:spPr/>
      <dgm:t>
        <a:bodyPr/>
        <a:lstStyle/>
        <a:p>
          <a:endParaRPr lang="en-GB"/>
        </a:p>
      </dgm:t>
    </dgm:pt>
    <dgm:pt modelId="{83103C8C-845E-4B57-ACAA-3C1ACDEF4650}" type="pres">
      <dgm:prSet presAssocID="{C9C10906-047C-4A20-B7CC-D7B612F29870}" presName="linear" presStyleCnt="0">
        <dgm:presLayoutVars>
          <dgm:dir/>
          <dgm:animLvl val="lvl"/>
          <dgm:resizeHandles val="exact"/>
        </dgm:presLayoutVars>
      </dgm:prSet>
      <dgm:spPr/>
    </dgm:pt>
    <dgm:pt modelId="{A559887C-2F3A-4FD6-A354-CBF5A8541352}" type="pres">
      <dgm:prSet presAssocID="{550EA637-AD9F-42B5-BBBB-4B73E4C10781}" presName="parentLin" presStyleCnt="0"/>
      <dgm:spPr/>
    </dgm:pt>
    <dgm:pt modelId="{75F94F31-3FD0-49D9-BDBD-5937E623FBAB}" type="pres">
      <dgm:prSet presAssocID="{550EA637-AD9F-42B5-BBBB-4B73E4C10781}" presName="parentLeftMargin" presStyleLbl="node1" presStyleIdx="0" presStyleCnt="3"/>
      <dgm:spPr/>
    </dgm:pt>
    <dgm:pt modelId="{57D3B2FE-6093-437B-BCBE-2F1E15C57830}" type="pres">
      <dgm:prSet presAssocID="{550EA637-AD9F-42B5-BBBB-4B73E4C10781}" presName="parentText" presStyleLbl="node1" presStyleIdx="0" presStyleCnt="3">
        <dgm:presLayoutVars>
          <dgm:chMax val="0"/>
          <dgm:bulletEnabled val="1"/>
        </dgm:presLayoutVars>
      </dgm:prSet>
      <dgm:spPr/>
    </dgm:pt>
    <dgm:pt modelId="{2CFF239B-CED8-467C-BEDC-E5478007893D}" type="pres">
      <dgm:prSet presAssocID="{550EA637-AD9F-42B5-BBBB-4B73E4C10781}" presName="negativeSpace" presStyleCnt="0"/>
      <dgm:spPr/>
    </dgm:pt>
    <dgm:pt modelId="{67B5BE30-3258-4984-A633-DDD65C454043}" type="pres">
      <dgm:prSet presAssocID="{550EA637-AD9F-42B5-BBBB-4B73E4C10781}" presName="childText" presStyleLbl="conFgAcc1" presStyleIdx="0" presStyleCnt="3">
        <dgm:presLayoutVars>
          <dgm:bulletEnabled val="1"/>
        </dgm:presLayoutVars>
      </dgm:prSet>
      <dgm:spPr/>
    </dgm:pt>
    <dgm:pt modelId="{97C1A1F6-BFC5-4685-8E48-C35FCC504389}" type="pres">
      <dgm:prSet presAssocID="{70E3E5C5-D16B-4C54-A259-08DF85FBBC44}" presName="spaceBetweenRectangles" presStyleCnt="0"/>
      <dgm:spPr/>
    </dgm:pt>
    <dgm:pt modelId="{1A882F2F-B92E-478A-974E-5645A701D92B}" type="pres">
      <dgm:prSet presAssocID="{535122B6-9A0E-496B-B404-5EF3CE95F9C3}" presName="parentLin" presStyleCnt="0"/>
      <dgm:spPr/>
    </dgm:pt>
    <dgm:pt modelId="{4BF65B91-CE43-43D4-B782-675AD8DC3C42}" type="pres">
      <dgm:prSet presAssocID="{535122B6-9A0E-496B-B404-5EF3CE95F9C3}" presName="parentLeftMargin" presStyleLbl="node1" presStyleIdx="0" presStyleCnt="3"/>
      <dgm:spPr/>
    </dgm:pt>
    <dgm:pt modelId="{EE0548F1-6D76-49D9-AF07-EDFF25234531}" type="pres">
      <dgm:prSet presAssocID="{535122B6-9A0E-496B-B404-5EF3CE95F9C3}" presName="parentText" presStyleLbl="node1" presStyleIdx="1" presStyleCnt="3">
        <dgm:presLayoutVars>
          <dgm:chMax val="0"/>
          <dgm:bulletEnabled val="1"/>
        </dgm:presLayoutVars>
      </dgm:prSet>
      <dgm:spPr/>
    </dgm:pt>
    <dgm:pt modelId="{F15A460A-FDD1-4FF8-B304-A87416CB9FA9}" type="pres">
      <dgm:prSet presAssocID="{535122B6-9A0E-496B-B404-5EF3CE95F9C3}" presName="negativeSpace" presStyleCnt="0"/>
      <dgm:spPr/>
    </dgm:pt>
    <dgm:pt modelId="{B629B07D-20A2-4366-BF7D-C395CCFFA79F}" type="pres">
      <dgm:prSet presAssocID="{535122B6-9A0E-496B-B404-5EF3CE95F9C3}" presName="childText" presStyleLbl="conFgAcc1" presStyleIdx="1" presStyleCnt="3">
        <dgm:presLayoutVars>
          <dgm:bulletEnabled val="1"/>
        </dgm:presLayoutVars>
      </dgm:prSet>
      <dgm:spPr/>
    </dgm:pt>
    <dgm:pt modelId="{6D00939A-631D-4535-96DD-7FA70521CDE9}" type="pres">
      <dgm:prSet presAssocID="{46E9E02C-B82D-4683-BE72-DD31F749B279}" presName="spaceBetweenRectangles" presStyleCnt="0"/>
      <dgm:spPr/>
    </dgm:pt>
    <dgm:pt modelId="{F0ADD35E-44E1-4B11-8B17-9E5CC68D2453}" type="pres">
      <dgm:prSet presAssocID="{FB306B47-7A1F-43AF-94F9-22F8D864BE96}" presName="parentLin" presStyleCnt="0"/>
      <dgm:spPr/>
    </dgm:pt>
    <dgm:pt modelId="{D354B5E7-B4C2-4348-8401-5A44F9500076}" type="pres">
      <dgm:prSet presAssocID="{FB306B47-7A1F-43AF-94F9-22F8D864BE96}" presName="parentLeftMargin" presStyleLbl="node1" presStyleIdx="1" presStyleCnt="3"/>
      <dgm:spPr/>
    </dgm:pt>
    <dgm:pt modelId="{0E798636-9C2F-4BF8-B0DC-71090E07477A}" type="pres">
      <dgm:prSet presAssocID="{FB306B47-7A1F-43AF-94F9-22F8D864BE96}" presName="parentText" presStyleLbl="node1" presStyleIdx="2" presStyleCnt="3">
        <dgm:presLayoutVars>
          <dgm:chMax val="0"/>
          <dgm:bulletEnabled val="1"/>
        </dgm:presLayoutVars>
      </dgm:prSet>
      <dgm:spPr/>
    </dgm:pt>
    <dgm:pt modelId="{06377450-8A5D-4BFB-9DD0-C61B0721B3BD}" type="pres">
      <dgm:prSet presAssocID="{FB306B47-7A1F-43AF-94F9-22F8D864BE96}" presName="negativeSpace" presStyleCnt="0"/>
      <dgm:spPr/>
    </dgm:pt>
    <dgm:pt modelId="{DCDE45F5-CFAD-4EEC-B403-A72D68D4E370}" type="pres">
      <dgm:prSet presAssocID="{FB306B47-7A1F-43AF-94F9-22F8D864BE96}" presName="childText" presStyleLbl="conFgAcc1" presStyleIdx="2" presStyleCnt="3">
        <dgm:presLayoutVars>
          <dgm:bulletEnabled val="1"/>
        </dgm:presLayoutVars>
      </dgm:prSet>
      <dgm:spPr/>
    </dgm:pt>
  </dgm:ptLst>
  <dgm:cxnLst>
    <dgm:cxn modelId="{F215040D-982B-4EEB-B1EF-315C6D80A60C}" type="presOf" srcId="{550EA637-AD9F-42B5-BBBB-4B73E4C10781}" destId="{57D3B2FE-6093-437B-BCBE-2F1E15C57830}" srcOrd="1" destOrd="0" presId="urn:microsoft.com/office/officeart/2005/8/layout/list1"/>
    <dgm:cxn modelId="{64BEF00D-B403-40B8-BCB1-12AE0CE052C9}" type="presOf" srcId="{1B417A69-3206-4CF4-816E-8EA683D4618E}" destId="{67B5BE30-3258-4984-A633-DDD65C454043}" srcOrd="0" destOrd="0" presId="urn:microsoft.com/office/officeart/2005/8/layout/list1"/>
    <dgm:cxn modelId="{C89B2F16-CD72-4976-B8BA-97CF44E82154}" srcId="{535122B6-9A0E-496B-B404-5EF3CE95F9C3}" destId="{98EAF298-342B-4E2E-9156-D3DA266D2CE2}" srcOrd="1" destOrd="0" parTransId="{80D9F7F3-A595-45D8-A9FC-C9C0EFAFE336}" sibTransId="{003A763D-CC08-49C4-8F14-82DAA53573A2}"/>
    <dgm:cxn modelId="{DA265F25-E7E7-496B-BFA4-09C1A7AE9806}" type="presOf" srcId="{9152CD79-FEA3-4308-AB9D-9E922B7B37D7}" destId="{67B5BE30-3258-4984-A633-DDD65C454043}" srcOrd="0" destOrd="2" presId="urn:microsoft.com/office/officeart/2005/8/layout/list1"/>
    <dgm:cxn modelId="{32C26329-4AD0-4707-A04D-ABDCF846014D}" type="presOf" srcId="{535122B6-9A0E-496B-B404-5EF3CE95F9C3}" destId="{EE0548F1-6D76-49D9-AF07-EDFF25234531}" srcOrd="1" destOrd="0" presId="urn:microsoft.com/office/officeart/2005/8/layout/list1"/>
    <dgm:cxn modelId="{8075C62F-E502-4FA3-AC5E-8CAF4EF2607C}" srcId="{FB306B47-7A1F-43AF-94F9-22F8D864BE96}" destId="{FEDE2FBE-79CE-4C16-8861-7089D2FBBC5D}" srcOrd="2" destOrd="0" parTransId="{FA7B2EB4-F402-46BE-AB9D-2BCAF2309205}" sibTransId="{B59AF0FC-3823-4507-9390-7EA20E3D7F6D}"/>
    <dgm:cxn modelId="{46B2FD5B-5FA1-4AEE-A21B-3611C4E31D4C}" type="presOf" srcId="{FEDE2FBE-79CE-4C16-8861-7089D2FBBC5D}" destId="{DCDE45F5-CFAD-4EEC-B403-A72D68D4E370}" srcOrd="0" destOrd="2" presId="urn:microsoft.com/office/officeart/2005/8/layout/list1"/>
    <dgm:cxn modelId="{8EA08460-D485-4C74-943D-67CC26E54F6A}" srcId="{550EA637-AD9F-42B5-BBBB-4B73E4C10781}" destId="{1B417A69-3206-4CF4-816E-8EA683D4618E}" srcOrd="0" destOrd="0" parTransId="{9268355D-CFCF-43B1-A747-0B870EA3308B}" sibTransId="{82135650-E26B-4ECE-9626-930474642EF0}"/>
    <dgm:cxn modelId="{40BA4A4E-A9F2-48C3-8C82-9EC8B57B5C84}" type="presOf" srcId="{AF31BFBE-B995-4290-BDBF-EBF98E797AFE}" destId="{DCDE45F5-CFAD-4EEC-B403-A72D68D4E370}" srcOrd="0" destOrd="1" presId="urn:microsoft.com/office/officeart/2005/8/layout/list1"/>
    <dgm:cxn modelId="{B4566C71-1BA3-439F-A1F9-BEAB2EE960F7}" srcId="{FB306B47-7A1F-43AF-94F9-22F8D864BE96}" destId="{015DD2B7-6722-4B24-8731-9419D41B502C}" srcOrd="0" destOrd="0" parTransId="{3D9BEE63-8AD9-458B-A1C0-9362D8FD8227}" sibTransId="{E851744E-C5B3-47C0-80A6-D29D49F05CAB}"/>
    <dgm:cxn modelId="{74941878-FC9B-47E3-952C-184F729426E5}" srcId="{FB306B47-7A1F-43AF-94F9-22F8D864BE96}" destId="{AF31BFBE-B995-4290-BDBF-EBF98E797AFE}" srcOrd="1" destOrd="0" parTransId="{A01A124C-D8EE-4263-A5B9-A334FB57906D}" sibTransId="{14FCEBDC-9E72-4D29-9B0D-BC504B3AAF02}"/>
    <dgm:cxn modelId="{5DC5F958-44AD-4929-9BB8-B18767174989}" srcId="{C9C10906-047C-4A20-B7CC-D7B612F29870}" destId="{FB306B47-7A1F-43AF-94F9-22F8D864BE96}" srcOrd="2" destOrd="0" parTransId="{1FCEDA4A-7A09-4663-83A9-351D59F11D6C}" sibTransId="{22857879-A1F0-41DB-B562-353D0E791BB7}"/>
    <dgm:cxn modelId="{A624DB5A-4CE2-4CD6-A1E3-9E6C5A3E0704}" srcId="{535122B6-9A0E-496B-B404-5EF3CE95F9C3}" destId="{9AE4E0D8-F09D-4FB7-9A33-578EC530389D}" srcOrd="0" destOrd="0" parTransId="{E11A2D0C-6EE7-41CD-9C57-034278C505D4}" sibTransId="{6A4F3DE0-684D-422C-A523-B012BBF83BE2}"/>
    <dgm:cxn modelId="{02084487-A4DD-4A2D-B2C6-D2D607D66074}" type="presOf" srcId="{FB306B47-7A1F-43AF-94F9-22F8D864BE96}" destId="{D354B5E7-B4C2-4348-8401-5A44F9500076}" srcOrd="0" destOrd="0" presId="urn:microsoft.com/office/officeart/2005/8/layout/list1"/>
    <dgm:cxn modelId="{CFC9FB91-730F-4829-958E-0B72F03B63E0}" srcId="{535122B6-9A0E-496B-B404-5EF3CE95F9C3}" destId="{C383EDF1-9177-4E34-A883-2F2744117E20}" srcOrd="2" destOrd="0" parTransId="{563F6F50-76AC-4C52-8A7E-AC7F73BFEBF4}" sibTransId="{72725168-48CC-485F-93F4-ECE5C051DE70}"/>
    <dgm:cxn modelId="{697FD59A-AAE1-4D45-B4CA-3204605CB7AB}" srcId="{C9C10906-047C-4A20-B7CC-D7B612F29870}" destId="{535122B6-9A0E-496B-B404-5EF3CE95F9C3}" srcOrd="1" destOrd="0" parTransId="{B89C9D5E-A5CF-420C-8177-DA574E2266CA}" sibTransId="{46E9E02C-B82D-4683-BE72-DD31F749B279}"/>
    <dgm:cxn modelId="{6EF837A8-7143-40B0-AA3E-CCD0E3431A4D}" type="presOf" srcId="{535122B6-9A0E-496B-B404-5EF3CE95F9C3}" destId="{4BF65B91-CE43-43D4-B782-675AD8DC3C42}" srcOrd="0" destOrd="0" presId="urn:microsoft.com/office/officeart/2005/8/layout/list1"/>
    <dgm:cxn modelId="{76CA9CAB-5FDC-404F-A2F5-5642F512CDB2}" srcId="{550EA637-AD9F-42B5-BBBB-4B73E4C10781}" destId="{9152CD79-FEA3-4308-AB9D-9E922B7B37D7}" srcOrd="2" destOrd="0" parTransId="{01A98B21-0BB3-4887-86DD-97B087373EB4}" sibTransId="{634CC958-BBCE-4188-9428-164095F483E1}"/>
    <dgm:cxn modelId="{3EC391BC-6E24-492B-BF43-B40D35FC14CF}" type="presOf" srcId="{FB306B47-7A1F-43AF-94F9-22F8D864BE96}" destId="{0E798636-9C2F-4BF8-B0DC-71090E07477A}" srcOrd="1" destOrd="0" presId="urn:microsoft.com/office/officeart/2005/8/layout/list1"/>
    <dgm:cxn modelId="{9CFBDABF-317B-4629-9E89-639195BF6D3E}" type="presOf" srcId="{C383EDF1-9177-4E34-A883-2F2744117E20}" destId="{B629B07D-20A2-4366-BF7D-C395CCFFA79F}" srcOrd="0" destOrd="2" presId="urn:microsoft.com/office/officeart/2005/8/layout/list1"/>
    <dgm:cxn modelId="{5984E1DD-6620-4909-8DE1-8D0715A57B2F}" type="presOf" srcId="{9AE4E0D8-F09D-4FB7-9A33-578EC530389D}" destId="{B629B07D-20A2-4366-BF7D-C395CCFFA79F}" srcOrd="0" destOrd="0" presId="urn:microsoft.com/office/officeart/2005/8/layout/list1"/>
    <dgm:cxn modelId="{FB3A84E6-5DCD-474E-B0D2-47671224E585}" type="presOf" srcId="{98EAF298-342B-4E2E-9156-D3DA266D2CE2}" destId="{B629B07D-20A2-4366-BF7D-C395CCFFA79F}" srcOrd="0" destOrd="1" presId="urn:microsoft.com/office/officeart/2005/8/layout/list1"/>
    <dgm:cxn modelId="{69993FEA-EA9C-4EE4-B87E-738E8EA0D624}" srcId="{550EA637-AD9F-42B5-BBBB-4B73E4C10781}" destId="{3E0C2CF0-ADAE-48EB-989D-92C19067DA89}" srcOrd="1" destOrd="0" parTransId="{578652F7-9140-4F49-9668-1E9CDE9943FE}" sibTransId="{A8ED7824-1302-421A-8725-C9E78EBAD7A9}"/>
    <dgm:cxn modelId="{0A522BEB-041F-4A27-975D-B9951D3DC3C2}" type="presOf" srcId="{C9C10906-047C-4A20-B7CC-D7B612F29870}" destId="{83103C8C-845E-4B57-ACAA-3C1ACDEF4650}" srcOrd="0" destOrd="0" presId="urn:microsoft.com/office/officeart/2005/8/layout/list1"/>
    <dgm:cxn modelId="{816FB6F4-16B5-4B80-B3A2-EA6E561B71A9}" type="presOf" srcId="{550EA637-AD9F-42B5-BBBB-4B73E4C10781}" destId="{75F94F31-3FD0-49D9-BDBD-5937E623FBAB}" srcOrd="0" destOrd="0" presId="urn:microsoft.com/office/officeart/2005/8/layout/list1"/>
    <dgm:cxn modelId="{FDAE7BF5-BE21-4F70-812F-F9E90D0FBA62}" type="presOf" srcId="{3E0C2CF0-ADAE-48EB-989D-92C19067DA89}" destId="{67B5BE30-3258-4984-A633-DDD65C454043}" srcOrd="0" destOrd="1" presId="urn:microsoft.com/office/officeart/2005/8/layout/list1"/>
    <dgm:cxn modelId="{278C68F6-FDEA-4A88-BEFC-205F19C6AEBC}" srcId="{C9C10906-047C-4A20-B7CC-D7B612F29870}" destId="{550EA637-AD9F-42B5-BBBB-4B73E4C10781}" srcOrd="0" destOrd="0" parTransId="{3D80FDCF-71FE-4E66-8EE9-E701EA585B31}" sibTransId="{70E3E5C5-D16B-4C54-A259-08DF85FBBC44}"/>
    <dgm:cxn modelId="{B349BCFF-B37B-461D-9DD0-759CB0C3C02F}" type="presOf" srcId="{015DD2B7-6722-4B24-8731-9419D41B502C}" destId="{DCDE45F5-CFAD-4EEC-B403-A72D68D4E370}" srcOrd="0" destOrd="0" presId="urn:microsoft.com/office/officeart/2005/8/layout/list1"/>
    <dgm:cxn modelId="{20BB64BD-4355-4ACE-9A37-A23885189AFF}" type="presParOf" srcId="{83103C8C-845E-4B57-ACAA-3C1ACDEF4650}" destId="{A559887C-2F3A-4FD6-A354-CBF5A8541352}" srcOrd="0" destOrd="0" presId="urn:microsoft.com/office/officeart/2005/8/layout/list1"/>
    <dgm:cxn modelId="{45029942-4142-4EEE-92A7-1E7E41265ACC}" type="presParOf" srcId="{A559887C-2F3A-4FD6-A354-CBF5A8541352}" destId="{75F94F31-3FD0-49D9-BDBD-5937E623FBAB}" srcOrd="0" destOrd="0" presId="urn:microsoft.com/office/officeart/2005/8/layout/list1"/>
    <dgm:cxn modelId="{E7EE1CEB-F491-4F4A-8CCF-F0A565503D54}" type="presParOf" srcId="{A559887C-2F3A-4FD6-A354-CBF5A8541352}" destId="{57D3B2FE-6093-437B-BCBE-2F1E15C57830}" srcOrd="1" destOrd="0" presId="urn:microsoft.com/office/officeart/2005/8/layout/list1"/>
    <dgm:cxn modelId="{B49CAC9B-E420-4C77-804B-4EE2A5F6504D}" type="presParOf" srcId="{83103C8C-845E-4B57-ACAA-3C1ACDEF4650}" destId="{2CFF239B-CED8-467C-BEDC-E5478007893D}" srcOrd="1" destOrd="0" presId="urn:microsoft.com/office/officeart/2005/8/layout/list1"/>
    <dgm:cxn modelId="{E1907078-6433-4D2E-B42D-A2B8007E81E7}" type="presParOf" srcId="{83103C8C-845E-4B57-ACAA-3C1ACDEF4650}" destId="{67B5BE30-3258-4984-A633-DDD65C454043}" srcOrd="2" destOrd="0" presId="urn:microsoft.com/office/officeart/2005/8/layout/list1"/>
    <dgm:cxn modelId="{87E12287-91FA-4D6F-893D-7A57CB39C41C}" type="presParOf" srcId="{83103C8C-845E-4B57-ACAA-3C1ACDEF4650}" destId="{97C1A1F6-BFC5-4685-8E48-C35FCC504389}" srcOrd="3" destOrd="0" presId="urn:microsoft.com/office/officeart/2005/8/layout/list1"/>
    <dgm:cxn modelId="{FAEB80F8-AC4A-456F-B213-A647C43A1F79}" type="presParOf" srcId="{83103C8C-845E-4B57-ACAA-3C1ACDEF4650}" destId="{1A882F2F-B92E-478A-974E-5645A701D92B}" srcOrd="4" destOrd="0" presId="urn:microsoft.com/office/officeart/2005/8/layout/list1"/>
    <dgm:cxn modelId="{2293EA58-D91C-4AA3-9DD3-73762A56D0CA}" type="presParOf" srcId="{1A882F2F-B92E-478A-974E-5645A701D92B}" destId="{4BF65B91-CE43-43D4-B782-675AD8DC3C42}" srcOrd="0" destOrd="0" presId="urn:microsoft.com/office/officeart/2005/8/layout/list1"/>
    <dgm:cxn modelId="{B2F505F8-6B87-4E3D-846C-B98AA23C599C}" type="presParOf" srcId="{1A882F2F-B92E-478A-974E-5645A701D92B}" destId="{EE0548F1-6D76-49D9-AF07-EDFF25234531}" srcOrd="1" destOrd="0" presId="urn:microsoft.com/office/officeart/2005/8/layout/list1"/>
    <dgm:cxn modelId="{D01E85D4-8E94-4763-AC55-12A755FCD5EE}" type="presParOf" srcId="{83103C8C-845E-4B57-ACAA-3C1ACDEF4650}" destId="{F15A460A-FDD1-4FF8-B304-A87416CB9FA9}" srcOrd="5" destOrd="0" presId="urn:microsoft.com/office/officeart/2005/8/layout/list1"/>
    <dgm:cxn modelId="{53634A7B-3E12-423D-BD8D-CB942854BB26}" type="presParOf" srcId="{83103C8C-845E-4B57-ACAA-3C1ACDEF4650}" destId="{B629B07D-20A2-4366-BF7D-C395CCFFA79F}" srcOrd="6" destOrd="0" presId="urn:microsoft.com/office/officeart/2005/8/layout/list1"/>
    <dgm:cxn modelId="{851EE8D3-65DD-495F-8218-76FE8D87D220}" type="presParOf" srcId="{83103C8C-845E-4B57-ACAA-3C1ACDEF4650}" destId="{6D00939A-631D-4535-96DD-7FA70521CDE9}" srcOrd="7" destOrd="0" presId="urn:microsoft.com/office/officeart/2005/8/layout/list1"/>
    <dgm:cxn modelId="{93169CAE-6A3B-4918-BA33-3736E4433794}" type="presParOf" srcId="{83103C8C-845E-4B57-ACAA-3C1ACDEF4650}" destId="{F0ADD35E-44E1-4B11-8B17-9E5CC68D2453}" srcOrd="8" destOrd="0" presId="urn:microsoft.com/office/officeart/2005/8/layout/list1"/>
    <dgm:cxn modelId="{75B3269D-9434-4B65-B5F9-504931A63E86}" type="presParOf" srcId="{F0ADD35E-44E1-4B11-8B17-9E5CC68D2453}" destId="{D354B5E7-B4C2-4348-8401-5A44F9500076}" srcOrd="0" destOrd="0" presId="urn:microsoft.com/office/officeart/2005/8/layout/list1"/>
    <dgm:cxn modelId="{C3768D51-FAD3-490A-9347-A5E535501A3C}" type="presParOf" srcId="{F0ADD35E-44E1-4B11-8B17-9E5CC68D2453}" destId="{0E798636-9C2F-4BF8-B0DC-71090E07477A}" srcOrd="1" destOrd="0" presId="urn:microsoft.com/office/officeart/2005/8/layout/list1"/>
    <dgm:cxn modelId="{1E12D27F-9235-40A4-BE4A-AD7BBE0CC304}" type="presParOf" srcId="{83103C8C-845E-4B57-ACAA-3C1ACDEF4650}" destId="{06377450-8A5D-4BFB-9DD0-C61B0721B3BD}" srcOrd="9" destOrd="0" presId="urn:microsoft.com/office/officeart/2005/8/layout/list1"/>
    <dgm:cxn modelId="{BEB94EBB-C068-4D79-AE5A-753323E1244B}" type="presParOf" srcId="{83103C8C-845E-4B57-ACAA-3C1ACDEF4650}" destId="{DCDE45F5-CFAD-4EEC-B403-A72D68D4E370}" srcOrd="10" destOrd="0" presId="urn:microsoft.com/office/officeart/2005/8/layout/lis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C9C10906-047C-4A20-B7CC-D7B612F29870}" type="doc">
      <dgm:prSet loTypeId="urn:microsoft.com/office/officeart/2005/8/layout/hierarchy3" loCatId="list" qsTypeId="urn:microsoft.com/office/officeart/2005/8/quickstyle/simple1" qsCatId="simple" csTypeId="urn:microsoft.com/office/officeart/2005/8/colors/accent1_3" csCatId="accent1" phldr="1"/>
      <dgm:spPr/>
      <dgm:t>
        <a:bodyPr/>
        <a:lstStyle/>
        <a:p>
          <a:endParaRPr lang="en-GB"/>
        </a:p>
      </dgm:t>
    </dgm:pt>
    <dgm:pt modelId="{550EA637-AD9F-42B5-BBBB-4B73E4C10781}">
      <dgm:prSet phldrT="[Text]"/>
      <dgm:spPr/>
      <dgm:t>
        <a:bodyPr/>
        <a:lstStyle/>
        <a:p>
          <a:r>
            <a:rPr lang="en-GB" dirty="0"/>
            <a:t>Literature identification</a:t>
          </a:r>
        </a:p>
      </dgm:t>
    </dgm:pt>
    <dgm:pt modelId="{3D80FDCF-71FE-4E66-8EE9-E701EA585B31}" type="parTrans" cxnId="{278C68F6-FDEA-4A88-BEFC-205F19C6AEBC}">
      <dgm:prSet/>
      <dgm:spPr/>
      <dgm:t>
        <a:bodyPr/>
        <a:lstStyle/>
        <a:p>
          <a:endParaRPr lang="en-GB"/>
        </a:p>
      </dgm:t>
    </dgm:pt>
    <dgm:pt modelId="{70E3E5C5-D16B-4C54-A259-08DF85FBBC44}" type="sibTrans" cxnId="{278C68F6-FDEA-4A88-BEFC-205F19C6AEBC}">
      <dgm:prSet/>
      <dgm:spPr/>
      <dgm:t>
        <a:bodyPr/>
        <a:lstStyle/>
        <a:p>
          <a:endParaRPr lang="en-GB"/>
        </a:p>
      </dgm:t>
    </dgm:pt>
    <dgm:pt modelId="{1B417A69-3206-4CF4-816E-8EA683D4618E}">
      <dgm:prSet/>
      <dgm:spPr/>
      <dgm:t>
        <a:bodyPr/>
        <a:lstStyle/>
        <a:p>
          <a:r>
            <a:rPr lang="en-GB" dirty="0"/>
            <a:t>Representative algorithmic works selected</a:t>
          </a:r>
        </a:p>
      </dgm:t>
    </dgm:pt>
    <dgm:pt modelId="{9268355D-CFCF-43B1-A747-0B870EA3308B}" type="parTrans" cxnId="{8EA08460-D485-4C74-943D-67CC26E54F6A}">
      <dgm:prSet/>
      <dgm:spPr/>
      <dgm:t>
        <a:bodyPr/>
        <a:lstStyle/>
        <a:p>
          <a:endParaRPr lang="en-GB"/>
        </a:p>
      </dgm:t>
    </dgm:pt>
    <dgm:pt modelId="{82135650-E26B-4ECE-9626-930474642EF0}" type="sibTrans" cxnId="{8EA08460-D485-4C74-943D-67CC26E54F6A}">
      <dgm:prSet/>
      <dgm:spPr/>
      <dgm:t>
        <a:bodyPr/>
        <a:lstStyle/>
        <a:p>
          <a:endParaRPr lang="en-GB"/>
        </a:p>
      </dgm:t>
    </dgm:pt>
    <dgm:pt modelId="{3E0C2CF0-ADAE-48EB-989D-92C19067DA89}">
      <dgm:prSet/>
      <dgm:spPr/>
      <dgm:t>
        <a:bodyPr/>
        <a:lstStyle/>
        <a:p>
          <a:r>
            <a:rPr lang="en-GB" dirty="0"/>
            <a:t>Seminal contributions identified</a:t>
          </a:r>
        </a:p>
      </dgm:t>
    </dgm:pt>
    <dgm:pt modelId="{578652F7-9140-4F49-9668-1E9CDE9943FE}" type="parTrans" cxnId="{69993FEA-EA9C-4EE4-B87E-738E8EA0D624}">
      <dgm:prSet/>
      <dgm:spPr/>
      <dgm:t>
        <a:bodyPr/>
        <a:lstStyle/>
        <a:p>
          <a:endParaRPr lang="en-GB"/>
        </a:p>
      </dgm:t>
    </dgm:pt>
    <dgm:pt modelId="{A8ED7824-1302-421A-8725-C9E78EBAD7A9}" type="sibTrans" cxnId="{69993FEA-EA9C-4EE4-B87E-738E8EA0D624}">
      <dgm:prSet/>
      <dgm:spPr/>
      <dgm:t>
        <a:bodyPr/>
        <a:lstStyle/>
        <a:p>
          <a:endParaRPr lang="en-GB"/>
        </a:p>
      </dgm:t>
    </dgm:pt>
    <dgm:pt modelId="{9152CD79-FEA3-4308-AB9D-9E922B7B37D7}">
      <dgm:prSet/>
      <dgm:spPr/>
      <dgm:t>
        <a:bodyPr/>
        <a:lstStyle/>
        <a:p>
          <a:r>
            <a:rPr lang="en-GB" dirty="0"/>
            <a:t>Recent developments reviewed</a:t>
          </a:r>
        </a:p>
      </dgm:t>
    </dgm:pt>
    <dgm:pt modelId="{01A98B21-0BB3-4887-86DD-97B087373EB4}" type="parTrans" cxnId="{76CA9CAB-5FDC-404F-A2F5-5642F512CDB2}">
      <dgm:prSet/>
      <dgm:spPr/>
      <dgm:t>
        <a:bodyPr/>
        <a:lstStyle/>
        <a:p>
          <a:endParaRPr lang="en-GB"/>
        </a:p>
      </dgm:t>
    </dgm:pt>
    <dgm:pt modelId="{634CC958-BBCE-4188-9428-164095F483E1}" type="sibTrans" cxnId="{76CA9CAB-5FDC-404F-A2F5-5642F512CDB2}">
      <dgm:prSet/>
      <dgm:spPr/>
      <dgm:t>
        <a:bodyPr/>
        <a:lstStyle/>
        <a:p>
          <a:endParaRPr lang="en-GB"/>
        </a:p>
      </dgm:t>
    </dgm:pt>
    <dgm:pt modelId="{535122B6-9A0E-496B-B404-5EF3CE95F9C3}">
      <dgm:prSet/>
      <dgm:spPr/>
      <dgm:t>
        <a:bodyPr/>
        <a:lstStyle/>
        <a:p>
          <a:r>
            <a:rPr lang="en-GB" dirty="0"/>
            <a:t>Screening and selection</a:t>
          </a:r>
        </a:p>
      </dgm:t>
    </dgm:pt>
    <dgm:pt modelId="{B89C9D5E-A5CF-420C-8177-DA574E2266CA}" type="parTrans" cxnId="{697FD59A-AAE1-4D45-B4CA-3204605CB7AB}">
      <dgm:prSet/>
      <dgm:spPr/>
      <dgm:t>
        <a:bodyPr/>
        <a:lstStyle/>
        <a:p>
          <a:endParaRPr lang="en-GB"/>
        </a:p>
      </dgm:t>
    </dgm:pt>
    <dgm:pt modelId="{46E9E02C-B82D-4683-BE72-DD31F749B279}" type="sibTrans" cxnId="{697FD59A-AAE1-4D45-B4CA-3204605CB7AB}">
      <dgm:prSet/>
      <dgm:spPr/>
      <dgm:t>
        <a:bodyPr/>
        <a:lstStyle/>
        <a:p>
          <a:endParaRPr lang="en-GB"/>
        </a:p>
      </dgm:t>
    </dgm:pt>
    <dgm:pt modelId="{9AE4E0D8-F09D-4FB7-9A33-578EC530389D}">
      <dgm:prSet/>
      <dgm:spPr/>
      <dgm:t>
        <a:bodyPr/>
        <a:lstStyle/>
        <a:p>
          <a:r>
            <a:rPr lang="en-GB" dirty="0"/>
            <a:t>Relevance to sequence alignment theory</a:t>
          </a:r>
        </a:p>
      </dgm:t>
    </dgm:pt>
    <dgm:pt modelId="{E11A2D0C-6EE7-41CD-9C57-034278C505D4}" type="parTrans" cxnId="{A624DB5A-4CE2-4CD6-A1E3-9E6C5A3E0704}">
      <dgm:prSet/>
      <dgm:spPr/>
      <dgm:t>
        <a:bodyPr/>
        <a:lstStyle/>
        <a:p>
          <a:endParaRPr lang="en-GB"/>
        </a:p>
      </dgm:t>
    </dgm:pt>
    <dgm:pt modelId="{6A4F3DE0-684D-422C-A523-B012BBF83BE2}" type="sibTrans" cxnId="{A624DB5A-4CE2-4CD6-A1E3-9E6C5A3E0704}">
      <dgm:prSet/>
      <dgm:spPr/>
      <dgm:t>
        <a:bodyPr/>
        <a:lstStyle/>
        <a:p>
          <a:endParaRPr lang="en-GB"/>
        </a:p>
      </dgm:t>
    </dgm:pt>
    <dgm:pt modelId="{98EAF298-342B-4E2E-9156-D3DA266D2CE2}">
      <dgm:prSet/>
      <dgm:spPr/>
      <dgm:t>
        <a:bodyPr/>
        <a:lstStyle/>
        <a:p>
          <a:r>
            <a:rPr lang="en-GB" dirty="0"/>
            <a:t>Methodological contribution</a:t>
          </a:r>
        </a:p>
      </dgm:t>
    </dgm:pt>
    <dgm:pt modelId="{80D9F7F3-A595-45D8-A9FC-C9C0EFAFE336}" type="parTrans" cxnId="{C89B2F16-CD72-4976-B8BA-97CF44E82154}">
      <dgm:prSet/>
      <dgm:spPr/>
      <dgm:t>
        <a:bodyPr/>
        <a:lstStyle/>
        <a:p>
          <a:endParaRPr lang="en-GB"/>
        </a:p>
      </dgm:t>
    </dgm:pt>
    <dgm:pt modelId="{003A763D-CC08-49C4-8F14-82DAA53573A2}" type="sibTrans" cxnId="{C89B2F16-CD72-4976-B8BA-97CF44E82154}">
      <dgm:prSet/>
      <dgm:spPr/>
      <dgm:t>
        <a:bodyPr/>
        <a:lstStyle/>
        <a:p>
          <a:endParaRPr lang="en-GB"/>
        </a:p>
      </dgm:t>
    </dgm:pt>
    <dgm:pt modelId="{C383EDF1-9177-4E34-A883-2F2744117E20}">
      <dgm:prSet/>
      <dgm:spPr/>
      <dgm:t>
        <a:bodyPr/>
        <a:lstStyle/>
        <a:p>
          <a:r>
            <a:rPr lang="en-GB" dirty="0"/>
            <a:t>Conceptual significance</a:t>
          </a:r>
        </a:p>
      </dgm:t>
    </dgm:pt>
    <dgm:pt modelId="{563F6F50-76AC-4C52-8A7E-AC7F73BFEBF4}" type="parTrans" cxnId="{CFC9FB91-730F-4829-958E-0B72F03B63E0}">
      <dgm:prSet/>
      <dgm:spPr/>
      <dgm:t>
        <a:bodyPr/>
        <a:lstStyle/>
        <a:p>
          <a:endParaRPr lang="en-GB"/>
        </a:p>
      </dgm:t>
    </dgm:pt>
    <dgm:pt modelId="{72725168-48CC-485F-93F4-ECE5C051DE70}" type="sibTrans" cxnId="{CFC9FB91-730F-4829-958E-0B72F03B63E0}">
      <dgm:prSet/>
      <dgm:spPr/>
      <dgm:t>
        <a:bodyPr/>
        <a:lstStyle/>
        <a:p>
          <a:endParaRPr lang="en-GB"/>
        </a:p>
      </dgm:t>
    </dgm:pt>
    <dgm:pt modelId="{FB306B47-7A1F-43AF-94F9-22F8D864BE96}">
      <dgm:prSet/>
      <dgm:spPr/>
      <dgm:t>
        <a:bodyPr/>
        <a:lstStyle/>
        <a:p>
          <a:r>
            <a:rPr lang="en-GB"/>
            <a:t>Final inclusion</a:t>
          </a:r>
        </a:p>
      </dgm:t>
    </dgm:pt>
    <dgm:pt modelId="{1FCEDA4A-7A09-4663-83A9-351D59F11D6C}" type="parTrans" cxnId="{5DC5F958-44AD-4929-9BB8-B18767174989}">
      <dgm:prSet/>
      <dgm:spPr/>
      <dgm:t>
        <a:bodyPr/>
        <a:lstStyle/>
        <a:p>
          <a:endParaRPr lang="en-GB"/>
        </a:p>
      </dgm:t>
    </dgm:pt>
    <dgm:pt modelId="{22857879-A1F0-41DB-B562-353D0E791BB7}" type="sibTrans" cxnId="{5DC5F958-44AD-4929-9BB8-B18767174989}">
      <dgm:prSet/>
      <dgm:spPr/>
      <dgm:t>
        <a:bodyPr/>
        <a:lstStyle/>
        <a:p>
          <a:endParaRPr lang="en-GB"/>
        </a:p>
      </dgm:t>
    </dgm:pt>
    <dgm:pt modelId="{015DD2B7-6722-4B24-8731-9419D41B502C}">
      <dgm:prSet/>
      <dgm:spPr/>
      <dgm:t>
        <a:bodyPr/>
        <a:lstStyle/>
        <a:p>
          <a:r>
            <a:rPr lang="en-GB" dirty="0"/>
            <a:t>Foundational methods</a:t>
          </a:r>
        </a:p>
      </dgm:t>
    </dgm:pt>
    <dgm:pt modelId="{3D9BEE63-8AD9-458B-A1C0-9362D8FD8227}" type="parTrans" cxnId="{B4566C71-1BA3-439F-A1F9-BEAB2EE960F7}">
      <dgm:prSet/>
      <dgm:spPr/>
      <dgm:t>
        <a:bodyPr/>
        <a:lstStyle/>
        <a:p>
          <a:endParaRPr lang="en-GB"/>
        </a:p>
      </dgm:t>
    </dgm:pt>
    <dgm:pt modelId="{E851744E-C5B3-47C0-80A6-D29D49F05CAB}" type="sibTrans" cxnId="{B4566C71-1BA3-439F-A1F9-BEAB2EE960F7}">
      <dgm:prSet/>
      <dgm:spPr/>
      <dgm:t>
        <a:bodyPr/>
        <a:lstStyle/>
        <a:p>
          <a:endParaRPr lang="en-GB"/>
        </a:p>
      </dgm:t>
    </dgm:pt>
    <dgm:pt modelId="{AF31BFBE-B995-4290-BDBF-EBF98E797AFE}">
      <dgm:prSet/>
      <dgm:spPr/>
      <dgm:t>
        <a:bodyPr/>
        <a:lstStyle/>
        <a:p>
          <a:r>
            <a:rPr lang="en-GB" dirty="0"/>
            <a:t>Algorithmic variants</a:t>
          </a:r>
        </a:p>
      </dgm:t>
    </dgm:pt>
    <dgm:pt modelId="{A01A124C-D8EE-4263-A5B9-A334FB57906D}" type="parTrans" cxnId="{74941878-FC9B-47E3-952C-184F729426E5}">
      <dgm:prSet/>
      <dgm:spPr/>
      <dgm:t>
        <a:bodyPr/>
        <a:lstStyle/>
        <a:p>
          <a:endParaRPr lang="en-GB"/>
        </a:p>
      </dgm:t>
    </dgm:pt>
    <dgm:pt modelId="{14FCEBDC-9E72-4D29-9B0D-BC504B3AAF02}" type="sibTrans" cxnId="{74941878-FC9B-47E3-952C-184F729426E5}">
      <dgm:prSet/>
      <dgm:spPr/>
      <dgm:t>
        <a:bodyPr/>
        <a:lstStyle/>
        <a:p>
          <a:endParaRPr lang="en-GB"/>
        </a:p>
      </dgm:t>
    </dgm:pt>
    <dgm:pt modelId="{FEDE2FBE-79CE-4C16-8861-7089D2FBBC5D}">
      <dgm:prSet/>
      <dgm:spPr/>
      <dgm:t>
        <a:bodyPr/>
        <a:lstStyle/>
        <a:p>
          <a:r>
            <a:rPr lang="en-GB" dirty="0"/>
            <a:t>Modern developments</a:t>
          </a:r>
        </a:p>
      </dgm:t>
    </dgm:pt>
    <dgm:pt modelId="{FA7B2EB4-F402-46BE-AB9D-2BCAF2309205}" type="parTrans" cxnId="{8075C62F-E502-4FA3-AC5E-8CAF4EF2607C}">
      <dgm:prSet/>
      <dgm:spPr/>
      <dgm:t>
        <a:bodyPr/>
        <a:lstStyle/>
        <a:p>
          <a:endParaRPr lang="en-GB"/>
        </a:p>
      </dgm:t>
    </dgm:pt>
    <dgm:pt modelId="{B59AF0FC-3823-4507-9390-7EA20E3D7F6D}" type="sibTrans" cxnId="{8075C62F-E502-4FA3-AC5E-8CAF4EF2607C}">
      <dgm:prSet/>
      <dgm:spPr/>
      <dgm:t>
        <a:bodyPr/>
        <a:lstStyle/>
        <a:p>
          <a:endParaRPr lang="en-GB"/>
        </a:p>
      </dgm:t>
    </dgm:pt>
    <dgm:pt modelId="{B9F0B83E-8779-49C9-AFE0-5DEBD611074A}" type="pres">
      <dgm:prSet presAssocID="{C9C10906-047C-4A20-B7CC-D7B612F29870}" presName="diagram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087CD487-F2BC-42FE-9594-1A2D5C33476C}" type="pres">
      <dgm:prSet presAssocID="{550EA637-AD9F-42B5-BBBB-4B73E4C10781}" presName="root" presStyleCnt="0"/>
      <dgm:spPr/>
    </dgm:pt>
    <dgm:pt modelId="{72E0BADD-D03C-486A-B2A8-D9898A4F4CA6}" type="pres">
      <dgm:prSet presAssocID="{550EA637-AD9F-42B5-BBBB-4B73E4C10781}" presName="rootComposite" presStyleCnt="0"/>
      <dgm:spPr/>
    </dgm:pt>
    <dgm:pt modelId="{93AA0D21-6FBC-4D3D-8DCE-7E296585697A}" type="pres">
      <dgm:prSet presAssocID="{550EA637-AD9F-42B5-BBBB-4B73E4C10781}" presName="rootText" presStyleLbl="node1" presStyleIdx="0" presStyleCnt="3"/>
      <dgm:spPr/>
    </dgm:pt>
    <dgm:pt modelId="{78244CEF-53CB-4FEC-9063-CB807278CC09}" type="pres">
      <dgm:prSet presAssocID="{550EA637-AD9F-42B5-BBBB-4B73E4C10781}" presName="rootConnector" presStyleLbl="node1" presStyleIdx="0" presStyleCnt="3"/>
      <dgm:spPr/>
    </dgm:pt>
    <dgm:pt modelId="{714C899D-CE88-4F4C-AF4E-66AA3B655361}" type="pres">
      <dgm:prSet presAssocID="{550EA637-AD9F-42B5-BBBB-4B73E4C10781}" presName="childShape" presStyleCnt="0"/>
      <dgm:spPr/>
    </dgm:pt>
    <dgm:pt modelId="{08E57DB2-BBF2-43B9-A345-DC0E9647B119}" type="pres">
      <dgm:prSet presAssocID="{9268355D-CFCF-43B1-A747-0B870EA3308B}" presName="Name13" presStyleLbl="parChTrans1D2" presStyleIdx="0" presStyleCnt="9"/>
      <dgm:spPr/>
    </dgm:pt>
    <dgm:pt modelId="{A17F267C-58E7-4372-934B-5C2D046245EE}" type="pres">
      <dgm:prSet presAssocID="{1B417A69-3206-4CF4-816E-8EA683D4618E}" presName="childText" presStyleLbl="bgAcc1" presStyleIdx="0" presStyleCnt="9">
        <dgm:presLayoutVars>
          <dgm:bulletEnabled val="1"/>
        </dgm:presLayoutVars>
      </dgm:prSet>
      <dgm:spPr/>
    </dgm:pt>
    <dgm:pt modelId="{AF8B9D97-6751-4A65-9092-A4BE9A6B45A0}" type="pres">
      <dgm:prSet presAssocID="{578652F7-9140-4F49-9668-1E9CDE9943FE}" presName="Name13" presStyleLbl="parChTrans1D2" presStyleIdx="1" presStyleCnt="9"/>
      <dgm:spPr/>
    </dgm:pt>
    <dgm:pt modelId="{34E73279-4C6A-4465-B034-9A51C03F778F}" type="pres">
      <dgm:prSet presAssocID="{3E0C2CF0-ADAE-48EB-989D-92C19067DA89}" presName="childText" presStyleLbl="bgAcc1" presStyleIdx="1" presStyleCnt="9">
        <dgm:presLayoutVars>
          <dgm:bulletEnabled val="1"/>
        </dgm:presLayoutVars>
      </dgm:prSet>
      <dgm:spPr/>
    </dgm:pt>
    <dgm:pt modelId="{CAA459FA-B23B-42C5-9911-C410487592CC}" type="pres">
      <dgm:prSet presAssocID="{01A98B21-0BB3-4887-86DD-97B087373EB4}" presName="Name13" presStyleLbl="parChTrans1D2" presStyleIdx="2" presStyleCnt="9"/>
      <dgm:spPr/>
    </dgm:pt>
    <dgm:pt modelId="{A81C5A39-DA9D-499C-AD8D-F23ABC9DA5E0}" type="pres">
      <dgm:prSet presAssocID="{9152CD79-FEA3-4308-AB9D-9E922B7B37D7}" presName="childText" presStyleLbl="bgAcc1" presStyleIdx="2" presStyleCnt="9">
        <dgm:presLayoutVars>
          <dgm:bulletEnabled val="1"/>
        </dgm:presLayoutVars>
      </dgm:prSet>
      <dgm:spPr/>
    </dgm:pt>
    <dgm:pt modelId="{0E799342-61F8-41AE-B71A-A06DA504509F}" type="pres">
      <dgm:prSet presAssocID="{535122B6-9A0E-496B-B404-5EF3CE95F9C3}" presName="root" presStyleCnt="0"/>
      <dgm:spPr/>
    </dgm:pt>
    <dgm:pt modelId="{81E2F1F0-1EC1-44CF-BF17-5748BB570E89}" type="pres">
      <dgm:prSet presAssocID="{535122B6-9A0E-496B-B404-5EF3CE95F9C3}" presName="rootComposite" presStyleCnt="0"/>
      <dgm:spPr/>
    </dgm:pt>
    <dgm:pt modelId="{EB732AC4-7F6C-43EE-8DD7-3C840C17E70E}" type="pres">
      <dgm:prSet presAssocID="{535122B6-9A0E-496B-B404-5EF3CE95F9C3}" presName="rootText" presStyleLbl="node1" presStyleIdx="1" presStyleCnt="3"/>
      <dgm:spPr/>
    </dgm:pt>
    <dgm:pt modelId="{7A6F4AEC-0B06-4534-9C41-B5896414ED06}" type="pres">
      <dgm:prSet presAssocID="{535122B6-9A0E-496B-B404-5EF3CE95F9C3}" presName="rootConnector" presStyleLbl="node1" presStyleIdx="1" presStyleCnt="3"/>
      <dgm:spPr/>
    </dgm:pt>
    <dgm:pt modelId="{2B38ABE0-2701-45CB-B125-75F9DCF72C4C}" type="pres">
      <dgm:prSet presAssocID="{535122B6-9A0E-496B-B404-5EF3CE95F9C3}" presName="childShape" presStyleCnt="0"/>
      <dgm:spPr/>
    </dgm:pt>
    <dgm:pt modelId="{835706D0-471A-4CAA-98BC-80885D4CA2CF}" type="pres">
      <dgm:prSet presAssocID="{E11A2D0C-6EE7-41CD-9C57-034278C505D4}" presName="Name13" presStyleLbl="parChTrans1D2" presStyleIdx="3" presStyleCnt="9"/>
      <dgm:spPr/>
    </dgm:pt>
    <dgm:pt modelId="{4858B34B-8A44-4EA0-B027-64A1E4C3FD35}" type="pres">
      <dgm:prSet presAssocID="{9AE4E0D8-F09D-4FB7-9A33-578EC530389D}" presName="childText" presStyleLbl="bgAcc1" presStyleIdx="3" presStyleCnt="9">
        <dgm:presLayoutVars>
          <dgm:bulletEnabled val="1"/>
        </dgm:presLayoutVars>
      </dgm:prSet>
      <dgm:spPr/>
    </dgm:pt>
    <dgm:pt modelId="{008C606F-C3BA-4519-BDF0-D69AAAF495E6}" type="pres">
      <dgm:prSet presAssocID="{80D9F7F3-A595-45D8-A9FC-C9C0EFAFE336}" presName="Name13" presStyleLbl="parChTrans1D2" presStyleIdx="4" presStyleCnt="9"/>
      <dgm:spPr/>
    </dgm:pt>
    <dgm:pt modelId="{C3F355B5-923E-4815-B540-859706716111}" type="pres">
      <dgm:prSet presAssocID="{98EAF298-342B-4E2E-9156-D3DA266D2CE2}" presName="childText" presStyleLbl="bgAcc1" presStyleIdx="4" presStyleCnt="9">
        <dgm:presLayoutVars>
          <dgm:bulletEnabled val="1"/>
        </dgm:presLayoutVars>
      </dgm:prSet>
      <dgm:spPr/>
    </dgm:pt>
    <dgm:pt modelId="{AFFF3EA8-16EF-4BA4-96A2-9C32CBC5A52C}" type="pres">
      <dgm:prSet presAssocID="{563F6F50-76AC-4C52-8A7E-AC7F73BFEBF4}" presName="Name13" presStyleLbl="parChTrans1D2" presStyleIdx="5" presStyleCnt="9"/>
      <dgm:spPr/>
    </dgm:pt>
    <dgm:pt modelId="{724C2400-830A-49A0-9C3F-B0D4E428E697}" type="pres">
      <dgm:prSet presAssocID="{C383EDF1-9177-4E34-A883-2F2744117E20}" presName="childText" presStyleLbl="bgAcc1" presStyleIdx="5" presStyleCnt="9">
        <dgm:presLayoutVars>
          <dgm:bulletEnabled val="1"/>
        </dgm:presLayoutVars>
      </dgm:prSet>
      <dgm:spPr/>
    </dgm:pt>
    <dgm:pt modelId="{15624797-3793-4803-A437-8298E5AAEF9A}" type="pres">
      <dgm:prSet presAssocID="{FB306B47-7A1F-43AF-94F9-22F8D864BE96}" presName="root" presStyleCnt="0"/>
      <dgm:spPr/>
    </dgm:pt>
    <dgm:pt modelId="{CB4AB39A-4719-4BF6-9FB7-E58D88287A82}" type="pres">
      <dgm:prSet presAssocID="{FB306B47-7A1F-43AF-94F9-22F8D864BE96}" presName="rootComposite" presStyleCnt="0"/>
      <dgm:spPr/>
    </dgm:pt>
    <dgm:pt modelId="{98A547FB-1259-4D47-882C-D00E75709C70}" type="pres">
      <dgm:prSet presAssocID="{FB306B47-7A1F-43AF-94F9-22F8D864BE96}" presName="rootText" presStyleLbl="node1" presStyleIdx="2" presStyleCnt="3"/>
      <dgm:spPr/>
    </dgm:pt>
    <dgm:pt modelId="{1EC9731E-D198-4E23-9E64-8567A5F70F57}" type="pres">
      <dgm:prSet presAssocID="{FB306B47-7A1F-43AF-94F9-22F8D864BE96}" presName="rootConnector" presStyleLbl="node1" presStyleIdx="2" presStyleCnt="3"/>
      <dgm:spPr/>
    </dgm:pt>
    <dgm:pt modelId="{2DE33FE9-BC0E-4BA0-8BD4-C6DEA37894DF}" type="pres">
      <dgm:prSet presAssocID="{FB306B47-7A1F-43AF-94F9-22F8D864BE96}" presName="childShape" presStyleCnt="0"/>
      <dgm:spPr/>
    </dgm:pt>
    <dgm:pt modelId="{3BB52678-B26F-431A-A8B6-F332A5FBC960}" type="pres">
      <dgm:prSet presAssocID="{3D9BEE63-8AD9-458B-A1C0-9362D8FD8227}" presName="Name13" presStyleLbl="parChTrans1D2" presStyleIdx="6" presStyleCnt="9"/>
      <dgm:spPr/>
    </dgm:pt>
    <dgm:pt modelId="{4CBCFC18-BC5D-4E4C-9AE4-9825B0AEE0E5}" type="pres">
      <dgm:prSet presAssocID="{015DD2B7-6722-4B24-8731-9419D41B502C}" presName="childText" presStyleLbl="bgAcc1" presStyleIdx="6" presStyleCnt="9">
        <dgm:presLayoutVars>
          <dgm:bulletEnabled val="1"/>
        </dgm:presLayoutVars>
      </dgm:prSet>
      <dgm:spPr/>
    </dgm:pt>
    <dgm:pt modelId="{419F81FE-2678-4767-84D3-DCAE0C1C35F3}" type="pres">
      <dgm:prSet presAssocID="{A01A124C-D8EE-4263-A5B9-A334FB57906D}" presName="Name13" presStyleLbl="parChTrans1D2" presStyleIdx="7" presStyleCnt="9"/>
      <dgm:spPr/>
    </dgm:pt>
    <dgm:pt modelId="{C1A25613-FFAB-4AB4-9686-8AEF9529FCDD}" type="pres">
      <dgm:prSet presAssocID="{AF31BFBE-B995-4290-BDBF-EBF98E797AFE}" presName="childText" presStyleLbl="bgAcc1" presStyleIdx="7" presStyleCnt="9">
        <dgm:presLayoutVars>
          <dgm:bulletEnabled val="1"/>
        </dgm:presLayoutVars>
      </dgm:prSet>
      <dgm:spPr/>
    </dgm:pt>
    <dgm:pt modelId="{2BF5A313-E8C7-4B1B-BDA8-FB16BDDAD459}" type="pres">
      <dgm:prSet presAssocID="{FA7B2EB4-F402-46BE-AB9D-2BCAF2309205}" presName="Name13" presStyleLbl="parChTrans1D2" presStyleIdx="8" presStyleCnt="9"/>
      <dgm:spPr/>
    </dgm:pt>
    <dgm:pt modelId="{0D0599F6-756D-4DD1-AE12-9B63844C9296}" type="pres">
      <dgm:prSet presAssocID="{FEDE2FBE-79CE-4C16-8861-7089D2FBBC5D}" presName="childText" presStyleLbl="bgAcc1" presStyleIdx="8" presStyleCnt="9">
        <dgm:presLayoutVars>
          <dgm:bulletEnabled val="1"/>
        </dgm:presLayoutVars>
      </dgm:prSet>
      <dgm:spPr/>
    </dgm:pt>
  </dgm:ptLst>
  <dgm:cxnLst>
    <dgm:cxn modelId="{F68F5D03-2452-4E51-9DB5-5C3C231B69AB}" type="presOf" srcId="{9AE4E0D8-F09D-4FB7-9A33-578EC530389D}" destId="{4858B34B-8A44-4EA0-B027-64A1E4C3FD35}" srcOrd="0" destOrd="0" presId="urn:microsoft.com/office/officeart/2005/8/layout/hierarchy3"/>
    <dgm:cxn modelId="{9812E710-AABC-4129-B4F6-3F640FEE9FEB}" type="presOf" srcId="{578652F7-9140-4F49-9668-1E9CDE9943FE}" destId="{AF8B9D97-6751-4A65-9092-A4BE9A6B45A0}" srcOrd="0" destOrd="0" presId="urn:microsoft.com/office/officeart/2005/8/layout/hierarchy3"/>
    <dgm:cxn modelId="{F3397412-D9C5-40DB-BC92-68CEE813CF43}" type="presOf" srcId="{1B417A69-3206-4CF4-816E-8EA683D4618E}" destId="{A17F267C-58E7-4372-934B-5C2D046245EE}" srcOrd="0" destOrd="0" presId="urn:microsoft.com/office/officeart/2005/8/layout/hierarchy3"/>
    <dgm:cxn modelId="{93A52213-D701-4807-86E8-548679BC9D47}" type="presOf" srcId="{98EAF298-342B-4E2E-9156-D3DA266D2CE2}" destId="{C3F355B5-923E-4815-B540-859706716111}" srcOrd="0" destOrd="0" presId="urn:microsoft.com/office/officeart/2005/8/layout/hierarchy3"/>
    <dgm:cxn modelId="{C89B2F16-CD72-4976-B8BA-97CF44E82154}" srcId="{535122B6-9A0E-496B-B404-5EF3CE95F9C3}" destId="{98EAF298-342B-4E2E-9156-D3DA266D2CE2}" srcOrd="1" destOrd="0" parTransId="{80D9F7F3-A595-45D8-A9FC-C9C0EFAFE336}" sibTransId="{003A763D-CC08-49C4-8F14-82DAA53573A2}"/>
    <dgm:cxn modelId="{3A3CD218-B42C-4F87-850C-B33EE69FB330}" type="presOf" srcId="{80D9F7F3-A595-45D8-A9FC-C9C0EFAFE336}" destId="{008C606F-C3BA-4519-BDF0-D69AAAF495E6}" srcOrd="0" destOrd="0" presId="urn:microsoft.com/office/officeart/2005/8/layout/hierarchy3"/>
    <dgm:cxn modelId="{0F1E641A-7E1F-48A4-83A2-9058904820BD}" type="presOf" srcId="{A01A124C-D8EE-4263-A5B9-A334FB57906D}" destId="{419F81FE-2678-4767-84D3-DCAE0C1C35F3}" srcOrd="0" destOrd="0" presId="urn:microsoft.com/office/officeart/2005/8/layout/hierarchy3"/>
    <dgm:cxn modelId="{8FFF0B1D-1439-401A-81BC-B313E6290011}" type="presOf" srcId="{C383EDF1-9177-4E34-A883-2F2744117E20}" destId="{724C2400-830A-49A0-9C3F-B0D4E428E697}" srcOrd="0" destOrd="0" presId="urn:microsoft.com/office/officeart/2005/8/layout/hierarchy3"/>
    <dgm:cxn modelId="{ABED961D-9E4D-4BE4-AA62-9F7981CAD62C}" type="presOf" srcId="{E11A2D0C-6EE7-41CD-9C57-034278C505D4}" destId="{835706D0-471A-4CAA-98BC-80885D4CA2CF}" srcOrd="0" destOrd="0" presId="urn:microsoft.com/office/officeart/2005/8/layout/hierarchy3"/>
    <dgm:cxn modelId="{E3AA6D26-9AC7-4A63-AB40-D2D88A8E44C8}" type="presOf" srcId="{535122B6-9A0E-496B-B404-5EF3CE95F9C3}" destId="{7A6F4AEC-0B06-4534-9C41-B5896414ED06}" srcOrd="1" destOrd="0" presId="urn:microsoft.com/office/officeart/2005/8/layout/hierarchy3"/>
    <dgm:cxn modelId="{8075C62F-E502-4FA3-AC5E-8CAF4EF2607C}" srcId="{FB306B47-7A1F-43AF-94F9-22F8D864BE96}" destId="{FEDE2FBE-79CE-4C16-8861-7089D2FBBC5D}" srcOrd="2" destOrd="0" parTransId="{FA7B2EB4-F402-46BE-AB9D-2BCAF2309205}" sibTransId="{B59AF0FC-3823-4507-9390-7EA20E3D7F6D}"/>
    <dgm:cxn modelId="{24F32E36-2E0D-4595-AB23-ADDE1479B36F}" type="presOf" srcId="{3E0C2CF0-ADAE-48EB-989D-92C19067DA89}" destId="{34E73279-4C6A-4465-B034-9A51C03F778F}" srcOrd="0" destOrd="0" presId="urn:microsoft.com/office/officeart/2005/8/layout/hierarchy3"/>
    <dgm:cxn modelId="{0DC93D3B-CA19-49DC-8016-63166C2DE51C}" type="presOf" srcId="{FA7B2EB4-F402-46BE-AB9D-2BCAF2309205}" destId="{2BF5A313-E8C7-4B1B-BDA8-FB16BDDAD459}" srcOrd="0" destOrd="0" presId="urn:microsoft.com/office/officeart/2005/8/layout/hierarchy3"/>
    <dgm:cxn modelId="{DD7EB45E-7550-4E56-94F3-4E46DD7AA822}" type="presOf" srcId="{9268355D-CFCF-43B1-A747-0B870EA3308B}" destId="{08E57DB2-BBF2-43B9-A345-DC0E9647B119}" srcOrd="0" destOrd="0" presId="urn:microsoft.com/office/officeart/2005/8/layout/hierarchy3"/>
    <dgm:cxn modelId="{8EA08460-D485-4C74-943D-67CC26E54F6A}" srcId="{550EA637-AD9F-42B5-BBBB-4B73E4C10781}" destId="{1B417A69-3206-4CF4-816E-8EA683D4618E}" srcOrd="0" destOrd="0" parTransId="{9268355D-CFCF-43B1-A747-0B870EA3308B}" sibTransId="{82135650-E26B-4ECE-9626-930474642EF0}"/>
    <dgm:cxn modelId="{3A835B66-994F-46F9-ADF7-5E3DE31B0B2E}" type="presOf" srcId="{550EA637-AD9F-42B5-BBBB-4B73E4C10781}" destId="{93AA0D21-6FBC-4D3D-8DCE-7E296585697A}" srcOrd="0" destOrd="0" presId="urn:microsoft.com/office/officeart/2005/8/layout/hierarchy3"/>
    <dgm:cxn modelId="{763C5D69-BACF-4A19-97C3-72A5FBC7C152}" type="presOf" srcId="{563F6F50-76AC-4C52-8A7E-AC7F73BFEBF4}" destId="{AFFF3EA8-16EF-4BA4-96A2-9C32CBC5A52C}" srcOrd="0" destOrd="0" presId="urn:microsoft.com/office/officeart/2005/8/layout/hierarchy3"/>
    <dgm:cxn modelId="{2E32276E-BEB4-4146-895C-E36AC4C3F64D}" type="presOf" srcId="{C9C10906-047C-4A20-B7CC-D7B612F29870}" destId="{B9F0B83E-8779-49C9-AFE0-5DEBD611074A}" srcOrd="0" destOrd="0" presId="urn:microsoft.com/office/officeart/2005/8/layout/hierarchy3"/>
    <dgm:cxn modelId="{BF6D9170-9072-439B-975F-A503F0C5E46E}" type="presOf" srcId="{015DD2B7-6722-4B24-8731-9419D41B502C}" destId="{4CBCFC18-BC5D-4E4C-9AE4-9825B0AEE0E5}" srcOrd="0" destOrd="0" presId="urn:microsoft.com/office/officeart/2005/8/layout/hierarchy3"/>
    <dgm:cxn modelId="{B4566C71-1BA3-439F-A1F9-BEAB2EE960F7}" srcId="{FB306B47-7A1F-43AF-94F9-22F8D864BE96}" destId="{015DD2B7-6722-4B24-8731-9419D41B502C}" srcOrd="0" destOrd="0" parTransId="{3D9BEE63-8AD9-458B-A1C0-9362D8FD8227}" sibTransId="{E851744E-C5B3-47C0-80A6-D29D49F05CAB}"/>
    <dgm:cxn modelId="{E46CFC71-4D7E-47A2-B1C3-534B75754E36}" type="presOf" srcId="{FB306B47-7A1F-43AF-94F9-22F8D864BE96}" destId="{1EC9731E-D198-4E23-9E64-8567A5F70F57}" srcOrd="1" destOrd="0" presId="urn:microsoft.com/office/officeart/2005/8/layout/hierarchy3"/>
    <dgm:cxn modelId="{74941878-FC9B-47E3-952C-184F729426E5}" srcId="{FB306B47-7A1F-43AF-94F9-22F8D864BE96}" destId="{AF31BFBE-B995-4290-BDBF-EBF98E797AFE}" srcOrd="1" destOrd="0" parTransId="{A01A124C-D8EE-4263-A5B9-A334FB57906D}" sibTransId="{14FCEBDC-9E72-4D29-9B0D-BC504B3AAF02}"/>
    <dgm:cxn modelId="{5DC5F958-44AD-4929-9BB8-B18767174989}" srcId="{C9C10906-047C-4A20-B7CC-D7B612F29870}" destId="{FB306B47-7A1F-43AF-94F9-22F8D864BE96}" srcOrd="2" destOrd="0" parTransId="{1FCEDA4A-7A09-4663-83A9-351D59F11D6C}" sibTransId="{22857879-A1F0-41DB-B562-353D0E791BB7}"/>
    <dgm:cxn modelId="{6E9B2459-8FAE-4A1C-9EB4-E9067551A838}" type="presOf" srcId="{535122B6-9A0E-496B-B404-5EF3CE95F9C3}" destId="{EB732AC4-7F6C-43EE-8DD7-3C840C17E70E}" srcOrd="0" destOrd="0" presId="urn:microsoft.com/office/officeart/2005/8/layout/hierarchy3"/>
    <dgm:cxn modelId="{A624DB5A-4CE2-4CD6-A1E3-9E6C5A3E0704}" srcId="{535122B6-9A0E-496B-B404-5EF3CE95F9C3}" destId="{9AE4E0D8-F09D-4FB7-9A33-578EC530389D}" srcOrd="0" destOrd="0" parTransId="{E11A2D0C-6EE7-41CD-9C57-034278C505D4}" sibTransId="{6A4F3DE0-684D-422C-A523-B012BBF83BE2}"/>
    <dgm:cxn modelId="{CFC9FB91-730F-4829-958E-0B72F03B63E0}" srcId="{535122B6-9A0E-496B-B404-5EF3CE95F9C3}" destId="{C383EDF1-9177-4E34-A883-2F2744117E20}" srcOrd="2" destOrd="0" parTransId="{563F6F50-76AC-4C52-8A7E-AC7F73BFEBF4}" sibTransId="{72725168-48CC-485F-93F4-ECE5C051DE70}"/>
    <dgm:cxn modelId="{697FD59A-AAE1-4D45-B4CA-3204605CB7AB}" srcId="{C9C10906-047C-4A20-B7CC-D7B612F29870}" destId="{535122B6-9A0E-496B-B404-5EF3CE95F9C3}" srcOrd="1" destOrd="0" parTransId="{B89C9D5E-A5CF-420C-8177-DA574E2266CA}" sibTransId="{46E9E02C-B82D-4683-BE72-DD31F749B279}"/>
    <dgm:cxn modelId="{DDA0A19B-87B7-4C5D-8926-08C868C25423}" type="presOf" srcId="{3D9BEE63-8AD9-458B-A1C0-9362D8FD8227}" destId="{3BB52678-B26F-431A-A8B6-F332A5FBC960}" srcOrd="0" destOrd="0" presId="urn:microsoft.com/office/officeart/2005/8/layout/hierarchy3"/>
    <dgm:cxn modelId="{5B53B29E-58D2-43B9-B26F-A65A25A95ABB}" type="presOf" srcId="{AF31BFBE-B995-4290-BDBF-EBF98E797AFE}" destId="{C1A25613-FFAB-4AB4-9686-8AEF9529FCDD}" srcOrd="0" destOrd="0" presId="urn:microsoft.com/office/officeart/2005/8/layout/hierarchy3"/>
    <dgm:cxn modelId="{BA3D4DA7-D523-4CB4-A796-3B689B1BFE95}" type="presOf" srcId="{550EA637-AD9F-42B5-BBBB-4B73E4C10781}" destId="{78244CEF-53CB-4FEC-9063-CB807278CC09}" srcOrd="1" destOrd="0" presId="urn:microsoft.com/office/officeart/2005/8/layout/hierarchy3"/>
    <dgm:cxn modelId="{76CA9CAB-5FDC-404F-A2F5-5642F512CDB2}" srcId="{550EA637-AD9F-42B5-BBBB-4B73E4C10781}" destId="{9152CD79-FEA3-4308-AB9D-9E922B7B37D7}" srcOrd="2" destOrd="0" parTransId="{01A98B21-0BB3-4887-86DD-97B087373EB4}" sibTransId="{634CC958-BBCE-4188-9428-164095F483E1}"/>
    <dgm:cxn modelId="{CEDD02AF-9A1B-42C2-958A-387D7B85616C}" type="presOf" srcId="{9152CD79-FEA3-4308-AB9D-9E922B7B37D7}" destId="{A81C5A39-DA9D-499C-AD8D-F23ABC9DA5E0}" srcOrd="0" destOrd="0" presId="urn:microsoft.com/office/officeart/2005/8/layout/hierarchy3"/>
    <dgm:cxn modelId="{A94996D2-E07B-497C-81F5-7617E86CCFF4}" type="presOf" srcId="{FEDE2FBE-79CE-4C16-8861-7089D2FBBC5D}" destId="{0D0599F6-756D-4DD1-AE12-9B63844C9296}" srcOrd="0" destOrd="0" presId="urn:microsoft.com/office/officeart/2005/8/layout/hierarchy3"/>
    <dgm:cxn modelId="{69993FEA-EA9C-4EE4-B87E-738E8EA0D624}" srcId="{550EA637-AD9F-42B5-BBBB-4B73E4C10781}" destId="{3E0C2CF0-ADAE-48EB-989D-92C19067DA89}" srcOrd="1" destOrd="0" parTransId="{578652F7-9140-4F49-9668-1E9CDE9943FE}" sibTransId="{A8ED7824-1302-421A-8725-C9E78EBAD7A9}"/>
    <dgm:cxn modelId="{278C68F6-FDEA-4A88-BEFC-205F19C6AEBC}" srcId="{C9C10906-047C-4A20-B7CC-D7B612F29870}" destId="{550EA637-AD9F-42B5-BBBB-4B73E4C10781}" srcOrd="0" destOrd="0" parTransId="{3D80FDCF-71FE-4E66-8EE9-E701EA585B31}" sibTransId="{70E3E5C5-D16B-4C54-A259-08DF85FBBC44}"/>
    <dgm:cxn modelId="{725EC2F8-2791-4BD3-B948-8566D7CB84D9}" type="presOf" srcId="{FB306B47-7A1F-43AF-94F9-22F8D864BE96}" destId="{98A547FB-1259-4D47-882C-D00E75709C70}" srcOrd="0" destOrd="0" presId="urn:microsoft.com/office/officeart/2005/8/layout/hierarchy3"/>
    <dgm:cxn modelId="{B8D81FFB-D3DF-4E6B-A937-80CDCF7A1C05}" type="presOf" srcId="{01A98B21-0BB3-4887-86DD-97B087373EB4}" destId="{CAA459FA-B23B-42C5-9911-C410487592CC}" srcOrd="0" destOrd="0" presId="urn:microsoft.com/office/officeart/2005/8/layout/hierarchy3"/>
    <dgm:cxn modelId="{D2BF2C56-BF3E-407C-9369-7658AC712011}" type="presParOf" srcId="{B9F0B83E-8779-49C9-AFE0-5DEBD611074A}" destId="{087CD487-F2BC-42FE-9594-1A2D5C33476C}" srcOrd="0" destOrd="0" presId="urn:microsoft.com/office/officeart/2005/8/layout/hierarchy3"/>
    <dgm:cxn modelId="{690B3C69-8C76-4278-9D3A-C9312BFF3495}" type="presParOf" srcId="{087CD487-F2BC-42FE-9594-1A2D5C33476C}" destId="{72E0BADD-D03C-486A-B2A8-D9898A4F4CA6}" srcOrd="0" destOrd="0" presId="urn:microsoft.com/office/officeart/2005/8/layout/hierarchy3"/>
    <dgm:cxn modelId="{FC56862E-14E4-4BB5-B88C-A88CCE97D1D4}" type="presParOf" srcId="{72E0BADD-D03C-486A-B2A8-D9898A4F4CA6}" destId="{93AA0D21-6FBC-4D3D-8DCE-7E296585697A}" srcOrd="0" destOrd="0" presId="urn:microsoft.com/office/officeart/2005/8/layout/hierarchy3"/>
    <dgm:cxn modelId="{22C53157-7127-44B1-9F77-1085163F616D}" type="presParOf" srcId="{72E0BADD-D03C-486A-B2A8-D9898A4F4CA6}" destId="{78244CEF-53CB-4FEC-9063-CB807278CC09}" srcOrd="1" destOrd="0" presId="urn:microsoft.com/office/officeart/2005/8/layout/hierarchy3"/>
    <dgm:cxn modelId="{31B2EDC4-AD80-40DC-ABCB-5BC202B06AD2}" type="presParOf" srcId="{087CD487-F2BC-42FE-9594-1A2D5C33476C}" destId="{714C899D-CE88-4F4C-AF4E-66AA3B655361}" srcOrd="1" destOrd="0" presId="urn:microsoft.com/office/officeart/2005/8/layout/hierarchy3"/>
    <dgm:cxn modelId="{EB02684E-5C22-49CB-9043-2475DEA6E6DD}" type="presParOf" srcId="{714C899D-CE88-4F4C-AF4E-66AA3B655361}" destId="{08E57DB2-BBF2-43B9-A345-DC0E9647B119}" srcOrd="0" destOrd="0" presId="urn:microsoft.com/office/officeart/2005/8/layout/hierarchy3"/>
    <dgm:cxn modelId="{E0A5DD03-B774-465F-B312-21596642F602}" type="presParOf" srcId="{714C899D-CE88-4F4C-AF4E-66AA3B655361}" destId="{A17F267C-58E7-4372-934B-5C2D046245EE}" srcOrd="1" destOrd="0" presId="urn:microsoft.com/office/officeart/2005/8/layout/hierarchy3"/>
    <dgm:cxn modelId="{B575B86C-48E2-4DB0-A77E-1ABB0622048E}" type="presParOf" srcId="{714C899D-CE88-4F4C-AF4E-66AA3B655361}" destId="{AF8B9D97-6751-4A65-9092-A4BE9A6B45A0}" srcOrd="2" destOrd="0" presId="urn:microsoft.com/office/officeart/2005/8/layout/hierarchy3"/>
    <dgm:cxn modelId="{163ACCD0-ACD7-4640-BFA8-80FF68F0CB0B}" type="presParOf" srcId="{714C899D-CE88-4F4C-AF4E-66AA3B655361}" destId="{34E73279-4C6A-4465-B034-9A51C03F778F}" srcOrd="3" destOrd="0" presId="urn:microsoft.com/office/officeart/2005/8/layout/hierarchy3"/>
    <dgm:cxn modelId="{142AEE19-DB9F-4F37-B15C-4D65CA8046F9}" type="presParOf" srcId="{714C899D-CE88-4F4C-AF4E-66AA3B655361}" destId="{CAA459FA-B23B-42C5-9911-C410487592CC}" srcOrd="4" destOrd="0" presId="urn:microsoft.com/office/officeart/2005/8/layout/hierarchy3"/>
    <dgm:cxn modelId="{9FF1EAED-0D05-458C-BEA8-1C2C0392EAE5}" type="presParOf" srcId="{714C899D-CE88-4F4C-AF4E-66AA3B655361}" destId="{A81C5A39-DA9D-499C-AD8D-F23ABC9DA5E0}" srcOrd="5" destOrd="0" presId="urn:microsoft.com/office/officeart/2005/8/layout/hierarchy3"/>
    <dgm:cxn modelId="{91F765C2-5052-4206-A5DE-2BF96371878E}" type="presParOf" srcId="{B9F0B83E-8779-49C9-AFE0-5DEBD611074A}" destId="{0E799342-61F8-41AE-B71A-A06DA504509F}" srcOrd="1" destOrd="0" presId="urn:microsoft.com/office/officeart/2005/8/layout/hierarchy3"/>
    <dgm:cxn modelId="{376F3A2A-7822-497C-A086-2639D1A42C9B}" type="presParOf" srcId="{0E799342-61F8-41AE-B71A-A06DA504509F}" destId="{81E2F1F0-1EC1-44CF-BF17-5748BB570E89}" srcOrd="0" destOrd="0" presId="urn:microsoft.com/office/officeart/2005/8/layout/hierarchy3"/>
    <dgm:cxn modelId="{88682773-08A3-4F20-814D-6E65C38F9B28}" type="presParOf" srcId="{81E2F1F0-1EC1-44CF-BF17-5748BB570E89}" destId="{EB732AC4-7F6C-43EE-8DD7-3C840C17E70E}" srcOrd="0" destOrd="0" presId="urn:microsoft.com/office/officeart/2005/8/layout/hierarchy3"/>
    <dgm:cxn modelId="{067471A7-3F2A-44AA-8562-9A29B99293EF}" type="presParOf" srcId="{81E2F1F0-1EC1-44CF-BF17-5748BB570E89}" destId="{7A6F4AEC-0B06-4534-9C41-B5896414ED06}" srcOrd="1" destOrd="0" presId="urn:microsoft.com/office/officeart/2005/8/layout/hierarchy3"/>
    <dgm:cxn modelId="{69083556-76BD-4F51-8770-BFA69C745BF5}" type="presParOf" srcId="{0E799342-61F8-41AE-B71A-A06DA504509F}" destId="{2B38ABE0-2701-45CB-B125-75F9DCF72C4C}" srcOrd="1" destOrd="0" presId="urn:microsoft.com/office/officeart/2005/8/layout/hierarchy3"/>
    <dgm:cxn modelId="{FA3D575E-5242-4133-A826-39215BCC56E6}" type="presParOf" srcId="{2B38ABE0-2701-45CB-B125-75F9DCF72C4C}" destId="{835706D0-471A-4CAA-98BC-80885D4CA2CF}" srcOrd="0" destOrd="0" presId="urn:microsoft.com/office/officeart/2005/8/layout/hierarchy3"/>
    <dgm:cxn modelId="{816BB2C6-E066-41C9-A050-9CD45672B69A}" type="presParOf" srcId="{2B38ABE0-2701-45CB-B125-75F9DCF72C4C}" destId="{4858B34B-8A44-4EA0-B027-64A1E4C3FD35}" srcOrd="1" destOrd="0" presId="urn:microsoft.com/office/officeart/2005/8/layout/hierarchy3"/>
    <dgm:cxn modelId="{6D859673-AB28-4B2B-8C29-836DC816270B}" type="presParOf" srcId="{2B38ABE0-2701-45CB-B125-75F9DCF72C4C}" destId="{008C606F-C3BA-4519-BDF0-D69AAAF495E6}" srcOrd="2" destOrd="0" presId="urn:microsoft.com/office/officeart/2005/8/layout/hierarchy3"/>
    <dgm:cxn modelId="{97F027E1-493E-4087-AA56-F5F479C9FE14}" type="presParOf" srcId="{2B38ABE0-2701-45CB-B125-75F9DCF72C4C}" destId="{C3F355B5-923E-4815-B540-859706716111}" srcOrd="3" destOrd="0" presId="urn:microsoft.com/office/officeart/2005/8/layout/hierarchy3"/>
    <dgm:cxn modelId="{116DB040-BF39-4161-97E6-EB2210E645AD}" type="presParOf" srcId="{2B38ABE0-2701-45CB-B125-75F9DCF72C4C}" destId="{AFFF3EA8-16EF-4BA4-96A2-9C32CBC5A52C}" srcOrd="4" destOrd="0" presId="urn:microsoft.com/office/officeart/2005/8/layout/hierarchy3"/>
    <dgm:cxn modelId="{D2271553-932A-4437-B930-A46D0313BA37}" type="presParOf" srcId="{2B38ABE0-2701-45CB-B125-75F9DCF72C4C}" destId="{724C2400-830A-49A0-9C3F-B0D4E428E697}" srcOrd="5" destOrd="0" presId="urn:microsoft.com/office/officeart/2005/8/layout/hierarchy3"/>
    <dgm:cxn modelId="{A453F2D4-BBB7-43AC-93BC-43BD8AEE4A33}" type="presParOf" srcId="{B9F0B83E-8779-49C9-AFE0-5DEBD611074A}" destId="{15624797-3793-4803-A437-8298E5AAEF9A}" srcOrd="2" destOrd="0" presId="urn:microsoft.com/office/officeart/2005/8/layout/hierarchy3"/>
    <dgm:cxn modelId="{3C66B4E1-FAA3-4A7E-AC8E-E2AA20BB75E5}" type="presParOf" srcId="{15624797-3793-4803-A437-8298E5AAEF9A}" destId="{CB4AB39A-4719-4BF6-9FB7-E58D88287A82}" srcOrd="0" destOrd="0" presId="urn:microsoft.com/office/officeart/2005/8/layout/hierarchy3"/>
    <dgm:cxn modelId="{DDA7EF8F-FC0B-4649-9906-47CA7D8A4CB0}" type="presParOf" srcId="{CB4AB39A-4719-4BF6-9FB7-E58D88287A82}" destId="{98A547FB-1259-4D47-882C-D00E75709C70}" srcOrd="0" destOrd="0" presId="urn:microsoft.com/office/officeart/2005/8/layout/hierarchy3"/>
    <dgm:cxn modelId="{C3CE65EE-1447-4327-B8FC-2218EFA3C193}" type="presParOf" srcId="{CB4AB39A-4719-4BF6-9FB7-E58D88287A82}" destId="{1EC9731E-D198-4E23-9E64-8567A5F70F57}" srcOrd="1" destOrd="0" presId="urn:microsoft.com/office/officeart/2005/8/layout/hierarchy3"/>
    <dgm:cxn modelId="{6D3FF292-F49D-4797-96C6-2B334FCBBFA9}" type="presParOf" srcId="{15624797-3793-4803-A437-8298E5AAEF9A}" destId="{2DE33FE9-BC0E-4BA0-8BD4-C6DEA37894DF}" srcOrd="1" destOrd="0" presId="urn:microsoft.com/office/officeart/2005/8/layout/hierarchy3"/>
    <dgm:cxn modelId="{49EE64B6-B472-4F8A-83DA-2A93BFC42324}" type="presParOf" srcId="{2DE33FE9-BC0E-4BA0-8BD4-C6DEA37894DF}" destId="{3BB52678-B26F-431A-A8B6-F332A5FBC960}" srcOrd="0" destOrd="0" presId="urn:microsoft.com/office/officeart/2005/8/layout/hierarchy3"/>
    <dgm:cxn modelId="{0A500BF9-D860-4F52-B1AD-EA0FF25BB097}" type="presParOf" srcId="{2DE33FE9-BC0E-4BA0-8BD4-C6DEA37894DF}" destId="{4CBCFC18-BC5D-4E4C-9AE4-9825B0AEE0E5}" srcOrd="1" destOrd="0" presId="urn:microsoft.com/office/officeart/2005/8/layout/hierarchy3"/>
    <dgm:cxn modelId="{E8D6602D-0318-4BA7-B801-B740A200B13E}" type="presParOf" srcId="{2DE33FE9-BC0E-4BA0-8BD4-C6DEA37894DF}" destId="{419F81FE-2678-4767-84D3-DCAE0C1C35F3}" srcOrd="2" destOrd="0" presId="urn:microsoft.com/office/officeart/2005/8/layout/hierarchy3"/>
    <dgm:cxn modelId="{4D4815C0-23DD-4416-A07D-750EF2FC8974}" type="presParOf" srcId="{2DE33FE9-BC0E-4BA0-8BD4-C6DEA37894DF}" destId="{C1A25613-FFAB-4AB4-9686-8AEF9529FCDD}" srcOrd="3" destOrd="0" presId="urn:microsoft.com/office/officeart/2005/8/layout/hierarchy3"/>
    <dgm:cxn modelId="{94C24966-FF16-4A5F-9CFE-FAD2C0D83835}" type="presParOf" srcId="{2DE33FE9-BC0E-4BA0-8BD4-C6DEA37894DF}" destId="{2BF5A313-E8C7-4B1B-BDA8-FB16BDDAD459}" srcOrd="4" destOrd="0" presId="urn:microsoft.com/office/officeart/2005/8/layout/hierarchy3"/>
    <dgm:cxn modelId="{DD77F7F5-F3E3-45FB-B35B-67FAC3EB6B8D}" type="presParOf" srcId="{2DE33FE9-BC0E-4BA0-8BD4-C6DEA37894DF}" destId="{0D0599F6-756D-4DD1-AE12-9B63844C9296}" srcOrd="5" destOrd="0" presId="urn:microsoft.com/office/officeart/2005/8/layout/hierarchy3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C9C10906-047C-4A20-B7CC-D7B612F29870}" type="doc">
      <dgm:prSet loTypeId="urn:microsoft.com/office/officeart/2005/8/layout/hProcess7" loCatId="list" qsTypeId="urn:microsoft.com/office/officeart/2005/8/quickstyle/simple1" qsCatId="simple" csTypeId="urn:microsoft.com/office/officeart/2005/8/colors/accent1_3" csCatId="accent1" phldr="1"/>
      <dgm:spPr/>
      <dgm:t>
        <a:bodyPr/>
        <a:lstStyle/>
        <a:p>
          <a:endParaRPr lang="en-GB"/>
        </a:p>
      </dgm:t>
    </dgm:pt>
    <dgm:pt modelId="{550EA637-AD9F-42B5-BBBB-4B73E4C10781}">
      <dgm:prSet phldrT="[Text]"/>
      <dgm:spPr/>
      <dgm:t>
        <a:bodyPr/>
        <a:lstStyle/>
        <a:p>
          <a:r>
            <a:rPr lang="en-GB" dirty="0"/>
            <a:t>Literature identification</a:t>
          </a:r>
        </a:p>
      </dgm:t>
    </dgm:pt>
    <dgm:pt modelId="{3D80FDCF-71FE-4E66-8EE9-E701EA585B31}" type="parTrans" cxnId="{278C68F6-FDEA-4A88-BEFC-205F19C6AEBC}">
      <dgm:prSet/>
      <dgm:spPr/>
      <dgm:t>
        <a:bodyPr/>
        <a:lstStyle/>
        <a:p>
          <a:endParaRPr lang="en-GB"/>
        </a:p>
      </dgm:t>
    </dgm:pt>
    <dgm:pt modelId="{70E3E5C5-D16B-4C54-A259-08DF85FBBC44}" type="sibTrans" cxnId="{278C68F6-FDEA-4A88-BEFC-205F19C6AEBC}">
      <dgm:prSet/>
      <dgm:spPr/>
      <dgm:t>
        <a:bodyPr/>
        <a:lstStyle/>
        <a:p>
          <a:endParaRPr lang="en-GB"/>
        </a:p>
      </dgm:t>
    </dgm:pt>
    <dgm:pt modelId="{1B417A69-3206-4CF4-816E-8EA683D4618E}">
      <dgm:prSet/>
      <dgm:spPr/>
      <dgm:t>
        <a:bodyPr/>
        <a:lstStyle/>
        <a:p>
          <a:pPr>
            <a:buFont typeface="Arial" panose="020B0604020202020204" pitchFamily="34" charset="0"/>
            <a:buNone/>
          </a:pPr>
          <a:r>
            <a:rPr lang="en-GB" dirty="0"/>
            <a:t>Representative algorithmic works selected</a:t>
          </a:r>
        </a:p>
      </dgm:t>
    </dgm:pt>
    <dgm:pt modelId="{9268355D-CFCF-43B1-A747-0B870EA3308B}" type="parTrans" cxnId="{8EA08460-D485-4C74-943D-67CC26E54F6A}">
      <dgm:prSet/>
      <dgm:spPr/>
      <dgm:t>
        <a:bodyPr/>
        <a:lstStyle/>
        <a:p>
          <a:endParaRPr lang="en-GB"/>
        </a:p>
      </dgm:t>
    </dgm:pt>
    <dgm:pt modelId="{82135650-E26B-4ECE-9626-930474642EF0}" type="sibTrans" cxnId="{8EA08460-D485-4C74-943D-67CC26E54F6A}">
      <dgm:prSet/>
      <dgm:spPr/>
      <dgm:t>
        <a:bodyPr/>
        <a:lstStyle/>
        <a:p>
          <a:endParaRPr lang="en-GB"/>
        </a:p>
      </dgm:t>
    </dgm:pt>
    <dgm:pt modelId="{3E0C2CF0-ADAE-48EB-989D-92C19067DA89}">
      <dgm:prSet/>
      <dgm:spPr/>
      <dgm:t>
        <a:bodyPr/>
        <a:lstStyle/>
        <a:p>
          <a:pPr>
            <a:buFont typeface="Arial" panose="020B0604020202020204" pitchFamily="34" charset="0"/>
            <a:buNone/>
          </a:pPr>
          <a:r>
            <a:rPr lang="en-GB" dirty="0"/>
            <a:t>Seminal contributions identified</a:t>
          </a:r>
        </a:p>
      </dgm:t>
    </dgm:pt>
    <dgm:pt modelId="{578652F7-9140-4F49-9668-1E9CDE9943FE}" type="parTrans" cxnId="{69993FEA-EA9C-4EE4-B87E-738E8EA0D624}">
      <dgm:prSet/>
      <dgm:spPr/>
      <dgm:t>
        <a:bodyPr/>
        <a:lstStyle/>
        <a:p>
          <a:endParaRPr lang="en-GB"/>
        </a:p>
      </dgm:t>
    </dgm:pt>
    <dgm:pt modelId="{A8ED7824-1302-421A-8725-C9E78EBAD7A9}" type="sibTrans" cxnId="{69993FEA-EA9C-4EE4-B87E-738E8EA0D624}">
      <dgm:prSet/>
      <dgm:spPr/>
      <dgm:t>
        <a:bodyPr/>
        <a:lstStyle/>
        <a:p>
          <a:endParaRPr lang="en-GB"/>
        </a:p>
      </dgm:t>
    </dgm:pt>
    <dgm:pt modelId="{9152CD79-FEA3-4308-AB9D-9E922B7B37D7}">
      <dgm:prSet/>
      <dgm:spPr/>
      <dgm:t>
        <a:bodyPr/>
        <a:lstStyle/>
        <a:p>
          <a:pPr>
            <a:buFont typeface="Arial" panose="020B0604020202020204" pitchFamily="34" charset="0"/>
            <a:buNone/>
          </a:pPr>
          <a:r>
            <a:rPr lang="en-GB" dirty="0"/>
            <a:t>Recent developments reviewed</a:t>
          </a:r>
        </a:p>
      </dgm:t>
    </dgm:pt>
    <dgm:pt modelId="{01A98B21-0BB3-4887-86DD-97B087373EB4}" type="parTrans" cxnId="{76CA9CAB-5FDC-404F-A2F5-5642F512CDB2}">
      <dgm:prSet/>
      <dgm:spPr/>
      <dgm:t>
        <a:bodyPr/>
        <a:lstStyle/>
        <a:p>
          <a:endParaRPr lang="en-GB"/>
        </a:p>
      </dgm:t>
    </dgm:pt>
    <dgm:pt modelId="{634CC958-BBCE-4188-9428-164095F483E1}" type="sibTrans" cxnId="{76CA9CAB-5FDC-404F-A2F5-5642F512CDB2}">
      <dgm:prSet/>
      <dgm:spPr/>
      <dgm:t>
        <a:bodyPr/>
        <a:lstStyle/>
        <a:p>
          <a:endParaRPr lang="en-GB"/>
        </a:p>
      </dgm:t>
    </dgm:pt>
    <dgm:pt modelId="{535122B6-9A0E-496B-B404-5EF3CE95F9C3}">
      <dgm:prSet/>
      <dgm:spPr/>
      <dgm:t>
        <a:bodyPr/>
        <a:lstStyle/>
        <a:p>
          <a:r>
            <a:rPr lang="en-GB" dirty="0"/>
            <a:t>Screening and selection</a:t>
          </a:r>
        </a:p>
      </dgm:t>
    </dgm:pt>
    <dgm:pt modelId="{B89C9D5E-A5CF-420C-8177-DA574E2266CA}" type="parTrans" cxnId="{697FD59A-AAE1-4D45-B4CA-3204605CB7AB}">
      <dgm:prSet/>
      <dgm:spPr/>
      <dgm:t>
        <a:bodyPr/>
        <a:lstStyle/>
        <a:p>
          <a:endParaRPr lang="en-GB"/>
        </a:p>
      </dgm:t>
    </dgm:pt>
    <dgm:pt modelId="{46E9E02C-B82D-4683-BE72-DD31F749B279}" type="sibTrans" cxnId="{697FD59A-AAE1-4D45-B4CA-3204605CB7AB}">
      <dgm:prSet/>
      <dgm:spPr/>
      <dgm:t>
        <a:bodyPr/>
        <a:lstStyle/>
        <a:p>
          <a:endParaRPr lang="en-GB"/>
        </a:p>
      </dgm:t>
    </dgm:pt>
    <dgm:pt modelId="{9AE4E0D8-F09D-4FB7-9A33-578EC530389D}">
      <dgm:prSet/>
      <dgm:spPr/>
      <dgm:t>
        <a:bodyPr/>
        <a:lstStyle/>
        <a:p>
          <a:r>
            <a:rPr lang="en-GB" dirty="0"/>
            <a:t>Relevance to sequence alignment theory</a:t>
          </a:r>
        </a:p>
      </dgm:t>
    </dgm:pt>
    <dgm:pt modelId="{E11A2D0C-6EE7-41CD-9C57-034278C505D4}" type="parTrans" cxnId="{A624DB5A-4CE2-4CD6-A1E3-9E6C5A3E0704}">
      <dgm:prSet/>
      <dgm:spPr/>
      <dgm:t>
        <a:bodyPr/>
        <a:lstStyle/>
        <a:p>
          <a:endParaRPr lang="en-GB"/>
        </a:p>
      </dgm:t>
    </dgm:pt>
    <dgm:pt modelId="{6A4F3DE0-684D-422C-A523-B012BBF83BE2}" type="sibTrans" cxnId="{A624DB5A-4CE2-4CD6-A1E3-9E6C5A3E0704}">
      <dgm:prSet/>
      <dgm:spPr/>
      <dgm:t>
        <a:bodyPr/>
        <a:lstStyle/>
        <a:p>
          <a:endParaRPr lang="en-GB"/>
        </a:p>
      </dgm:t>
    </dgm:pt>
    <dgm:pt modelId="{98EAF298-342B-4E2E-9156-D3DA266D2CE2}">
      <dgm:prSet/>
      <dgm:spPr/>
      <dgm:t>
        <a:bodyPr/>
        <a:lstStyle/>
        <a:p>
          <a:r>
            <a:rPr lang="en-GB" dirty="0"/>
            <a:t>Methodological contribution</a:t>
          </a:r>
        </a:p>
      </dgm:t>
    </dgm:pt>
    <dgm:pt modelId="{80D9F7F3-A595-45D8-A9FC-C9C0EFAFE336}" type="parTrans" cxnId="{C89B2F16-CD72-4976-B8BA-97CF44E82154}">
      <dgm:prSet/>
      <dgm:spPr/>
      <dgm:t>
        <a:bodyPr/>
        <a:lstStyle/>
        <a:p>
          <a:endParaRPr lang="en-GB"/>
        </a:p>
      </dgm:t>
    </dgm:pt>
    <dgm:pt modelId="{003A763D-CC08-49C4-8F14-82DAA53573A2}" type="sibTrans" cxnId="{C89B2F16-CD72-4976-B8BA-97CF44E82154}">
      <dgm:prSet/>
      <dgm:spPr/>
      <dgm:t>
        <a:bodyPr/>
        <a:lstStyle/>
        <a:p>
          <a:endParaRPr lang="en-GB"/>
        </a:p>
      </dgm:t>
    </dgm:pt>
    <dgm:pt modelId="{C383EDF1-9177-4E34-A883-2F2744117E20}">
      <dgm:prSet/>
      <dgm:spPr/>
      <dgm:t>
        <a:bodyPr/>
        <a:lstStyle/>
        <a:p>
          <a:r>
            <a:rPr lang="en-GB" dirty="0"/>
            <a:t>Conceptual significance</a:t>
          </a:r>
        </a:p>
      </dgm:t>
    </dgm:pt>
    <dgm:pt modelId="{563F6F50-76AC-4C52-8A7E-AC7F73BFEBF4}" type="parTrans" cxnId="{CFC9FB91-730F-4829-958E-0B72F03B63E0}">
      <dgm:prSet/>
      <dgm:spPr/>
      <dgm:t>
        <a:bodyPr/>
        <a:lstStyle/>
        <a:p>
          <a:endParaRPr lang="en-GB"/>
        </a:p>
      </dgm:t>
    </dgm:pt>
    <dgm:pt modelId="{72725168-48CC-485F-93F4-ECE5C051DE70}" type="sibTrans" cxnId="{CFC9FB91-730F-4829-958E-0B72F03B63E0}">
      <dgm:prSet/>
      <dgm:spPr/>
      <dgm:t>
        <a:bodyPr/>
        <a:lstStyle/>
        <a:p>
          <a:endParaRPr lang="en-GB"/>
        </a:p>
      </dgm:t>
    </dgm:pt>
    <dgm:pt modelId="{FB306B47-7A1F-43AF-94F9-22F8D864BE96}">
      <dgm:prSet/>
      <dgm:spPr/>
      <dgm:t>
        <a:bodyPr/>
        <a:lstStyle/>
        <a:p>
          <a:r>
            <a:rPr lang="en-GB"/>
            <a:t>Final inclusion</a:t>
          </a:r>
        </a:p>
      </dgm:t>
    </dgm:pt>
    <dgm:pt modelId="{1FCEDA4A-7A09-4663-83A9-351D59F11D6C}" type="parTrans" cxnId="{5DC5F958-44AD-4929-9BB8-B18767174989}">
      <dgm:prSet/>
      <dgm:spPr/>
      <dgm:t>
        <a:bodyPr/>
        <a:lstStyle/>
        <a:p>
          <a:endParaRPr lang="en-GB"/>
        </a:p>
      </dgm:t>
    </dgm:pt>
    <dgm:pt modelId="{22857879-A1F0-41DB-B562-353D0E791BB7}" type="sibTrans" cxnId="{5DC5F958-44AD-4929-9BB8-B18767174989}">
      <dgm:prSet/>
      <dgm:spPr/>
      <dgm:t>
        <a:bodyPr/>
        <a:lstStyle/>
        <a:p>
          <a:endParaRPr lang="en-GB"/>
        </a:p>
      </dgm:t>
    </dgm:pt>
    <dgm:pt modelId="{015DD2B7-6722-4B24-8731-9419D41B502C}">
      <dgm:prSet/>
      <dgm:spPr/>
      <dgm:t>
        <a:bodyPr/>
        <a:lstStyle/>
        <a:p>
          <a:r>
            <a:rPr lang="en-GB" dirty="0"/>
            <a:t>Foundational methods</a:t>
          </a:r>
        </a:p>
      </dgm:t>
    </dgm:pt>
    <dgm:pt modelId="{3D9BEE63-8AD9-458B-A1C0-9362D8FD8227}" type="parTrans" cxnId="{B4566C71-1BA3-439F-A1F9-BEAB2EE960F7}">
      <dgm:prSet/>
      <dgm:spPr/>
      <dgm:t>
        <a:bodyPr/>
        <a:lstStyle/>
        <a:p>
          <a:endParaRPr lang="en-GB"/>
        </a:p>
      </dgm:t>
    </dgm:pt>
    <dgm:pt modelId="{E851744E-C5B3-47C0-80A6-D29D49F05CAB}" type="sibTrans" cxnId="{B4566C71-1BA3-439F-A1F9-BEAB2EE960F7}">
      <dgm:prSet/>
      <dgm:spPr/>
      <dgm:t>
        <a:bodyPr/>
        <a:lstStyle/>
        <a:p>
          <a:endParaRPr lang="en-GB"/>
        </a:p>
      </dgm:t>
    </dgm:pt>
    <dgm:pt modelId="{AF31BFBE-B995-4290-BDBF-EBF98E797AFE}">
      <dgm:prSet/>
      <dgm:spPr/>
      <dgm:t>
        <a:bodyPr/>
        <a:lstStyle/>
        <a:p>
          <a:r>
            <a:rPr lang="en-GB" dirty="0"/>
            <a:t>Algorithmic variants</a:t>
          </a:r>
        </a:p>
      </dgm:t>
    </dgm:pt>
    <dgm:pt modelId="{A01A124C-D8EE-4263-A5B9-A334FB57906D}" type="parTrans" cxnId="{74941878-FC9B-47E3-952C-184F729426E5}">
      <dgm:prSet/>
      <dgm:spPr/>
      <dgm:t>
        <a:bodyPr/>
        <a:lstStyle/>
        <a:p>
          <a:endParaRPr lang="en-GB"/>
        </a:p>
      </dgm:t>
    </dgm:pt>
    <dgm:pt modelId="{14FCEBDC-9E72-4D29-9B0D-BC504B3AAF02}" type="sibTrans" cxnId="{74941878-FC9B-47E3-952C-184F729426E5}">
      <dgm:prSet/>
      <dgm:spPr/>
      <dgm:t>
        <a:bodyPr/>
        <a:lstStyle/>
        <a:p>
          <a:endParaRPr lang="en-GB"/>
        </a:p>
      </dgm:t>
    </dgm:pt>
    <dgm:pt modelId="{FEDE2FBE-79CE-4C16-8861-7089D2FBBC5D}">
      <dgm:prSet/>
      <dgm:spPr/>
      <dgm:t>
        <a:bodyPr/>
        <a:lstStyle/>
        <a:p>
          <a:r>
            <a:rPr lang="en-GB" dirty="0"/>
            <a:t>Modern developments</a:t>
          </a:r>
        </a:p>
      </dgm:t>
    </dgm:pt>
    <dgm:pt modelId="{FA7B2EB4-F402-46BE-AB9D-2BCAF2309205}" type="parTrans" cxnId="{8075C62F-E502-4FA3-AC5E-8CAF4EF2607C}">
      <dgm:prSet/>
      <dgm:spPr/>
      <dgm:t>
        <a:bodyPr/>
        <a:lstStyle/>
        <a:p>
          <a:endParaRPr lang="en-GB"/>
        </a:p>
      </dgm:t>
    </dgm:pt>
    <dgm:pt modelId="{B59AF0FC-3823-4507-9390-7EA20E3D7F6D}" type="sibTrans" cxnId="{8075C62F-E502-4FA3-AC5E-8CAF4EF2607C}">
      <dgm:prSet/>
      <dgm:spPr/>
      <dgm:t>
        <a:bodyPr/>
        <a:lstStyle/>
        <a:p>
          <a:endParaRPr lang="en-GB"/>
        </a:p>
      </dgm:t>
    </dgm:pt>
    <dgm:pt modelId="{F8C87A47-C1D1-4D03-8996-F839C881E63D}" type="pres">
      <dgm:prSet presAssocID="{C9C10906-047C-4A20-B7CC-D7B612F29870}" presName="Name0" presStyleCnt="0">
        <dgm:presLayoutVars>
          <dgm:dir/>
          <dgm:animLvl val="lvl"/>
          <dgm:resizeHandles val="exact"/>
        </dgm:presLayoutVars>
      </dgm:prSet>
      <dgm:spPr/>
    </dgm:pt>
    <dgm:pt modelId="{9FCE3401-30F1-4AC1-B192-47FB61063197}" type="pres">
      <dgm:prSet presAssocID="{550EA637-AD9F-42B5-BBBB-4B73E4C10781}" presName="compositeNode" presStyleCnt="0">
        <dgm:presLayoutVars>
          <dgm:bulletEnabled val="1"/>
        </dgm:presLayoutVars>
      </dgm:prSet>
      <dgm:spPr/>
    </dgm:pt>
    <dgm:pt modelId="{B0D1CAA7-556F-4DDB-AE04-C80C2C7916B1}" type="pres">
      <dgm:prSet presAssocID="{550EA637-AD9F-42B5-BBBB-4B73E4C10781}" presName="bgRect" presStyleLbl="node1" presStyleIdx="0" presStyleCnt="3"/>
      <dgm:spPr/>
    </dgm:pt>
    <dgm:pt modelId="{75E2DF24-B2FB-453F-9F78-01FEE298243F}" type="pres">
      <dgm:prSet presAssocID="{550EA637-AD9F-42B5-BBBB-4B73E4C10781}" presName="parentNode" presStyleLbl="node1" presStyleIdx="0" presStyleCnt="3">
        <dgm:presLayoutVars>
          <dgm:chMax val="0"/>
          <dgm:bulletEnabled val="1"/>
        </dgm:presLayoutVars>
      </dgm:prSet>
      <dgm:spPr/>
    </dgm:pt>
    <dgm:pt modelId="{96FA3981-F598-48A5-B7E2-E2451E636824}" type="pres">
      <dgm:prSet presAssocID="{550EA637-AD9F-42B5-BBBB-4B73E4C10781}" presName="childNode" presStyleLbl="node1" presStyleIdx="0" presStyleCnt="3">
        <dgm:presLayoutVars>
          <dgm:bulletEnabled val="1"/>
        </dgm:presLayoutVars>
      </dgm:prSet>
      <dgm:spPr/>
    </dgm:pt>
    <dgm:pt modelId="{D7CD56E4-EE5C-4A8D-89D5-FD85AEBA5C23}" type="pres">
      <dgm:prSet presAssocID="{70E3E5C5-D16B-4C54-A259-08DF85FBBC44}" presName="hSp" presStyleCnt="0"/>
      <dgm:spPr/>
    </dgm:pt>
    <dgm:pt modelId="{D4C2DCB3-94BC-4B4A-8E74-EEF2C36C34AD}" type="pres">
      <dgm:prSet presAssocID="{70E3E5C5-D16B-4C54-A259-08DF85FBBC44}" presName="vProcSp" presStyleCnt="0"/>
      <dgm:spPr/>
    </dgm:pt>
    <dgm:pt modelId="{B245513E-1BB9-4F8D-8FDF-AA3B35EF28DC}" type="pres">
      <dgm:prSet presAssocID="{70E3E5C5-D16B-4C54-A259-08DF85FBBC44}" presName="vSp1" presStyleCnt="0"/>
      <dgm:spPr/>
    </dgm:pt>
    <dgm:pt modelId="{D2592E04-593A-4DE6-9F3D-B477DCCCA243}" type="pres">
      <dgm:prSet presAssocID="{70E3E5C5-D16B-4C54-A259-08DF85FBBC44}" presName="simulatedConn" presStyleLbl="solidFgAcc1" presStyleIdx="0" presStyleCnt="2"/>
      <dgm:spPr/>
    </dgm:pt>
    <dgm:pt modelId="{4230F787-74B2-49D8-B1CC-C7FDB5336FDD}" type="pres">
      <dgm:prSet presAssocID="{70E3E5C5-D16B-4C54-A259-08DF85FBBC44}" presName="vSp2" presStyleCnt="0"/>
      <dgm:spPr/>
    </dgm:pt>
    <dgm:pt modelId="{6D9013D6-82F4-47F3-9F10-84DBA4664590}" type="pres">
      <dgm:prSet presAssocID="{70E3E5C5-D16B-4C54-A259-08DF85FBBC44}" presName="sibTrans" presStyleCnt="0"/>
      <dgm:spPr/>
    </dgm:pt>
    <dgm:pt modelId="{D44332F1-389A-41FE-BDC5-F3EC80D28C2C}" type="pres">
      <dgm:prSet presAssocID="{535122B6-9A0E-496B-B404-5EF3CE95F9C3}" presName="compositeNode" presStyleCnt="0">
        <dgm:presLayoutVars>
          <dgm:bulletEnabled val="1"/>
        </dgm:presLayoutVars>
      </dgm:prSet>
      <dgm:spPr/>
    </dgm:pt>
    <dgm:pt modelId="{457DB39D-4E29-4581-8AEA-4452EC68EE11}" type="pres">
      <dgm:prSet presAssocID="{535122B6-9A0E-496B-B404-5EF3CE95F9C3}" presName="bgRect" presStyleLbl="node1" presStyleIdx="1" presStyleCnt="3"/>
      <dgm:spPr/>
    </dgm:pt>
    <dgm:pt modelId="{BE6CCDE5-A9B8-4632-B169-BED9F96DED6A}" type="pres">
      <dgm:prSet presAssocID="{535122B6-9A0E-496B-B404-5EF3CE95F9C3}" presName="parentNode" presStyleLbl="node1" presStyleIdx="1" presStyleCnt="3">
        <dgm:presLayoutVars>
          <dgm:chMax val="0"/>
          <dgm:bulletEnabled val="1"/>
        </dgm:presLayoutVars>
      </dgm:prSet>
      <dgm:spPr/>
    </dgm:pt>
    <dgm:pt modelId="{F4548099-1E05-4837-8692-E14E257E1FEB}" type="pres">
      <dgm:prSet presAssocID="{535122B6-9A0E-496B-B404-5EF3CE95F9C3}" presName="childNode" presStyleLbl="node1" presStyleIdx="1" presStyleCnt="3">
        <dgm:presLayoutVars>
          <dgm:bulletEnabled val="1"/>
        </dgm:presLayoutVars>
      </dgm:prSet>
      <dgm:spPr/>
    </dgm:pt>
    <dgm:pt modelId="{5AAB64E9-B8E2-4412-B9E1-9CA6C1E4F43D}" type="pres">
      <dgm:prSet presAssocID="{46E9E02C-B82D-4683-BE72-DD31F749B279}" presName="hSp" presStyleCnt="0"/>
      <dgm:spPr/>
    </dgm:pt>
    <dgm:pt modelId="{86F2EC8C-30F5-4F6B-96D6-C10936B41351}" type="pres">
      <dgm:prSet presAssocID="{46E9E02C-B82D-4683-BE72-DD31F749B279}" presName="vProcSp" presStyleCnt="0"/>
      <dgm:spPr/>
    </dgm:pt>
    <dgm:pt modelId="{CB2AA559-FCA5-4DFD-A9EE-31AEFC96BA1B}" type="pres">
      <dgm:prSet presAssocID="{46E9E02C-B82D-4683-BE72-DD31F749B279}" presName="vSp1" presStyleCnt="0"/>
      <dgm:spPr/>
    </dgm:pt>
    <dgm:pt modelId="{653EE05C-CF20-4FB1-AC5E-BBC302C8CA75}" type="pres">
      <dgm:prSet presAssocID="{46E9E02C-B82D-4683-BE72-DD31F749B279}" presName="simulatedConn" presStyleLbl="solidFgAcc1" presStyleIdx="1" presStyleCnt="2"/>
      <dgm:spPr/>
    </dgm:pt>
    <dgm:pt modelId="{E958260E-C9E8-411E-896B-3248EE3E090A}" type="pres">
      <dgm:prSet presAssocID="{46E9E02C-B82D-4683-BE72-DD31F749B279}" presName="vSp2" presStyleCnt="0"/>
      <dgm:spPr/>
    </dgm:pt>
    <dgm:pt modelId="{F7ABC83F-DC16-4D6B-887D-7CD467033A9F}" type="pres">
      <dgm:prSet presAssocID="{46E9E02C-B82D-4683-BE72-DD31F749B279}" presName="sibTrans" presStyleCnt="0"/>
      <dgm:spPr/>
    </dgm:pt>
    <dgm:pt modelId="{0530C2F5-6F0A-4266-8CAA-98F612CB6240}" type="pres">
      <dgm:prSet presAssocID="{FB306B47-7A1F-43AF-94F9-22F8D864BE96}" presName="compositeNode" presStyleCnt="0">
        <dgm:presLayoutVars>
          <dgm:bulletEnabled val="1"/>
        </dgm:presLayoutVars>
      </dgm:prSet>
      <dgm:spPr/>
    </dgm:pt>
    <dgm:pt modelId="{DFCE6DCE-8BF0-49BA-8C5D-53CD4CF94A6B}" type="pres">
      <dgm:prSet presAssocID="{FB306B47-7A1F-43AF-94F9-22F8D864BE96}" presName="bgRect" presStyleLbl="node1" presStyleIdx="2" presStyleCnt="3"/>
      <dgm:spPr/>
    </dgm:pt>
    <dgm:pt modelId="{EE03B22E-2D53-49FD-9D5E-0677EE65B55C}" type="pres">
      <dgm:prSet presAssocID="{FB306B47-7A1F-43AF-94F9-22F8D864BE96}" presName="parentNode" presStyleLbl="node1" presStyleIdx="2" presStyleCnt="3">
        <dgm:presLayoutVars>
          <dgm:chMax val="0"/>
          <dgm:bulletEnabled val="1"/>
        </dgm:presLayoutVars>
      </dgm:prSet>
      <dgm:spPr/>
    </dgm:pt>
    <dgm:pt modelId="{CF32E4CD-F3DC-4C23-85C0-558CC4CEE2AD}" type="pres">
      <dgm:prSet presAssocID="{FB306B47-7A1F-43AF-94F9-22F8D864BE96}" presName="childNode" presStyleLbl="node1" presStyleIdx="2" presStyleCnt="3">
        <dgm:presLayoutVars>
          <dgm:bulletEnabled val="1"/>
        </dgm:presLayoutVars>
      </dgm:prSet>
      <dgm:spPr/>
    </dgm:pt>
  </dgm:ptLst>
  <dgm:cxnLst>
    <dgm:cxn modelId="{95291B15-8F29-4F7D-BDB5-E90CF661907E}" type="presOf" srcId="{AF31BFBE-B995-4290-BDBF-EBF98E797AFE}" destId="{CF32E4CD-F3DC-4C23-85C0-558CC4CEE2AD}" srcOrd="0" destOrd="1" presId="urn:microsoft.com/office/officeart/2005/8/layout/hProcess7"/>
    <dgm:cxn modelId="{C89B2F16-CD72-4976-B8BA-97CF44E82154}" srcId="{535122B6-9A0E-496B-B404-5EF3CE95F9C3}" destId="{98EAF298-342B-4E2E-9156-D3DA266D2CE2}" srcOrd="1" destOrd="0" parTransId="{80D9F7F3-A595-45D8-A9FC-C9C0EFAFE336}" sibTransId="{003A763D-CC08-49C4-8F14-82DAA53573A2}"/>
    <dgm:cxn modelId="{E68DC428-5552-476D-946B-06A0F7191F97}" type="presOf" srcId="{535122B6-9A0E-496B-B404-5EF3CE95F9C3}" destId="{457DB39D-4E29-4581-8AEA-4452EC68EE11}" srcOrd="0" destOrd="0" presId="urn:microsoft.com/office/officeart/2005/8/layout/hProcess7"/>
    <dgm:cxn modelId="{7A21B82D-0593-4E1F-A290-6C9304BF05B6}" type="presOf" srcId="{9152CD79-FEA3-4308-AB9D-9E922B7B37D7}" destId="{96FA3981-F598-48A5-B7E2-E2451E636824}" srcOrd="0" destOrd="2" presId="urn:microsoft.com/office/officeart/2005/8/layout/hProcess7"/>
    <dgm:cxn modelId="{8075C62F-E502-4FA3-AC5E-8CAF4EF2607C}" srcId="{FB306B47-7A1F-43AF-94F9-22F8D864BE96}" destId="{FEDE2FBE-79CE-4C16-8861-7089D2FBBC5D}" srcOrd="2" destOrd="0" parTransId="{FA7B2EB4-F402-46BE-AB9D-2BCAF2309205}" sibTransId="{B59AF0FC-3823-4507-9390-7EA20E3D7F6D}"/>
    <dgm:cxn modelId="{8EA08460-D485-4C74-943D-67CC26E54F6A}" srcId="{550EA637-AD9F-42B5-BBBB-4B73E4C10781}" destId="{1B417A69-3206-4CF4-816E-8EA683D4618E}" srcOrd="0" destOrd="0" parTransId="{9268355D-CFCF-43B1-A747-0B870EA3308B}" sibTransId="{82135650-E26B-4ECE-9626-930474642EF0}"/>
    <dgm:cxn modelId="{3DD27049-A4B5-4B88-8F32-F70E876FC6C7}" type="presOf" srcId="{1B417A69-3206-4CF4-816E-8EA683D4618E}" destId="{96FA3981-F598-48A5-B7E2-E2451E636824}" srcOrd="0" destOrd="0" presId="urn:microsoft.com/office/officeart/2005/8/layout/hProcess7"/>
    <dgm:cxn modelId="{C3523470-FBD9-41BC-890A-1927E82502B3}" type="presOf" srcId="{535122B6-9A0E-496B-B404-5EF3CE95F9C3}" destId="{BE6CCDE5-A9B8-4632-B169-BED9F96DED6A}" srcOrd="1" destOrd="0" presId="urn:microsoft.com/office/officeart/2005/8/layout/hProcess7"/>
    <dgm:cxn modelId="{D8F4ED50-C19D-4986-AF26-21947B4371DC}" type="presOf" srcId="{3E0C2CF0-ADAE-48EB-989D-92C19067DA89}" destId="{96FA3981-F598-48A5-B7E2-E2451E636824}" srcOrd="0" destOrd="1" presId="urn:microsoft.com/office/officeart/2005/8/layout/hProcess7"/>
    <dgm:cxn modelId="{B4566C71-1BA3-439F-A1F9-BEAB2EE960F7}" srcId="{FB306B47-7A1F-43AF-94F9-22F8D864BE96}" destId="{015DD2B7-6722-4B24-8731-9419D41B502C}" srcOrd="0" destOrd="0" parTransId="{3D9BEE63-8AD9-458B-A1C0-9362D8FD8227}" sibTransId="{E851744E-C5B3-47C0-80A6-D29D49F05CAB}"/>
    <dgm:cxn modelId="{74941878-FC9B-47E3-952C-184F729426E5}" srcId="{FB306B47-7A1F-43AF-94F9-22F8D864BE96}" destId="{AF31BFBE-B995-4290-BDBF-EBF98E797AFE}" srcOrd="1" destOrd="0" parTransId="{A01A124C-D8EE-4263-A5B9-A334FB57906D}" sibTransId="{14FCEBDC-9E72-4D29-9B0D-BC504B3AAF02}"/>
    <dgm:cxn modelId="{5DC5F958-44AD-4929-9BB8-B18767174989}" srcId="{C9C10906-047C-4A20-B7CC-D7B612F29870}" destId="{FB306B47-7A1F-43AF-94F9-22F8D864BE96}" srcOrd="2" destOrd="0" parTransId="{1FCEDA4A-7A09-4663-83A9-351D59F11D6C}" sibTransId="{22857879-A1F0-41DB-B562-353D0E791BB7}"/>
    <dgm:cxn modelId="{A624DB5A-4CE2-4CD6-A1E3-9E6C5A3E0704}" srcId="{535122B6-9A0E-496B-B404-5EF3CE95F9C3}" destId="{9AE4E0D8-F09D-4FB7-9A33-578EC530389D}" srcOrd="0" destOrd="0" parTransId="{E11A2D0C-6EE7-41CD-9C57-034278C505D4}" sibTransId="{6A4F3DE0-684D-422C-A523-B012BBF83BE2}"/>
    <dgm:cxn modelId="{86F5507B-A322-4F97-A969-526102F8249F}" type="presOf" srcId="{550EA637-AD9F-42B5-BBBB-4B73E4C10781}" destId="{B0D1CAA7-556F-4DDB-AE04-C80C2C7916B1}" srcOrd="0" destOrd="0" presId="urn:microsoft.com/office/officeart/2005/8/layout/hProcess7"/>
    <dgm:cxn modelId="{F42AC485-545A-4197-B666-B348981E5F11}" type="presOf" srcId="{9AE4E0D8-F09D-4FB7-9A33-578EC530389D}" destId="{F4548099-1E05-4837-8692-E14E257E1FEB}" srcOrd="0" destOrd="0" presId="urn:microsoft.com/office/officeart/2005/8/layout/hProcess7"/>
    <dgm:cxn modelId="{CFC9FB91-730F-4829-958E-0B72F03B63E0}" srcId="{535122B6-9A0E-496B-B404-5EF3CE95F9C3}" destId="{C383EDF1-9177-4E34-A883-2F2744117E20}" srcOrd="2" destOrd="0" parTransId="{563F6F50-76AC-4C52-8A7E-AC7F73BFEBF4}" sibTransId="{72725168-48CC-485F-93F4-ECE5C051DE70}"/>
    <dgm:cxn modelId="{697FD59A-AAE1-4D45-B4CA-3204605CB7AB}" srcId="{C9C10906-047C-4A20-B7CC-D7B612F29870}" destId="{535122B6-9A0E-496B-B404-5EF3CE95F9C3}" srcOrd="1" destOrd="0" parTransId="{B89C9D5E-A5CF-420C-8177-DA574E2266CA}" sibTransId="{46E9E02C-B82D-4683-BE72-DD31F749B279}"/>
    <dgm:cxn modelId="{3ED44F9C-6725-4A5A-A167-903C63F486B2}" type="presOf" srcId="{FB306B47-7A1F-43AF-94F9-22F8D864BE96}" destId="{EE03B22E-2D53-49FD-9D5E-0677EE65B55C}" srcOrd="1" destOrd="0" presId="urn:microsoft.com/office/officeart/2005/8/layout/hProcess7"/>
    <dgm:cxn modelId="{76CA9CAB-5FDC-404F-A2F5-5642F512CDB2}" srcId="{550EA637-AD9F-42B5-BBBB-4B73E4C10781}" destId="{9152CD79-FEA3-4308-AB9D-9E922B7B37D7}" srcOrd="2" destOrd="0" parTransId="{01A98B21-0BB3-4887-86DD-97B087373EB4}" sibTransId="{634CC958-BBCE-4188-9428-164095F483E1}"/>
    <dgm:cxn modelId="{701610B0-4EA7-4F27-B26E-D3EDC90E2706}" type="presOf" srcId="{98EAF298-342B-4E2E-9156-D3DA266D2CE2}" destId="{F4548099-1E05-4837-8692-E14E257E1FEB}" srcOrd="0" destOrd="1" presId="urn:microsoft.com/office/officeart/2005/8/layout/hProcess7"/>
    <dgm:cxn modelId="{972882BC-0F5F-4FF3-A14B-2CD1192ACAE1}" type="presOf" srcId="{FEDE2FBE-79CE-4C16-8861-7089D2FBBC5D}" destId="{CF32E4CD-F3DC-4C23-85C0-558CC4CEE2AD}" srcOrd="0" destOrd="2" presId="urn:microsoft.com/office/officeart/2005/8/layout/hProcess7"/>
    <dgm:cxn modelId="{51714DC9-4950-4A95-9ACF-2A564AD5FC73}" type="presOf" srcId="{C383EDF1-9177-4E34-A883-2F2744117E20}" destId="{F4548099-1E05-4837-8692-E14E257E1FEB}" srcOrd="0" destOrd="2" presId="urn:microsoft.com/office/officeart/2005/8/layout/hProcess7"/>
    <dgm:cxn modelId="{D43762D4-94DC-40A7-9682-88A07CBA2946}" type="presOf" srcId="{C9C10906-047C-4A20-B7CC-D7B612F29870}" destId="{F8C87A47-C1D1-4D03-8996-F839C881E63D}" srcOrd="0" destOrd="0" presId="urn:microsoft.com/office/officeart/2005/8/layout/hProcess7"/>
    <dgm:cxn modelId="{187577E2-51EC-4D6A-B6AB-EEEBE0CFC99D}" type="presOf" srcId="{550EA637-AD9F-42B5-BBBB-4B73E4C10781}" destId="{75E2DF24-B2FB-453F-9F78-01FEE298243F}" srcOrd="1" destOrd="0" presId="urn:microsoft.com/office/officeart/2005/8/layout/hProcess7"/>
    <dgm:cxn modelId="{77A9B9E4-B564-4A60-AFBF-28D5D4E7C851}" type="presOf" srcId="{FB306B47-7A1F-43AF-94F9-22F8D864BE96}" destId="{DFCE6DCE-8BF0-49BA-8C5D-53CD4CF94A6B}" srcOrd="0" destOrd="0" presId="urn:microsoft.com/office/officeart/2005/8/layout/hProcess7"/>
    <dgm:cxn modelId="{B556DBE6-3E7D-47CE-BE45-4E110CA48917}" type="presOf" srcId="{015DD2B7-6722-4B24-8731-9419D41B502C}" destId="{CF32E4CD-F3DC-4C23-85C0-558CC4CEE2AD}" srcOrd="0" destOrd="0" presId="urn:microsoft.com/office/officeart/2005/8/layout/hProcess7"/>
    <dgm:cxn modelId="{69993FEA-EA9C-4EE4-B87E-738E8EA0D624}" srcId="{550EA637-AD9F-42B5-BBBB-4B73E4C10781}" destId="{3E0C2CF0-ADAE-48EB-989D-92C19067DA89}" srcOrd="1" destOrd="0" parTransId="{578652F7-9140-4F49-9668-1E9CDE9943FE}" sibTransId="{A8ED7824-1302-421A-8725-C9E78EBAD7A9}"/>
    <dgm:cxn modelId="{278C68F6-FDEA-4A88-BEFC-205F19C6AEBC}" srcId="{C9C10906-047C-4A20-B7CC-D7B612F29870}" destId="{550EA637-AD9F-42B5-BBBB-4B73E4C10781}" srcOrd="0" destOrd="0" parTransId="{3D80FDCF-71FE-4E66-8EE9-E701EA585B31}" sibTransId="{70E3E5C5-D16B-4C54-A259-08DF85FBBC44}"/>
    <dgm:cxn modelId="{6FA75135-D847-42B7-B963-094FCD98E839}" type="presParOf" srcId="{F8C87A47-C1D1-4D03-8996-F839C881E63D}" destId="{9FCE3401-30F1-4AC1-B192-47FB61063197}" srcOrd="0" destOrd="0" presId="urn:microsoft.com/office/officeart/2005/8/layout/hProcess7"/>
    <dgm:cxn modelId="{B8C7CDA5-D804-4B84-92ED-5FC273021AC2}" type="presParOf" srcId="{9FCE3401-30F1-4AC1-B192-47FB61063197}" destId="{B0D1CAA7-556F-4DDB-AE04-C80C2C7916B1}" srcOrd="0" destOrd="0" presId="urn:microsoft.com/office/officeart/2005/8/layout/hProcess7"/>
    <dgm:cxn modelId="{E0DCBAF9-8EC0-4B75-AB52-724B43153DA9}" type="presParOf" srcId="{9FCE3401-30F1-4AC1-B192-47FB61063197}" destId="{75E2DF24-B2FB-453F-9F78-01FEE298243F}" srcOrd="1" destOrd="0" presId="urn:microsoft.com/office/officeart/2005/8/layout/hProcess7"/>
    <dgm:cxn modelId="{50CE8FA8-5211-45C6-A457-066BF9FD9576}" type="presParOf" srcId="{9FCE3401-30F1-4AC1-B192-47FB61063197}" destId="{96FA3981-F598-48A5-B7E2-E2451E636824}" srcOrd="2" destOrd="0" presId="urn:microsoft.com/office/officeart/2005/8/layout/hProcess7"/>
    <dgm:cxn modelId="{8C733813-26BA-42E4-B75D-D9FF0F488DE6}" type="presParOf" srcId="{F8C87A47-C1D1-4D03-8996-F839C881E63D}" destId="{D7CD56E4-EE5C-4A8D-89D5-FD85AEBA5C23}" srcOrd="1" destOrd="0" presId="urn:microsoft.com/office/officeart/2005/8/layout/hProcess7"/>
    <dgm:cxn modelId="{035E21B4-3CCA-46D8-AF3A-E604C4688CD6}" type="presParOf" srcId="{F8C87A47-C1D1-4D03-8996-F839C881E63D}" destId="{D4C2DCB3-94BC-4B4A-8E74-EEF2C36C34AD}" srcOrd="2" destOrd="0" presId="urn:microsoft.com/office/officeart/2005/8/layout/hProcess7"/>
    <dgm:cxn modelId="{88C4D875-620E-4A79-B623-33CA6831FC7F}" type="presParOf" srcId="{D4C2DCB3-94BC-4B4A-8E74-EEF2C36C34AD}" destId="{B245513E-1BB9-4F8D-8FDF-AA3B35EF28DC}" srcOrd="0" destOrd="0" presId="urn:microsoft.com/office/officeart/2005/8/layout/hProcess7"/>
    <dgm:cxn modelId="{1CC6E051-84E5-445B-9F09-892D46E2C40A}" type="presParOf" srcId="{D4C2DCB3-94BC-4B4A-8E74-EEF2C36C34AD}" destId="{D2592E04-593A-4DE6-9F3D-B477DCCCA243}" srcOrd="1" destOrd="0" presId="urn:microsoft.com/office/officeart/2005/8/layout/hProcess7"/>
    <dgm:cxn modelId="{B2F0CDE9-4A90-4446-9A16-AAC0F8E13685}" type="presParOf" srcId="{D4C2DCB3-94BC-4B4A-8E74-EEF2C36C34AD}" destId="{4230F787-74B2-49D8-B1CC-C7FDB5336FDD}" srcOrd="2" destOrd="0" presId="urn:microsoft.com/office/officeart/2005/8/layout/hProcess7"/>
    <dgm:cxn modelId="{DCD63596-A79F-4D16-B5F0-CEE29918CAB0}" type="presParOf" srcId="{F8C87A47-C1D1-4D03-8996-F839C881E63D}" destId="{6D9013D6-82F4-47F3-9F10-84DBA4664590}" srcOrd="3" destOrd="0" presId="urn:microsoft.com/office/officeart/2005/8/layout/hProcess7"/>
    <dgm:cxn modelId="{24EF848F-A6CD-49AC-AE77-93E48692C697}" type="presParOf" srcId="{F8C87A47-C1D1-4D03-8996-F839C881E63D}" destId="{D44332F1-389A-41FE-BDC5-F3EC80D28C2C}" srcOrd="4" destOrd="0" presId="urn:microsoft.com/office/officeart/2005/8/layout/hProcess7"/>
    <dgm:cxn modelId="{4DC7E345-02D2-464D-8D15-DECD6659F367}" type="presParOf" srcId="{D44332F1-389A-41FE-BDC5-F3EC80D28C2C}" destId="{457DB39D-4E29-4581-8AEA-4452EC68EE11}" srcOrd="0" destOrd="0" presId="urn:microsoft.com/office/officeart/2005/8/layout/hProcess7"/>
    <dgm:cxn modelId="{C8E8B8B6-5EF7-46B6-ABDB-1144185B1F6A}" type="presParOf" srcId="{D44332F1-389A-41FE-BDC5-F3EC80D28C2C}" destId="{BE6CCDE5-A9B8-4632-B169-BED9F96DED6A}" srcOrd="1" destOrd="0" presId="urn:microsoft.com/office/officeart/2005/8/layout/hProcess7"/>
    <dgm:cxn modelId="{6CA1FD06-7F88-4160-84EF-9EC427E54C51}" type="presParOf" srcId="{D44332F1-389A-41FE-BDC5-F3EC80D28C2C}" destId="{F4548099-1E05-4837-8692-E14E257E1FEB}" srcOrd="2" destOrd="0" presId="urn:microsoft.com/office/officeart/2005/8/layout/hProcess7"/>
    <dgm:cxn modelId="{2A2AC1A9-D1FA-49FB-8FD2-CB4A1DD84BFD}" type="presParOf" srcId="{F8C87A47-C1D1-4D03-8996-F839C881E63D}" destId="{5AAB64E9-B8E2-4412-B9E1-9CA6C1E4F43D}" srcOrd="5" destOrd="0" presId="urn:microsoft.com/office/officeart/2005/8/layout/hProcess7"/>
    <dgm:cxn modelId="{CE9F0D18-FC5D-42D0-AD7E-3FEB867670F2}" type="presParOf" srcId="{F8C87A47-C1D1-4D03-8996-F839C881E63D}" destId="{86F2EC8C-30F5-4F6B-96D6-C10936B41351}" srcOrd="6" destOrd="0" presId="urn:microsoft.com/office/officeart/2005/8/layout/hProcess7"/>
    <dgm:cxn modelId="{81F723D1-46BC-4473-8D9C-B0CAB3DD0895}" type="presParOf" srcId="{86F2EC8C-30F5-4F6B-96D6-C10936B41351}" destId="{CB2AA559-FCA5-4DFD-A9EE-31AEFC96BA1B}" srcOrd="0" destOrd="0" presId="urn:microsoft.com/office/officeart/2005/8/layout/hProcess7"/>
    <dgm:cxn modelId="{3C1D4B92-62F7-485F-8FC5-AE5E6A3D3073}" type="presParOf" srcId="{86F2EC8C-30F5-4F6B-96D6-C10936B41351}" destId="{653EE05C-CF20-4FB1-AC5E-BBC302C8CA75}" srcOrd="1" destOrd="0" presId="urn:microsoft.com/office/officeart/2005/8/layout/hProcess7"/>
    <dgm:cxn modelId="{DB052F18-9D7C-4AE1-9D6B-2ED03E3B37DD}" type="presParOf" srcId="{86F2EC8C-30F5-4F6B-96D6-C10936B41351}" destId="{E958260E-C9E8-411E-896B-3248EE3E090A}" srcOrd="2" destOrd="0" presId="urn:microsoft.com/office/officeart/2005/8/layout/hProcess7"/>
    <dgm:cxn modelId="{B0A551E9-4B03-4A5C-B158-25831FE9A374}" type="presParOf" srcId="{F8C87A47-C1D1-4D03-8996-F839C881E63D}" destId="{F7ABC83F-DC16-4D6B-887D-7CD467033A9F}" srcOrd="7" destOrd="0" presId="urn:microsoft.com/office/officeart/2005/8/layout/hProcess7"/>
    <dgm:cxn modelId="{A83559F4-EE87-47FB-BE16-4B2C8EF44429}" type="presParOf" srcId="{F8C87A47-C1D1-4D03-8996-F839C881E63D}" destId="{0530C2F5-6F0A-4266-8CAA-98F612CB6240}" srcOrd="8" destOrd="0" presId="urn:microsoft.com/office/officeart/2005/8/layout/hProcess7"/>
    <dgm:cxn modelId="{EE1CDCA2-35B1-4B9F-B128-40193E221E67}" type="presParOf" srcId="{0530C2F5-6F0A-4266-8CAA-98F612CB6240}" destId="{DFCE6DCE-8BF0-49BA-8C5D-53CD4CF94A6B}" srcOrd="0" destOrd="0" presId="urn:microsoft.com/office/officeart/2005/8/layout/hProcess7"/>
    <dgm:cxn modelId="{913D856B-06BE-4DB4-96F7-5391A82E5482}" type="presParOf" srcId="{0530C2F5-6F0A-4266-8CAA-98F612CB6240}" destId="{EE03B22E-2D53-49FD-9D5E-0677EE65B55C}" srcOrd="1" destOrd="0" presId="urn:microsoft.com/office/officeart/2005/8/layout/hProcess7"/>
    <dgm:cxn modelId="{939A21F8-DEC1-4B7A-AA11-3E3DF974DAA5}" type="presParOf" srcId="{0530C2F5-6F0A-4266-8CAA-98F612CB6240}" destId="{CF32E4CD-F3DC-4C23-85C0-558CC4CEE2AD}" srcOrd="2" destOrd="0" presId="urn:microsoft.com/office/officeart/2005/8/layout/hProcess7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7B5BE30-3258-4984-A633-DDD65C454043}">
      <dsp:nvSpPr>
        <dsp:cNvPr id="0" name=""/>
        <dsp:cNvSpPr/>
      </dsp:nvSpPr>
      <dsp:spPr>
        <a:xfrm>
          <a:off x="0" y="311913"/>
          <a:ext cx="8128000" cy="14364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30823" tIns="395732" rIns="630823" bIns="135128" numCol="1" spcCol="1270" anchor="t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900" kern="1200" dirty="0"/>
            <a:t> Representative algorithmic works selected</a:t>
          </a: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900" kern="1200" dirty="0"/>
            <a:t> Seminal contributions identified</a:t>
          </a: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900" kern="1200" dirty="0"/>
            <a:t> Recent </a:t>
          </a:r>
          <a:r>
            <a:rPr lang="en-GB" sz="1900" kern="1200"/>
            <a:t>developments reviewed</a:t>
          </a:r>
          <a:endParaRPr lang="en-GB" sz="1900" kern="1200" dirty="0"/>
        </a:p>
      </dsp:txBody>
      <dsp:txXfrm>
        <a:off x="0" y="311913"/>
        <a:ext cx="8128000" cy="1436400"/>
      </dsp:txXfrm>
    </dsp:sp>
    <dsp:sp modelId="{57D3B2FE-6093-437B-BCBE-2F1E15C57830}">
      <dsp:nvSpPr>
        <dsp:cNvPr id="0" name=""/>
        <dsp:cNvSpPr/>
      </dsp:nvSpPr>
      <dsp:spPr>
        <a:xfrm>
          <a:off x="406400" y="31473"/>
          <a:ext cx="5689600" cy="560880"/>
        </a:xfrm>
        <a:prstGeom prst="roundRect">
          <a:avLst/>
        </a:prstGeom>
        <a:solidFill>
          <a:schemeClr val="accent1">
            <a:shade val="8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053" tIns="0" rIns="215053" bIns="0" numCol="1" spcCol="1270" anchor="ctr" anchorCtr="0">
          <a:noAutofit/>
        </a:bodyPr>
        <a:lstStyle/>
        <a:p>
          <a:pPr marL="0" lvl="0" indent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900" kern="1200" dirty="0"/>
            <a:t>Literature identification</a:t>
          </a:r>
        </a:p>
      </dsp:txBody>
      <dsp:txXfrm>
        <a:off x="433780" y="58853"/>
        <a:ext cx="5634840" cy="506120"/>
      </dsp:txXfrm>
    </dsp:sp>
    <dsp:sp modelId="{B629B07D-20A2-4366-BF7D-C395CCFFA79F}">
      <dsp:nvSpPr>
        <dsp:cNvPr id="0" name=""/>
        <dsp:cNvSpPr/>
      </dsp:nvSpPr>
      <dsp:spPr>
        <a:xfrm>
          <a:off x="0" y="2131353"/>
          <a:ext cx="8128000" cy="14364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272799"/>
              <a:satOff val="-28446"/>
              <a:lumOff val="1911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30823" tIns="395732" rIns="630823" bIns="135128" numCol="1" spcCol="1270" anchor="t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900" kern="1200" dirty="0"/>
            <a:t> Relevance to sequence alignment theory</a:t>
          </a: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900" kern="1200" dirty="0"/>
            <a:t> Methodological contribution</a:t>
          </a: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900" kern="1200" dirty="0"/>
            <a:t> </a:t>
          </a:r>
          <a:r>
            <a:rPr lang="en-GB" sz="1900" kern="1200"/>
            <a:t>Conceptual significance</a:t>
          </a:r>
          <a:endParaRPr lang="en-GB" sz="1900" kern="1200" dirty="0"/>
        </a:p>
      </dsp:txBody>
      <dsp:txXfrm>
        <a:off x="0" y="2131353"/>
        <a:ext cx="8128000" cy="1436400"/>
      </dsp:txXfrm>
    </dsp:sp>
    <dsp:sp modelId="{EE0548F1-6D76-49D9-AF07-EDFF25234531}">
      <dsp:nvSpPr>
        <dsp:cNvPr id="0" name=""/>
        <dsp:cNvSpPr/>
      </dsp:nvSpPr>
      <dsp:spPr>
        <a:xfrm>
          <a:off x="406400" y="1850913"/>
          <a:ext cx="5689600" cy="560880"/>
        </a:xfrm>
        <a:prstGeom prst="roundRect">
          <a:avLst/>
        </a:prstGeom>
        <a:solidFill>
          <a:schemeClr val="accent1">
            <a:shade val="80000"/>
            <a:hueOff val="272799"/>
            <a:satOff val="-28446"/>
            <a:lumOff val="1911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053" tIns="0" rIns="215053" bIns="0" numCol="1" spcCol="1270" anchor="ctr" anchorCtr="0">
          <a:noAutofit/>
        </a:bodyPr>
        <a:lstStyle/>
        <a:p>
          <a:pPr marL="0" lvl="0" indent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900" kern="1200" dirty="0"/>
            <a:t>Screening and selection</a:t>
          </a:r>
        </a:p>
      </dsp:txBody>
      <dsp:txXfrm>
        <a:off x="433780" y="1878293"/>
        <a:ext cx="5634840" cy="506120"/>
      </dsp:txXfrm>
    </dsp:sp>
    <dsp:sp modelId="{DCDE45F5-CFAD-4EEC-B403-A72D68D4E370}">
      <dsp:nvSpPr>
        <dsp:cNvPr id="0" name=""/>
        <dsp:cNvSpPr/>
      </dsp:nvSpPr>
      <dsp:spPr>
        <a:xfrm>
          <a:off x="0" y="3950793"/>
          <a:ext cx="8128000" cy="14364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545598"/>
              <a:satOff val="-56892"/>
              <a:lumOff val="38221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30823" tIns="395732" rIns="630823" bIns="135128" numCol="1" spcCol="1270" anchor="t" anchorCtr="0">
          <a:noAutofit/>
        </a:bodyPr>
        <a:lstStyle/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900" kern="1200" dirty="0"/>
            <a:t> Foundational methods</a:t>
          </a: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900" kern="1200" dirty="0"/>
            <a:t> Algorithmic variants</a:t>
          </a:r>
        </a:p>
        <a:p>
          <a:pPr marL="171450" lvl="1" indent="-171450" algn="l" defTabSz="8445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GB" sz="1900" kern="1200" dirty="0"/>
            <a:t> </a:t>
          </a:r>
          <a:r>
            <a:rPr lang="en-GB" sz="1900" kern="1200"/>
            <a:t>Modern developments</a:t>
          </a:r>
          <a:endParaRPr lang="en-GB" sz="1900" kern="1200" dirty="0"/>
        </a:p>
      </dsp:txBody>
      <dsp:txXfrm>
        <a:off x="0" y="3950793"/>
        <a:ext cx="8128000" cy="1436400"/>
      </dsp:txXfrm>
    </dsp:sp>
    <dsp:sp modelId="{0E798636-9C2F-4BF8-B0DC-71090E07477A}">
      <dsp:nvSpPr>
        <dsp:cNvPr id="0" name=""/>
        <dsp:cNvSpPr/>
      </dsp:nvSpPr>
      <dsp:spPr>
        <a:xfrm>
          <a:off x="406400" y="3670353"/>
          <a:ext cx="5689600" cy="560880"/>
        </a:xfrm>
        <a:prstGeom prst="roundRect">
          <a:avLst/>
        </a:prstGeom>
        <a:solidFill>
          <a:schemeClr val="accent1">
            <a:shade val="80000"/>
            <a:hueOff val="545598"/>
            <a:satOff val="-56892"/>
            <a:lumOff val="38221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053" tIns="0" rIns="215053" bIns="0" numCol="1" spcCol="1270" anchor="ctr" anchorCtr="0">
          <a:noAutofit/>
        </a:bodyPr>
        <a:lstStyle/>
        <a:p>
          <a:pPr marL="0" lvl="0" indent="0" algn="l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900" kern="1200"/>
            <a:t>Final inclusion</a:t>
          </a:r>
        </a:p>
      </dsp:txBody>
      <dsp:txXfrm>
        <a:off x="433780" y="3697733"/>
        <a:ext cx="5634840" cy="506120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3AA0D21-6FBC-4D3D-8DCE-7E296585697A}">
      <dsp:nvSpPr>
        <dsp:cNvPr id="0" name=""/>
        <dsp:cNvSpPr/>
      </dsp:nvSpPr>
      <dsp:spPr>
        <a:xfrm>
          <a:off x="77390" y="4134"/>
          <a:ext cx="2278062" cy="1139031"/>
        </a:xfrm>
        <a:prstGeom prst="roundRect">
          <a:avLst>
            <a:gd name="adj" fmla="val 10000"/>
          </a:avLst>
        </a:prstGeom>
        <a:solidFill>
          <a:schemeClr val="accent1">
            <a:shade val="8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3340" tIns="35560" rIns="53340" bIns="35560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800" kern="1200" dirty="0"/>
            <a:t>Literature identification</a:t>
          </a:r>
        </a:p>
      </dsp:txBody>
      <dsp:txXfrm>
        <a:off x="110751" y="37495"/>
        <a:ext cx="2211340" cy="1072309"/>
      </dsp:txXfrm>
    </dsp:sp>
    <dsp:sp modelId="{08E57DB2-BBF2-43B9-A345-DC0E9647B119}">
      <dsp:nvSpPr>
        <dsp:cNvPr id="0" name=""/>
        <dsp:cNvSpPr/>
      </dsp:nvSpPr>
      <dsp:spPr>
        <a:xfrm>
          <a:off x="305196" y="1143165"/>
          <a:ext cx="227806" cy="85427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54273"/>
              </a:lnTo>
              <a:lnTo>
                <a:pt x="227806" y="854273"/>
              </a:lnTo>
            </a:path>
          </a:pathLst>
        </a:custGeom>
        <a:noFill/>
        <a:ln w="19050" cap="flat" cmpd="sng" algn="ctr">
          <a:solidFill>
            <a:schemeClr val="accent1">
              <a:tint val="99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17F267C-58E7-4372-934B-5C2D046245EE}">
      <dsp:nvSpPr>
        <dsp:cNvPr id="0" name=""/>
        <dsp:cNvSpPr/>
      </dsp:nvSpPr>
      <dsp:spPr>
        <a:xfrm>
          <a:off x="533003" y="1427923"/>
          <a:ext cx="1822450" cy="113903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22860" rIns="34290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800" kern="1200" dirty="0"/>
            <a:t>Representative algorithmic works selected</a:t>
          </a:r>
        </a:p>
      </dsp:txBody>
      <dsp:txXfrm>
        <a:off x="566364" y="1461284"/>
        <a:ext cx="1755728" cy="1072309"/>
      </dsp:txXfrm>
    </dsp:sp>
    <dsp:sp modelId="{AF8B9D97-6751-4A65-9092-A4BE9A6B45A0}">
      <dsp:nvSpPr>
        <dsp:cNvPr id="0" name=""/>
        <dsp:cNvSpPr/>
      </dsp:nvSpPr>
      <dsp:spPr>
        <a:xfrm>
          <a:off x="305196" y="1143165"/>
          <a:ext cx="227806" cy="227806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278062"/>
              </a:lnTo>
              <a:lnTo>
                <a:pt x="227806" y="2278062"/>
              </a:lnTo>
            </a:path>
          </a:pathLst>
        </a:custGeom>
        <a:noFill/>
        <a:ln w="19050" cap="flat" cmpd="sng" algn="ctr">
          <a:solidFill>
            <a:schemeClr val="accent1">
              <a:tint val="99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4E73279-4C6A-4465-B034-9A51C03F778F}">
      <dsp:nvSpPr>
        <dsp:cNvPr id="0" name=""/>
        <dsp:cNvSpPr/>
      </dsp:nvSpPr>
      <dsp:spPr>
        <a:xfrm>
          <a:off x="533003" y="2851712"/>
          <a:ext cx="1822450" cy="113903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68200"/>
              <a:satOff val="-7112"/>
              <a:lumOff val="4778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22860" rIns="34290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800" kern="1200" dirty="0"/>
            <a:t>Seminal contributions identified</a:t>
          </a:r>
        </a:p>
      </dsp:txBody>
      <dsp:txXfrm>
        <a:off x="566364" y="2885073"/>
        <a:ext cx="1755728" cy="1072309"/>
      </dsp:txXfrm>
    </dsp:sp>
    <dsp:sp modelId="{CAA459FA-B23B-42C5-9911-C410487592CC}">
      <dsp:nvSpPr>
        <dsp:cNvPr id="0" name=""/>
        <dsp:cNvSpPr/>
      </dsp:nvSpPr>
      <dsp:spPr>
        <a:xfrm>
          <a:off x="305196" y="1143165"/>
          <a:ext cx="227806" cy="370185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701851"/>
              </a:lnTo>
              <a:lnTo>
                <a:pt x="227806" y="3701851"/>
              </a:lnTo>
            </a:path>
          </a:pathLst>
        </a:custGeom>
        <a:noFill/>
        <a:ln w="19050" cap="flat" cmpd="sng" algn="ctr">
          <a:solidFill>
            <a:schemeClr val="accent1">
              <a:tint val="99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81C5A39-DA9D-499C-AD8D-F23ABC9DA5E0}">
      <dsp:nvSpPr>
        <dsp:cNvPr id="0" name=""/>
        <dsp:cNvSpPr/>
      </dsp:nvSpPr>
      <dsp:spPr>
        <a:xfrm>
          <a:off x="533003" y="4275501"/>
          <a:ext cx="1822450" cy="113903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136400"/>
              <a:satOff val="-14223"/>
              <a:lumOff val="9555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22860" rIns="34290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800" kern="1200" dirty="0"/>
            <a:t>Recent developments reviewed</a:t>
          </a:r>
        </a:p>
      </dsp:txBody>
      <dsp:txXfrm>
        <a:off x="566364" y="4308862"/>
        <a:ext cx="1755728" cy="1072309"/>
      </dsp:txXfrm>
    </dsp:sp>
    <dsp:sp modelId="{EB732AC4-7F6C-43EE-8DD7-3C840C17E70E}">
      <dsp:nvSpPr>
        <dsp:cNvPr id="0" name=""/>
        <dsp:cNvSpPr/>
      </dsp:nvSpPr>
      <dsp:spPr>
        <a:xfrm>
          <a:off x="2924968" y="4134"/>
          <a:ext cx="2278062" cy="1139031"/>
        </a:xfrm>
        <a:prstGeom prst="roundRect">
          <a:avLst>
            <a:gd name="adj" fmla="val 10000"/>
          </a:avLst>
        </a:prstGeom>
        <a:solidFill>
          <a:schemeClr val="accent1">
            <a:shade val="80000"/>
            <a:hueOff val="272799"/>
            <a:satOff val="-28446"/>
            <a:lumOff val="1911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3340" tIns="35560" rIns="53340" bIns="35560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800" kern="1200" dirty="0"/>
            <a:t>Screening and selection</a:t>
          </a:r>
        </a:p>
      </dsp:txBody>
      <dsp:txXfrm>
        <a:off x="2958329" y="37495"/>
        <a:ext cx="2211340" cy="1072309"/>
      </dsp:txXfrm>
    </dsp:sp>
    <dsp:sp modelId="{835706D0-471A-4CAA-98BC-80885D4CA2CF}">
      <dsp:nvSpPr>
        <dsp:cNvPr id="0" name=""/>
        <dsp:cNvSpPr/>
      </dsp:nvSpPr>
      <dsp:spPr>
        <a:xfrm>
          <a:off x="3152775" y="1143165"/>
          <a:ext cx="227806" cy="85427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54273"/>
              </a:lnTo>
              <a:lnTo>
                <a:pt x="227806" y="854273"/>
              </a:lnTo>
            </a:path>
          </a:pathLst>
        </a:custGeom>
        <a:noFill/>
        <a:ln w="19050" cap="flat" cmpd="sng" algn="ctr">
          <a:solidFill>
            <a:schemeClr val="accent1">
              <a:tint val="99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858B34B-8A44-4EA0-B027-64A1E4C3FD35}">
      <dsp:nvSpPr>
        <dsp:cNvPr id="0" name=""/>
        <dsp:cNvSpPr/>
      </dsp:nvSpPr>
      <dsp:spPr>
        <a:xfrm>
          <a:off x="3380581" y="1427923"/>
          <a:ext cx="1822450" cy="113903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204599"/>
              <a:satOff val="-21335"/>
              <a:lumOff val="14333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22860" rIns="34290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800" kern="1200" dirty="0"/>
            <a:t>Relevance to sequence alignment theory</a:t>
          </a:r>
        </a:p>
      </dsp:txBody>
      <dsp:txXfrm>
        <a:off x="3413942" y="1461284"/>
        <a:ext cx="1755728" cy="1072309"/>
      </dsp:txXfrm>
    </dsp:sp>
    <dsp:sp modelId="{008C606F-C3BA-4519-BDF0-D69AAAF495E6}">
      <dsp:nvSpPr>
        <dsp:cNvPr id="0" name=""/>
        <dsp:cNvSpPr/>
      </dsp:nvSpPr>
      <dsp:spPr>
        <a:xfrm>
          <a:off x="3152775" y="1143165"/>
          <a:ext cx="227806" cy="227806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278062"/>
              </a:lnTo>
              <a:lnTo>
                <a:pt x="227806" y="2278062"/>
              </a:lnTo>
            </a:path>
          </a:pathLst>
        </a:custGeom>
        <a:noFill/>
        <a:ln w="19050" cap="flat" cmpd="sng" algn="ctr">
          <a:solidFill>
            <a:schemeClr val="accent1">
              <a:tint val="99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3F355B5-923E-4815-B540-859706716111}">
      <dsp:nvSpPr>
        <dsp:cNvPr id="0" name=""/>
        <dsp:cNvSpPr/>
      </dsp:nvSpPr>
      <dsp:spPr>
        <a:xfrm>
          <a:off x="3380581" y="2851712"/>
          <a:ext cx="1822450" cy="113903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272799"/>
              <a:satOff val="-28446"/>
              <a:lumOff val="1911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22860" rIns="34290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800" kern="1200" dirty="0"/>
            <a:t>Methodological contribution</a:t>
          </a:r>
        </a:p>
      </dsp:txBody>
      <dsp:txXfrm>
        <a:off x="3413942" y="2885073"/>
        <a:ext cx="1755728" cy="1072309"/>
      </dsp:txXfrm>
    </dsp:sp>
    <dsp:sp modelId="{AFFF3EA8-16EF-4BA4-96A2-9C32CBC5A52C}">
      <dsp:nvSpPr>
        <dsp:cNvPr id="0" name=""/>
        <dsp:cNvSpPr/>
      </dsp:nvSpPr>
      <dsp:spPr>
        <a:xfrm>
          <a:off x="3152775" y="1143165"/>
          <a:ext cx="227806" cy="370185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701851"/>
              </a:lnTo>
              <a:lnTo>
                <a:pt x="227806" y="3701851"/>
              </a:lnTo>
            </a:path>
          </a:pathLst>
        </a:custGeom>
        <a:noFill/>
        <a:ln w="19050" cap="flat" cmpd="sng" algn="ctr">
          <a:solidFill>
            <a:schemeClr val="accent1">
              <a:tint val="99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24C2400-830A-49A0-9C3F-B0D4E428E697}">
      <dsp:nvSpPr>
        <dsp:cNvPr id="0" name=""/>
        <dsp:cNvSpPr/>
      </dsp:nvSpPr>
      <dsp:spPr>
        <a:xfrm>
          <a:off x="3380581" y="4275501"/>
          <a:ext cx="1822450" cy="113903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340999"/>
              <a:satOff val="-35558"/>
              <a:lumOff val="23888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22860" rIns="34290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800" kern="1200" dirty="0"/>
            <a:t>Conceptual significance</a:t>
          </a:r>
        </a:p>
      </dsp:txBody>
      <dsp:txXfrm>
        <a:off x="3413942" y="4308862"/>
        <a:ext cx="1755728" cy="1072309"/>
      </dsp:txXfrm>
    </dsp:sp>
    <dsp:sp modelId="{98A547FB-1259-4D47-882C-D00E75709C70}">
      <dsp:nvSpPr>
        <dsp:cNvPr id="0" name=""/>
        <dsp:cNvSpPr/>
      </dsp:nvSpPr>
      <dsp:spPr>
        <a:xfrm>
          <a:off x="5772546" y="4134"/>
          <a:ext cx="2278062" cy="1139031"/>
        </a:xfrm>
        <a:prstGeom prst="roundRect">
          <a:avLst>
            <a:gd name="adj" fmla="val 10000"/>
          </a:avLst>
        </a:prstGeom>
        <a:solidFill>
          <a:schemeClr val="accent1">
            <a:shade val="80000"/>
            <a:hueOff val="545598"/>
            <a:satOff val="-56892"/>
            <a:lumOff val="38221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3340" tIns="35560" rIns="53340" bIns="35560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800" kern="1200"/>
            <a:t>Final inclusion</a:t>
          </a:r>
        </a:p>
      </dsp:txBody>
      <dsp:txXfrm>
        <a:off x="5805907" y="37495"/>
        <a:ext cx="2211340" cy="1072309"/>
      </dsp:txXfrm>
    </dsp:sp>
    <dsp:sp modelId="{3BB52678-B26F-431A-A8B6-F332A5FBC960}">
      <dsp:nvSpPr>
        <dsp:cNvPr id="0" name=""/>
        <dsp:cNvSpPr/>
      </dsp:nvSpPr>
      <dsp:spPr>
        <a:xfrm>
          <a:off x="6000353" y="1143165"/>
          <a:ext cx="227806" cy="85427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854273"/>
              </a:lnTo>
              <a:lnTo>
                <a:pt x="227806" y="854273"/>
              </a:lnTo>
            </a:path>
          </a:pathLst>
        </a:custGeom>
        <a:noFill/>
        <a:ln w="19050" cap="flat" cmpd="sng" algn="ctr">
          <a:solidFill>
            <a:schemeClr val="accent1">
              <a:tint val="99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CBCFC18-BC5D-4E4C-9AE4-9825B0AEE0E5}">
      <dsp:nvSpPr>
        <dsp:cNvPr id="0" name=""/>
        <dsp:cNvSpPr/>
      </dsp:nvSpPr>
      <dsp:spPr>
        <a:xfrm>
          <a:off x="6228159" y="1427923"/>
          <a:ext cx="1822450" cy="113903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409199"/>
              <a:satOff val="-42669"/>
              <a:lumOff val="28666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22860" rIns="34290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800" kern="1200" dirty="0"/>
            <a:t>Foundational methods</a:t>
          </a:r>
        </a:p>
      </dsp:txBody>
      <dsp:txXfrm>
        <a:off x="6261520" y="1461284"/>
        <a:ext cx="1755728" cy="1072309"/>
      </dsp:txXfrm>
    </dsp:sp>
    <dsp:sp modelId="{419F81FE-2678-4767-84D3-DCAE0C1C35F3}">
      <dsp:nvSpPr>
        <dsp:cNvPr id="0" name=""/>
        <dsp:cNvSpPr/>
      </dsp:nvSpPr>
      <dsp:spPr>
        <a:xfrm>
          <a:off x="6000353" y="1143165"/>
          <a:ext cx="227806" cy="227806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278062"/>
              </a:lnTo>
              <a:lnTo>
                <a:pt x="227806" y="2278062"/>
              </a:lnTo>
            </a:path>
          </a:pathLst>
        </a:custGeom>
        <a:noFill/>
        <a:ln w="19050" cap="flat" cmpd="sng" algn="ctr">
          <a:solidFill>
            <a:schemeClr val="accent1">
              <a:tint val="99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1A25613-FFAB-4AB4-9686-8AEF9529FCDD}">
      <dsp:nvSpPr>
        <dsp:cNvPr id="0" name=""/>
        <dsp:cNvSpPr/>
      </dsp:nvSpPr>
      <dsp:spPr>
        <a:xfrm>
          <a:off x="6228159" y="2851712"/>
          <a:ext cx="1822450" cy="113903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477399"/>
              <a:satOff val="-49780"/>
              <a:lumOff val="33443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22860" rIns="34290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800" kern="1200" dirty="0"/>
            <a:t>Algorithmic variants</a:t>
          </a:r>
        </a:p>
      </dsp:txBody>
      <dsp:txXfrm>
        <a:off x="6261520" y="2885073"/>
        <a:ext cx="1755728" cy="1072309"/>
      </dsp:txXfrm>
    </dsp:sp>
    <dsp:sp modelId="{2BF5A313-E8C7-4B1B-BDA8-FB16BDDAD459}">
      <dsp:nvSpPr>
        <dsp:cNvPr id="0" name=""/>
        <dsp:cNvSpPr/>
      </dsp:nvSpPr>
      <dsp:spPr>
        <a:xfrm>
          <a:off x="6000353" y="1143165"/>
          <a:ext cx="227806" cy="370185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701851"/>
              </a:lnTo>
              <a:lnTo>
                <a:pt x="227806" y="3701851"/>
              </a:lnTo>
            </a:path>
          </a:pathLst>
        </a:custGeom>
        <a:noFill/>
        <a:ln w="19050" cap="flat" cmpd="sng" algn="ctr">
          <a:solidFill>
            <a:schemeClr val="accent1">
              <a:tint val="99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D0599F6-756D-4DD1-AE12-9B63844C9296}">
      <dsp:nvSpPr>
        <dsp:cNvPr id="0" name=""/>
        <dsp:cNvSpPr/>
      </dsp:nvSpPr>
      <dsp:spPr>
        <a:xfrm>
          <a:off x="6228159" y="4275501"/>
          <a:ext cx="1822450" cy="113903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545598"/>
              <a:satOff val="-56892"/>
              <a:lumOff val="38221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4290" tIns="22860" rIns="34290" bIns="2286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800" kern="1200" dirty="0"/>
            <a:t>Modern developments</a:t>
          </a:r>
        </a:p>
      </dsp:txBody>
      <dsp:txXfrm>
        <a:off x="6261520" y="4308862"/>
        <a:ext cx="1755728" cy="1072309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0D1CAA7-556F-4DDB-AE04-C80C2C7916B1}">
      <dsp:nvSpPr>
        <dsp:cNvPr id="0" name=""/>
        <dsp:cNvSpPr/>
      </dsp:nvSpPr>
      <dsp:spPr>
        <a:xfrm>
          <a:off x="615" y="1121039"/>
          <a:ext cx="2647156" cy="3176587"/>
        </a:xfrm>
        <a:prstGeom prst="roundRect">
          <a:avLst>
            <a:gd name="adj" fmla="val 5000"/>
          </a:avLst>
        </a:prstGeom>
        <a:solidFill>
          <a:schemeClr val="accent1">
            <a:shade val="8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65151" rIns="84455" bIns="0" numCol="1" spcCol="1270" anchor="t" anchorCtr="0">
          <a:noAutofit/>
        </a:bodyPr>
        <a:lstStyle/>
        <a:p>
          <a:pPr marL="0" lvl="0" indent="0" algn="r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900" kern="1200" dirty="0"/>
            <a:t>Literature identification</a:t>
          </a:r>
        </a:p>
      </dsp:txBody>
      <dsp:txXfrm rot="16200000">
        <a:off x="-1037070" y="2158725"/>
        <a:ext cx="2604801" cy="529431"/>
      </dsp:txXfrm>
    </dsp:sp>
    <dsp:sp modelId="{96FA3981-F598-48A5-B7E2-E2451E636824}">
      <dsp:nvSpPr>
        <dsp:cNvPr id="0" name=""/>
        <dsp:cNvSpPr/>
      </dsp:nvSpPr>
      <dsp:spPr>
        <a:xfrm>
          <a:off x="530046" y="1121039"/>
          <a:ext cx="1972131" cy="3176587"/>
        </a:xfrm>
        <a:prstGeom prst="rect">
          <a:avLst/>
        </a:prstGeom>
        <a:noFill/>
        <a:ln w="19050" cap="flat" cmpd="sng" algn="ctr">
          <a:noFill/>
          <a:prstDash val="solid"/>
          <a:miter lim="800000"/>
        </a:ln>
        <a:effectLst/>
        <a:sp3d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75438" rIns="0" bIns="0" numCol="1" spcCol="1270" anchor="t" anchorCtr="0">
          <a:noAutofit/>
        </a:bodyPr>
        <a:lstStyle/>
        <a:p>
          <a:pPr marL="0" lvl="0" indent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Arial" panose="020B0604020202020204" pitchFamily="34" charset="0"/>
            <a:buNone/>
          </a:pPr>
          <a:r>
            <a:rPr lang="en-GB" sz="2200" kern="1200" dirty="0"/>
            <a:t>Representative algorithmic works selected</a:t>
          </a:r>
        </a:p>
        <a:p>
          <a:pPr marL="0" lvl="0" indent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Arial" panose="020B0604020202020204" pitchFamily="34" charset="0"/>
            <a:buNone/>
          </a:pPr>
          <a:r>
            <a:rPr lang="en-GB" sz="2200" kern="1200" dirty="0"/>
            <a:t>Seminal contributions identified</a:t>
          </a:r>
        </a:p>
        <a:p>
          <a:pPr marL="0" lvl="0" indent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Arial" panose="020B0604020202020204" pitchFamily="34" charset="0"/>
            <a:buNone/>
          </a:pPr>
          <a:r>
            <a:rPr lang="en-GB" sz="2200" kern="1200" dirty="0"/>
            <a:t>Recent developments reviewed</a:t>
          </a:r>
        </a:p>
      </dsp:txBody>
      <dsp:txXfrm>
        <a:off x="530046" y="1121039"/>
        <a:ext cx="1972131" cy="3176587"/>
      </dsp:txXfrm>
    </dsp:sp>
    <dsp:sp modelId="{457DB39D-4E29-4581-8AEA-4452EC68EE11}">
      <dsp:nvSpPr>
        <dsp:cNvPr id="0" name=""/>
        <dsp:cNvSpPr/>
      </dsp:nvSpPr>
      <dsp:spPr>
        <a:xfrm>
          <a:off x="2740421" y="1121039"/>
          <a:ext cx="2647156" cy="3176587"/>
        </a:xfrm>
        <a:prstGeom prst="roundRect">
          <a:avLst>
            <a:gd name="adj" fmla="val 5000"/>
          </a:avLst>
        </a:prstGeom>
        <a:solidFill>
          <a:schemeClr val="accent1">
            <a:shade val="80000"/>
            <a:hueOff val="272799"/>
            <a:satOff val="-28446"/>
            <a:lumOff val="1911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65151" rIns="84455" bIns="0" numCol="1" spcCol="1270" anchor="t" anchorCtr="0">
          <a:noAutofit/>
        </a:bodyPr>
        <a:lstStyle/>
        <a:p>
          <a:pPr marL="0" lvl="0" indent="0" algn="r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900" kern="1200" dirty="0"/>
            <a:t>Screening and selection</a:t>
          </a:r>
        </a:p>
      </dsp:txBody>
      <dsp:txXfrm rot="16200000">
        <a:off x="1702736" y="2158725"/>
        <a:ext cx="2604801" cy="529431"/>
      </dsp:txXfrm>
    </dsp:sp>
    <dsp:sp modelId="{D2592E04-593A-4DE6-9F3D-B477DCCCA243}">
      <dsp:nvSpPr>
        <dsp:cNvPr id="0" name=""/>
        <dsp:cNvSpPr/>
      </dsp:nvSpPr>
      <dsp:spPr>
        <a:xfrm rot="5400000">
          <a:off x="2520299" y="3645011"/>
          <a:ext cx="466715" cy="397073"/>
        </a:xfrm>
        <a:prstGeom prst="flowChartExtra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4548099-1E05-4837-8692-E14E257E1FEB}">
      <dsp:nvSpPr>
        <dsp:cNvPr id="0" name=""/>
        <dsp:cNvSpPr/>
      </dsp:nvSpPr>
      <dsp:spPr>
        <a:xfrm>
          <a:off x="3269853" y="1121039"/>
          <a:ext cx="1972131" cy="3176587"/>
        </a:xfrm>
        <a:prstGeom prst="rect">
          <a:avLst/>
        </a:prstGeom>
        <a:noFill/>
        <a:ln w="19050" cap="flat" cmpd="sng" algn="ctr">
          <a:noFill/>
          <a:prstDash val="solid"/>
          <a:miter lim="800000"/>
        </a:ln>
        <a:effectLst/>
        <a:sp3d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75438" rIns="0" bIns="0" numCol="1" spcCol="1270" anchor="t" anchorCtr="0">
          <a:noAutofit/>
        </a:bodyPr>
        <a:lstStyle/>
        <a:p>
          <a:pPr marL="0" lvl="0" indent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200" kern="1200" dirty="0"/>
            <a:t>Relevance to sequence alignment theory</a:t>
          </a:r>
        </a:p>
        <a:p>
          <a:pPr marL="0" lvl="0" indent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200" kern="1200" dirty="0"/>
            <a:t>Methodological contribution</a:t>
          </a:r>
        </a:p>
        <a:p>
          <a:pPr marL="0" lvl="0" indent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200" kern="1200" dirty="0"/>
            <a:t>Conceptual significance</a:t>
          </a:r>
        </a:p>
      </dsp:txBody>
      <dsp:txXfrm>
        <a:off x="3269853" y="1121039"/>
        <a:ext cx="1972131" cy="3176587"/>
      </dsp:txXfrm>
    </dsp:sp>
    <dsp:sp modelId="{DFCE6DCE-8BF0-49BA-8C5D-53CD4CF94A6B}">
      <dsp:nvSpPr>
        <dsp:cNvPr id="0" name=""/>
        <dsp:cNvSpPr/>
      </dsp:nvSpPr>
      <dsp:spPr>
        <a:xfrm>
          <a:off x="5480228" y="1121039"/>
          <a:ext cx="2647156" cy="3176587"/>
        </a:xfrm>
        <a:prstGeom prst="roundRect">
          <a:avLst>
            <a:gd name="adj" fmla="val 5000"/>
          </a:avLst>
        </a:prstGeom>
        <a:solidFill>
          <a:schemeClr val="accent1">
            <a:shade val="80000"/>
            <a:hueOff val="545598"/>
            <a:satOff val="-56892"/>
            <a:lumOff val="38221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65151" rIns="84455" bIns="0" numCol="1" spcCol="1270" anchor="t" anchorCtr="0">
          <a:noAutofit/>
        </a:bodyPr>
        <a:lstStyle/>
        <a:p>
          <a:pPr marL="0" lvl="0" indent="0" algn="r" defTabSz="844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900" kern="1200"/>
            <a:t>Final inclusion</a:t>
          </a:r>
        </a:p>
      </dsp:txBody>
      <dsp:txXfrm rot="16200000">
        <a:off x="4442543" y="2158725"/>
        <a:ext cx="2604801" cy="529431"/>
      </dsp:txXfrm>
    </dsp:sp>
    <dsp:sp modelId="{653EE05C-CF20-4FB1-AC5E-BBC302C8CA75}">
      <dsp:nvSpPr>
        <dsp:cNvPr id="0" name=""/>
        <dsp:cNvSpPr/>
      </dsp:nvSpPr>
      <dsp:spPr>
        <a:xfrm rot="5400000">
          <a:off x="5260106" y="3645011"/>
          <a:ext cx="466715" cy="397073"/>
        </a:xfrm>
        <a:prstGeom prst="flowChartExtra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accent1">
              <a:shade val="80000"/>
              <a:hueOff val="545598"/>
              <a:satOff val="-56892"/>
              <a:lumOff val="38221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F32E4CD-F3DC-4C23-85C0-558CC4CEE2AD}">
      <dsp:nvSpPr>
        <dsp:cNvPr id="0" name=""/>
        <dsp:cNvSpPr/>
      </dsp:nvSpPr>
      <dsp:spPr>
        <a:xfrm>
          <a:off x="6009659" y="1121039"/>
          <a:ext cx="1972131" cy="3176587"/>
        </a:xfrm>
        <a:prstGeom prst="rect">
          <a:avLst/>
        </a:prstGeom>
        <a:noFill/>
        <a:ln w="19050" cap="flat" cmpd="sng" algn="ctr">
          <a:noFill/>
          <a:prstDash val="solid"/>
          <a:miter lim="800000"/>
        </a:ln>
        <a:effectLst/>
        <a:sp3d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75438" rIns="0" bIns="0" numCol="1" spcCol="1270" anchor="t" anchorCtr="0">
          <a:noAutofit/>
        </a:bodyPr>
        <a:lstStyle/>
        <a:p>
          <a:pPr marL="0" lvl="0" indent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200" kern="1200" dirty="0"/>
            <a:t>Foundational methods</a:t>
          </a:r>
        </a:p>
        <a:p>
          <a:pPr marL="0" lvl="0" indent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200" kern="1200" dirty="0"/>
            <a:t>Algorithmic variants</a:t>
          </a:r>
        </a:p>
        <a:p>
          <a:pPr marL="0" lvl="0" indent="0" algn="l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200" kern="1200" dirty="0"/>
            <a:t>Modern developments</a:t>
          </a:r>
        </a:p>
      </dsp:txBody>
      <dsp:txXfrm>
        <a:off x="6009659" y="1121039"/>
        <a:ext cx="1972131" cy="317658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list1">
  <dgm:title val=""/>
  <dgm:desc val=""/>
  <dgm:catLst>
    <dgm:cat type="list" pri="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T"/>
          <dgm:param type="vertAlign" val="mid"/>
          <dgm:param type="horzAlign" val="l"/>
          <dgm:param type="nodeHorzAlign" val="l"/>
        </dgm:alg>
      </dgm:if>
      <dgm:else name="Name2">
        <dgm:alg type="lin">
          <dgm:param type="linDir" val="fromT"/>
          <dgm:param type="vertAlign" val="mid"/>
          <dgm:param type="horzAlign" val="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parentLin" refType="w"/>
      <dgm:constr type="h" for="ch" forName="parentLin" val="INF"/>
      <dgm:constr type="w" for="des" forName="parentLeftMargin" refType="w" fact="0.05"/>
      <dgm:constr type="w" for="des" forName="parentText" refType="w" fact="0.7"/>
      <dgm:constr type="h" for="des" forName="parentText" refType="primFontSz" refFor="des" refForName="parentText" fact="0.82"/>
      <dgm:constr type="h" for="ch" forName="negativeSpace" refType="primFontSz" refFor="des" refForName="parentText" fact="-0.41"/>
      <dgm:constr type="h" for="ch" forName="negativeSpace" refType="h" refFor="des" refForName="parentText" op="lte" fact="-0.82"/>
      <dgm:constr type="h" for="ch" forName="negativeSpace" refType="h" refFor="des" refForName="parentText" op="gte" fact="-0.82"/>
      <dgm:constr type="w" for="ch" forName="childText" refType="w"/>
      <dgm:constr type="h" for="ch" forName="childText" refType="primFontSz" refFor="des" refForName="parentText" fact="0.7"/>
      <dgm:constr type="primFontSz" for="des" forName="parentText" val="65"/>
      <dgm:constr type="primFontSz" for="ch" forName="childText" refType="primFontSz" refFor="des" refForName="parentText"/>
      <dgm:constr type="tMarg" for="ch" forName="childText" refType="primFontSz" refFor="des" refForName="parentText" fact="1.64"/>
      <dgm:constr type="tMarg" for="ch" forName="childText" refType="h" refFor="des" refForName="parentText" op="lte" fact="3.28"/>
      <dgm:constr type="tMarg" for="ch" forName="childText" refType="h" refFor="des" refForName="parentText" op="gte" fact="3.28"/>
      <dgm:constr type="lMarg" for="ch" forName="childText" refType="w" fact="0.22"/>
      <dgm:constr type="rMarg" for="ch" forName="childText" refType="lMarg" refFor="ch" refForName="childText"/>
      <dgm:constr type="lMarg" for="des" forName="parentText" refType="w" fact="0.075"/>
      <dgm:constr type="rMarg" for="des" forName="parentText" refType="lMarg" refFor="des" refForName="parentText"/>
      <dgm:constr type="h" for="ch" forName="spaceBetweenRectangles" refType="primFontSz" refFor="des" refForName="parentText" fact="0.15"/>
    </dgm:constrLst>
    <dgm:ruleLst>
      <dgm:rule type="primFontSz" for="des" forName="parentText" val="5" fact="NaN" max="NaN"/>
    </dgm:ruleLst>
    <dgm:forEach name="Name3" axis="ch" ptType="node">
      <dgm:layoutNode name="parentLin">
        <dgm:choose name="Name4">
          <dgm:if name="Name5" func="var" arg="dir" op="equ" val="norm">
            <dgm:alg type="lin">
              <dgm:param type="linDir" val="fromL"/>
              <dgm:param type="horzAlign" val="l"/>
              <dgm:param type="nodeHorzAlign" val="l"/>
            </dgm:alg>
          </dgm:if>
          <dgm:else name="Name6">
            <dgm:alg type="lin">
              <dgm:param type="linDir" val="fromR"/>
              <dgm:param type="horzAlign" val="r"/>
              <dgm:param type="nodeHorzAlign" val="r"/>
            </dgm:alg>
          </dgm:else>
        </dgm:choose>
        <dgm:shape xmlns:r="http://schemas.openxmlformats.org/officeDocument/2006/relationships" r:blip="">
          <dgm:adjLst/>
        </dgm:shape>
        <dgm:presOf/>
        <dgm:constrLst/>
        <dgm:ruleLst/>
        <dgm:layoutNode name="parentLeftMargin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h"/>
          </dgm:constrLst>
          <dgm:ruleLst/>
        </dgm:layoutNode>
        <dgm:layoutNode name="parentText" styleLbl="node1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parTxLTRAlign" val="l"/>
                <dgm:param type="parTxRTLAlign" val="l"/>
              </dgm:alg>
            </dgm:if>
            <dgm:else name="Name9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/>
            <dgm:constr type="bMarg"/>
          </dgm:constrLst>
          <dgm:ruleLst/>
        </dgm:layoutNode>
      </dgm:layoutNode>
      <dgm:layoutNode name="negative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childText" styleLbl="conFgAcc1">
        <dgm:varLst>
          <dgm:bulletEnabled val="1"/>
        </dgm:varLst>
        <dgm:alg type="tx">
          <dgm:param type="stBulletLvl" val="1"/>
        </dgm:alg>
        <dgm:shape xmlns:r="http://schemas.openxmlformats.org/officeDocument/2006/relationships" type="rect" r:blip="" zOrderOff="-2">
          <dgm:adjLst/>
        </dgm:shape>
        <dgm:presOf axis="des" ptType="node"/>
        <dgm:constrLst>
          <dgm:constr type="secFontSz" refType="primFontSz"/>
        </dgm:constrLst>
        <dgm:ruleLst>
          <dgm:rule type="h" val="INF" fact="NaN" max="NaN"/>
        </dgm:ruleLst>
      </dgm:layoutNode>
      <dgm:forEach name="Name1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ierarchy3">
  <dgm:title val=""/>
  <dgm:desc val=""/>
  <dgm:catLst>
    <dgm:cat type="hierarchy" pri="7000"/>
    <dgm:cat type="list" pri="23000"/>
    <dgm:cat type="relationship" pri="15000"/>
    <dgm:cat type="convert" pri="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</dgm:ptLst>
      <dgm:cxnLst>
        <dgm:cxn modelId="4" srcId="0" destId="1" srcOrd="0" destOrd="0"/>
        <dgm:cxn modelId="5" srcId="1" destId="11" srcOrd="0" destOrd="0"/>
        <dgm:cxn modelId="6" srcId="1" destId="12" srcOrd="1" destOrd="0"/>
        <dgm:cxn modelId="7" srcId="0" destId="2" srcOrd="1" destOrd="0"/>
        <dgm:cxn modelId="8" srcId="2" destId="21" srcOrd="0" destOrd="0"/>
        <dgm:cxn modelId="9" srcId="2" destId="2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forName="rootText" op="equ" val="65"/>
      <dgm:constr type="primFontSz" for="des" forName="childText" op="equ" val="65"/>
      <dgm:constr type="w" for="des" forName="rootComposite" refType="w"/>
      <dgm:constr type="h" for="des" forName="rootComposite" refType="w" fact="0.5"/>
      <dgm:constr type="w" for="des" forName="childText" refType="w" refFor="des" refForName="rootComposite" fact="0.8"/>
      <dgm:constr type="h" for="des" forName="childText" refType="h" refFor="des" refForName="rootComposite"/>
      <dgm:constr type="sibSp" refType="w" refFor="des" refForName="rootComposite" fact="0.25"/>
      <dgm:constr type="sibSp" for="des" forName="childShape" refType="h" refFor="des" refForName="childText" fact="0.25"/>
      <dgm:constr type="sp" for="des" forName="root" refType="h" refFor="des" refForName="childText" fact="0.25"/>
    </dgm:constrLst>
    <dgm:ruleLst/>
    <dgm:forEach name="Name3" axis="ch">
      <dgm:forEach name="Name4" axis="self" ptType="node" cnt="1">
        <dgm:layoutNode name="root">
          <dgm:choose name="Name5">
            <dgm:if name="Name6" func="var" arg="dir" op="equ" val="norm">
              <dgm:alg type="hierRoot">
                <dgm:param type="hierAlign" val="tL"/>
              </dgm:alg>
            </dgm:if>
            <dgm:else name="Name7">
              <dgm:alg type="hierRoot">
                <dgm:param type="hierAlign" val="tR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>
            <dgm:constr type="alignOff" val="0.2"/>
          </dgm:constrLst>
          <dgm:ruleLst/>
          <dgm:layoutNode name="rootComposite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8">
              <dgm:if name="Name9" func="var" arg="dir" op="equ" val="norm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l" for="ch" forName="rootConnector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if>
              <dgm:else name="Name10">
                <dgm:constrLst>
                  <dgm:constr type="l" for="ch" forName="rootText"/>
                  <dgm:constr type="t" for="ch" forName="rootText"/>
                  <dgm:constr type="w" for="ch" forName="rootText" refType="w"/>
                  <dgm:constr type="h" for="ch" forName="rootText" refType="h"/>
                  <dgm:constr type="r" for="ch" forName="rootConnector" refType="w"/>
                  <dgm:constr type="t" for="ch" forName="rootConnector"/>
                  <dgm:constr type="w" for="ch" forName="rootConnector" refType="w" refFor="ch" refForName="rootText" fact="0.2"/>
                  <dgm:constr type="h" for="ch" forName="rootConnector" refType="h" refFor="ch" refForName="rootText"/>
                </dgm:constrLst>
              </dgm:else>
            </dgm:choose>
            <dgm:ruleLst/>
            <dgm:layoutNode name="rootText" styleLbl="node1"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 ptType="node" cnt="1"/>
              <dgm:constrLst>
                <dgm:constr type="tMarg" refType="primFontSz" fact="0.1"/>
                <dgm:constr type="bMarg" refType="primFontSz" fact="0.1"/>
                <dgm:constr type="lMarg" refType="primFontSz" fact="0.15"/>
                <dgm:constr type="rMarg" refType="primFontSz" fact="0.15"/>
              </dgm:constrLst>
              <dgm:ruleLst>
                <dgm:rule type="primFontSz" val="5" fact="NaN" max="NaN"/>
              </dgm:ruleLst>
            </dgm:layoutNode>
            <dgm:layoutNode name="rootConnector" moveWith="rootText">
              <dgm:alg type="sp"/>
              <dgm:shape xmlns:r="http://schemas.openxmlformats.org/officeDocument/2006/relationships" type="roundRect" r:blip="" hideGeom="1">
                <dgm:adjLst>
                  <dgm:adj idx="1" val="0.1"/>
                </dgm:adjLst>
              </dgm:shape>
              <dgm:presOf axis="self" ptType="node" cnt="1"/>
              <dgm:constrLst/>
              <dgm:ruleLst/>
            </dgm:layoutNode>
          </dgm:layoutNode>
          <dgm:layoutNode name="childShape">
            <dgm:alg type="hierChild">
              <dgm:param type="chAlign" val="l"/>
              <dgm:param type="linDir" val="fromT"/>
            </dgm:alg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11" axis="ch">
              <dgm:forEach name="Name12" axis="self" ptType="parTrans" cnt="1">
                <dgm:layoutNode name="Name13">
                  <dgm:choose name="Name14">
                    <dgm:if name="Name15" func="var" arg="dir" op="equ" val="norm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L"/>
                      </dgm:alg>
                    </dgm:if>
                    <dgm:else name="Name16">
                      <dgm:alg type="conn">
                        <dgm:param type="dim" val="1D"/>
                        <dgm:param type="endSty" val="noArr"/>
                        <dgm:param type="connRout" val="bend"/>
                        <dgm:param type="srcNode" val="rootConnector"/>
                        <dgm:param type="begPts" val="bCtr"/>
                        <dgm:param type="endPts" val="mid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7" axis="self" ptType="node">
                <dgm:layoutNode name="childText" styleLbl="bgAcc1">
                  <dgm:varLst>
                    <dgm:bulletEnabled val="1"/>
                  </dgm:varLst>
                  <dgm:alg type="tx"/>
                  <dgm:shape xmlns:r="http://schemas.openxmlformats.org/officeDocument/2006/relationships" type="roundRect" r:blip="">
                    <dgm:adjLst>
                      <dgm:adj idx="1" val="0.1"/>
                    </dgm:adjLst>
                  </dgm:shape>
                  <dgm:presOf axis="self desOrSelf" ptType="node node" st="1 1" cnt="1 0"/>
                  <dgm:constrLst>
                    <dgm:constr type="tMarg" refType="primFontSz" fact="0.1"/>
                    <dgm:constr type="bMarg" refType="primFontSz" fact="0.1"/>
                    <dgm:constr type="lMarg" refType="primFontSz" fact="0.15"/>
                    <dgm:constr type="rMarg" refType="primFontSz" fact="0.15"/>
                  </dgm:constrLst>
                  <dgm:ruleLst>
                    <dgm:rule type="primFontSz" val="5" fact="NaN" max="NaN"/>
                  </dgm:ruleLst>
                </dgm:layoutNode>
              </dgm:forEach>
            </dgm:forEach>
          </dgm:layoutNode>
        </dgm:layoutNode>
      </dgm:forEach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hProcess7">
  <dgm:title val=""/>
  <dgm:desc val=""/>
  <dgm:catLst>
    <dgm:cat type="process" pri="21000"/>
    <dgm:cat type="list" pri="9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23" srcId="2" destId="21" srcOrd="0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>
          <dgm:param type="linDir" val="fromL"/>
          <dgm:param type="nodeVertAlign" val="t"/>
        </dgm:alg>
      </dgm:if>
      <dgm:else name="Name3">
        <dgm:alg type="lin">
          <dgm:param type="linDir" val="fromR"/>
          <dgm:param type="nodeVertAlign" val="t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compositeNode" refType="h"/>
      <dgm:constr type="w" for="ch" forName="compositeNode" refType="w"/>
      <dgm:constr type="w" for="ch" forName="hSp" refType="w" refFor="ch" refForName="compositeNode" fact="-0.035"/>
      <dgm:constr type="w" for="des" forName="simulatedConn" refType="w" refFor="ch" refForName="compositeNode" fact="0.15"/>
      <dgm:constr type="h" for="des" forName="simulatedConn" refType="w" refFor="des" refForName="simulatedConn"/>
      <dgm:constr type="h" for="des" forName="vSp1" refType="w" refFor="ch" refForName="compositeNode" fact="0.8"/>
      <dgm:constr type="h" for="des" forName="vSp2" refType="w" refFor="ch" refForName="compositeNode" fact="0.07"/>
      <dgm:constr type="w" for="ch" forName="vProcSp" refType="w" refFor="des" refForName="simulatedConn" op="equ"/>
      <dgm:constr type="h" for="ch" forName="vProcSp" refType="h" refFor="ch" refForName="compositeNode" op="equ"/>
      <dgm:constr type="w" for="ch" forName="sibTrans" refType="w" refFor="ch" refForName="compositeNode" fact="-0.08"/>
      <dgm:constr type="primFontSz" for="des" forName="parentNode" op="equ"/>
      <dgm:constr type="primFontSz" for="des" forName="childNode" op="equ"/>
    </dgm:constrLst>
    <dgm:ruleLst/>
    <dgm:forEach name="Name4" axis="ch" ptType="node">
      <dgm:layoutNode name="compositeNode">
        <dgm:varLst>
          <dgm:bulletEnabled val="1"/>
        </dgm:varLst>
        <dgm:alg type="composite"/>
        <dgm:choose name="Name5">
          <dgm:if name="Name6" func="var" arg="dir" op="equ" val="norm">
            <dgm:constrLst>
              <dgm:constr type="h" refType="w" op="lte" fact="1.2"/>
              <dgm:constr type="w" for="ch" forName="bgRect" refType="w"/>
              <dgm:constr type="h" for="ch" forName="bgRect" refType="h"/>
              <dgm:constr type="t" for="ch" forName="bgRect"/>
              <dgm:constr type="l" for="ch" forName="bgRect"/>
              <dgm:constr type="w" for="ch" forName="parentNode" refType="w" refFor="ch" refForName="bgRect" fact="0.2"/>
              <dgm:constr type="h" for="ch" forName="parentNode" refType="h" fact="0.82"/>
              <dgm:constr type="t" for="ch" forName="parentNode"/>
              <dgm:constr type="l" for="ch" forName="parentNode"/>
              <dgm:constr type="r" for="ch" forName="childNode" refType="r" refFor="ch" refForName="bgRect" fact="0.945"/>
              <dgm:constr type="h" for="ch" forName="childNode" refType="h" refFor="ch" refForName="bgRect" op="equ"/>
              <dgm:constr type="t" for="ch" forName="childNode"/>
              <dgm:constr type="l" for="ch" forName="childNode" refType="r" refFor="ch" refForName="parentNode"/>
            </dgm:constrLst>
          </dgm:if>
          <dgm:else name="Name7">
            <dgm:constrLst>
              <dgm:constr type="h" refType="w" op="lte" fact="1.2"/>
              <dgm:constr type="w" for="ch" forName="bgRect" refType="w"/>
              <dgm:constr type="h" for="ch" forName="bgRect" refType="h"/>
              <dgm:constr type="t" for="ch" forName="bgRect"/>
              <dgm:constr type="r" for="ch" forName="bgRect" refType="w"/>
              <dgm:constr type="w" for="ch" forName="parentNode" refType="w" refFor="ch" refForName="bgRect" fact="0.2"/>
              <dgm:constr type="h" for="ch" forName="parentNode" refType="h" fact="0.82"/>
              <dgm:constr type="t" for="ch" forName="parentNode"/>
              <dgm:constr type="r" for="ch" forName="parentNode" refType="w"/>
              <dgm:constr type="h" for="ch" forName="childNode" refType="h" refFor="ch" refForName="bgRect"/>
              <dgm:constr type="t" for="ch" forName="childNode"/>
              <dgm:constr type="r" for="ch" forName="childNode" refType="l" refFor="ch" refForName="parentNode"/>
              <dgm:constr type="l" for="ch" forName="childNode" refType="w" refFor="ch" refForName="bgRect" fact="0.055"/>
            </dgm:constrLst>
          </dgm:else>
        </dgm:choose>
        <dgm:ruleLst>
          <dgm:rule type="w" for="ch" forName="childNode" val="NaN" fact="NaN" max="30"/>
        </dgm:ruleLst>
        <dgm:layoutNode name="bgRect" styleLbl="node1">
          <dgm:alg type="sp"/>
          <dgm:shape xmlns:r="http://schemas.openxmlformats.org/officeDocument/2006/relationships" type="roundRect" r:blip="" zOrderOff="-1">
            <dgm:adjLst>
              <dgm:adj idx="1" val="0.05"/>
            </dgm:adjLst>
          </dgm:shape>
          <dgm:presOf axis="self"/>
          <dgm:constrLst/>
          <dgm:ruleLst/>
        </dgm:layoutNode>
        <dgm:layoutNode name="parentNode" styleLbl="node1">
          <dgm:varLst>
            <dgm:chMax val="0"/>
            <dgm:bulletEnabled val="1"/>
          </dgm:varLst>
          <dgm:presOf axis="self"/>
          <dgm:choose name="Name8">
            <dgm:if name="Name9" func="var" arg="dir" op="equ" val="norm">
              <dgm:alg type="tx">
                <dgm:param type="autoTxRot" val="grav"/>
                <dgm:param type="txAnchorVert" val="t"/>
                <dgm:param type="parTxLTRAlign" val="r"/>
                <dgm:param type="parTxRTLAlign" val="r"/>
              </dgm:alg>
              <dgm:shape xmlns:r="http://schemas.openxmlformats.org/officeDocument/2006/relationships" rot="270" type="rect" r:blip="" hideGeom="1">
                <dgm:adjLst/>
              </dgm:shape>
              <dgm:constrLst>
                <dgm:constr type="primFontSz" val="65"/>
                <dgm:constr type="lMarg"/>
                <dgm:constr type="rMarg" refType="primFontSz" fact="0.35"/>
                <dgm:constr type="tMarg" refType="primFontSz" fact="0.27"/>
                <dgm:constr type="bMarg"/>
              </dgm:constrLst>
            </dgm:if>
            <dgm:else name="Name10">
              <dgm:alg type="tx">
                <dgm:param type="autoTxRot" val="grav"/>
                <dgm:param type="txAnchorVert" val="t"/>
                <dgm:param type="parTxLTRAlign" val="l"/>
                <dgm:param type="parTxRTLAlign" val="l"/>
              </dgm:alg>
              <dgm:shape xmlns:r="http://schemas.openxmlformats.org/officeDocument/2006/relationships" rot="90" type="rect" r:blip="" hideGeom="1">
                <dgm:adjLst/>
              </dgm:shape>
              <dgm:constrLst>
                <dgm:constr type="primFontSz" val="65"/>
                <dgm:constr type="lMarg" refType="primFontSz" fact="0.35"/>
                <dgm:constr type="rMarg"/>
                <dgm:constr type="tMarg" refType="primFontSz" fact="0.27"/>
                <dgm:constr type="bMarg"/>
              </dgm:constrLst>
            </dgm:else>
          </dgm:choose>
          <dgm:ruleLst>
            <dgm:rule type="primFontSz" val="5" fact="NaN" max="NaN"/>
          </dgm:ruleLst>
        </dgm:layoutNode>
        <dgm:choose name="Name11">
          <dgm:if name="Name12" axis="ch" ptType="node" func="cnt" op="gte" val="1">
            <dgm:layoutNode name="childNode" styleLbl="node1" moveWith="bgRect">
              <dgm:varLst>
                <dgm:bulletEnabled val="1"/>
              </dgm:varLst>
              <dgm:alg type="tx">
                <dgm:param type="parTxLTRAlign" val="l"/>
                <dgm:param type="parTxRTLAlign" val="r"/>
                <dgm:param type="txAnchorVert" val="t"/>
              </dgm:alg>
              <dgm:shape xmlns:r="http://schemas.openxmlformats.org/officeDocument/2006/relationships" type="rect" r:blip="" hideGeom="1">
                <dgm:adjLst/>
              </dgm:shape>
              <dgm:presOf axis="des" ptType="node"/>
              <dgm:constrLst>
                <dgm:constr type="primFontSz" val="65"/>
                <dgm:constr type="lMarg"/>
                <dgm:constr type="bMarg"/>
                <dgm:constr type="tMarg" refType="primFontSz" fact="0.27"/>
                <dgm:constr type="rMarg"/>
              </dgm:constrLst>
              <dgm:ruleLst>
                <dgm:rule type="primFontSz" val="5" fact="NaN" max="NaN"/>
              </dgm:ruleLst>
            </dgm:layoutNode>
          </dgm:if>
          <dgm:else name="Name13"/>
        </dgm:choose>
      </dgm:layoutNode>
      <dgm:forEach name="Name14" axis="followSib" ptType="sibTrans" cnt="1">
        <dgm:layoutNode name="hSp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vProcSp" moveWith="bgRect">
          <dgm:alg type="lin">
            <dgm:param type="linDir" val="fromT"/>
          </dgm:alg>
          <dgm:shape xmlns:r="http://schemas.openxmlformats.org/officeDocument/2006/relationships" r:blip="">
            <dgm:adjLst/>
          </dgm:shape>
          <dgm:presOf/>
          <dgm:constrLst>
            <dgm:constr type="w" for="ch" forName="vSp1" refType="w"/>
            <dgm:constr type="w" for="ch" forName="simulatedConn" refType="w"/>
            <dgm:constr type="w" for="ch" forName="vSp2" refType="w"/>
          </dgm:constrLst>
          <dgm:ruleLst/>
          <dgm:layoutNode name="vSp1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  <dgm:layoutNode name="simulatedConn" styleLbl="solidFgAcc1">
            <dgm:alg type="sp"/>
            <dgm:choose name="Name15">
              <dgm:if name="Name16" func="var" arg="dir" op="equ" val="norm">
                <dgm:shape xmlns:r="http://schemas.openxmlformats.org/officeDocument/2006/relationships" rot="90" type="flowChartExtract" r:blip="">
                  <dgm:adjLst/>
                </dgm:shape>
              </dgm:if>
              <dgm:else name="Name17">
                <dgm:shape xmlns:r="http://schemas.openxmlformats.org/officeDocument/2006/relationships" rot="-90" type="flowChartExtract" r:blip="">
                  <dgm:adjLst/>
                </dgm:shape>
              </dgm:else>
            </dgm:choose>
            <dgm:presOf/>
            <dgm:constrLst/>
            <dgm:ruleLst/>
          </dgm:layoutNode>
          <dgm:layoutNode name="vSp2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layoutNode>
        <dgm:layoutNode name="sibTran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316379-F484-8CE3-953F-66F91E62CC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5F285FC-649F-4DDD-13A0-3B5573CA6D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AEEF58-56AD-76A2-6492-C4D7778FD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9EAEF1-E616-7B14-ADD4-C1183D6DD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AD054C-C7EE-799A-3D21-D2B84611D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4328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F372B5-E781-02C6-E12E-A372A65FB0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6D3AC6-CE12-9502-DA48-16391CAC5E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8737A9-E236-D87E-ADD5-3A05F3CC3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D595C5-1A1E-4A39-BC59-60B70C984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2F2990-BA16-57A2-C2A4-751A6F191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3836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92D3413-A9AA-BA3F-29AB-EE5505BD7C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E54DE9-F34F-33C2-495D-678B0F7C75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3F2213-1574-B19F-5AF7-6C4AB6733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C5D13C-6DF7-A296-D782-79BC62B1C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3F228-AEB8-1219-70B3-CC7AAA2075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7450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FC1C99-F123-A589-15B9-B0B6F1145E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F2AB5A-AAD1-27FA-AE41-28B5CE3796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FD3C3F-735F-BE4C-A6F9-A6F3F5A2B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FC9A46-F98F-0728-7269-FD6953E0FF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C2CAF9-9BAB-D851-75C6-9366C2276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445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55487A-66DC-9F51-2FDF-EF67D369C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F9EFEF-2508-416D-DDDA-923C6B4364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91B5E4-31F7-C263-5849-758662601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7EA40A-25B2-BA67-1300-46CF3CCC6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F35825-C5AB-2C23-033E-829FED61CF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7897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1E36DA-DF09-3C38-59E0-9B0B054F2D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ABDAF6-8E4E-E7DD-BB28-B5B6634A58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6C0D16-EBC7-A8F2-FA87-52812B51D0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8D5711-579E-8B2C-9E38-9CAD4C1F8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3650BE-A750-21A0-26B8-6DFCB578E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DB4CC4-4E5F-F231-4498-50A13F31E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5400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A9B64-5699-193E-DFE8-FC23D976C9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B4786D-E4EC-B3E5-30C6-2EB376DDAA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C63122-5A99-69E8-4BC6-3F9FB8A3B1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21927F-BDAF-CBA0-D453-D9EA5783D5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4092329-E95A-DF36-6E33-DF2937C5B0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79AA539-047B-9242-B05C-5ACE843C0E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D1CCE6E-160D-7BC7-43CD-C53D05878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6221A0-3E0B-FF7E-7D91-698B5ADFC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0434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8DA49-6B56-335B-833F-6FDDB30057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50D9E5-3D28-EE65-A0D5-56D1E4088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DF3178-5461-A526-F613-CEEE5F7B0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4230E22-70B3-514A-EF68-6FEB82C03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7910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C00A4F-FE59-F30E-36D5-1D032C41C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FE0A250-C86B-AA67-B76A-2EC3FA9E3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43E6B4-F5F4-44AB-35EB-328182AA2C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3088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364D2A-B58C-CA3F-DB6D-83926DBABC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47B9E4-0D53-1900-6C8A-7995320070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EE4168-7965-9F58-6426-52A5E14D7A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1D07A2-DDCC-D048-9EFE-EAB487978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B4220F-FB5F-559F-BAFF-5E5294152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4B6218-903D-0C60-359D-B27C00E5C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9927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CAAEC-631E-F956-F28C-52F19906D4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29ED5C-208D-5447-C847-90FF9A38DF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10B8FB-24E9-531C-F2DD-1F70DF1B31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AA9B7B-CD73-5AA0-0131-792E755F8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6519D5-A0C1-EADC-33D2-7FCC14AC6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8DA3A1-0795-B151-DC3B-A11A57A37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916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02750C-14AD-2C0E-952C-136FC2DF91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1CA291-CD69-5F71-93A2-95E6EC4D5F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68B648-8CF6-F6C2-7703-3F9C1B4313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02D3A4-53B8-4C5E-8745-ECD302E29D5E}" type="datetimeFigureOut">
              <a:rPr lang="en-GB" smtClean="0"/>
              <a:t>22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614AB3-9616-2643-15D8-9F1A211DF5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A76C3D-457B-D151-7CB9-2C399B0F87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567AD2-CEBE-45B6-BA76-A18F181194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0522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3.xml"/><Relationship Id="rId2" Type="http://schemas.openxmlformats.org/officeDocument/2006/relationships/diagramData" Target="../diagrams/data3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3.xml"/><Relationship Id="rId5" Type="http://schemas.openxmlformats.org/officeDocument/2006/relationships/diagramColors" Target="../diagrams/colors3.xml"/><Relationship Id="rId4" Type="http://schemas.openxmlformats.org/officeDocument/2006/relationships/diagramQuickStyle" Target="../diagrams/quickStyl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A37CED-6E0B-5C72-273F-BF4DF0EE1AE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F3477A3E-84A5-8A15-6205-F48AD94F498C}"/>
              </a:ext>
            </a:extLst>
          </p:cNvPr>
          <p:cNvSpPr/>
          <p:nvPr/>
        </p:nvSpPr>
        <p:spPr>
          <a:xfrm>
            <a:off x="80213" y="71634"/>
            <a:ext cx="5743409" cy="6714732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5D003C9-C525-7282-2738-58E2E3603733}"/>
              </a:ext>
            </a:extLst>
          </p:cNvPr>
          <p:cNvSpPr/>
          <p:nvPr/>
        </p:nvSpPr>
        <p:spPr>
          <a:xfrm>
            <a:off x="5967664" y="71634"/>
            <a:ext cx="5841331" cy="6714732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F138153-E211-948F-943B-EB96CF19F87A}"/>
              </a:ext>
            </a:extLst>
          </p:cNvPr>
          <p:cNvSpPr txBox="1"/>
          <p:nvPr/>
        </p:nvSpPr>
        <p:spPr>
          <a:xfrm>
            <a:off x="0" y="169778"/>
            <a:ext cx="5743409" cy="8438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2000"/>
              </a:lnSpc>
              <a:buNone/>
            </a:pPr>
            <a:r>
              <a:rPr lang="en-GB" sz="14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      101001─10101─1───1─1─101─0101101010010101010001  </a:t>
            </a:r>
            <a:br>
              <a:rPr lang="en-GB" sz="1400" b="0" i="0" dirty="0">
                <a:solidFill>
                  <a:srgbClr val="000000"/>
                </a:solidFill>
                <a:effectLst/>
                <a:latin typeface="Consolas" panose="020B0609020204030204" pitchFamily="49" charset="0"/>
              </a:rPr>
            </a:br>
            <a:r>
              <a:rPr lang="en-GB" sz="14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      ██████ █████ █   █ █ ███ █████ </a:t>
            </a:r>
            <a:br>
              <a:rPr lang="en-GB" sz="1400" b="0" i="0" dirty="0">
                <a:solidFill>
                  <a:srgbClr val="000000"/>
                </a:solidFill>
                <a:effectLst/>
                <a:latin typeface="Consolas" panose="020B0609020204030204" pitchFamily="49" charset="0"/>
              </a:rPr>
            </a:br>
            <a:r>
              <a:rPr lang="en-GB" sz="14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 11010101001010101010001010101001011─1111</a:t>
            </a:r>
            <a:endParaRPr lang="en-GB" sz="1400" dirty="0">
              <a:latin typeface="Consolas" panose="020B0609020204030204" pitchFamily="49" charset="0"/>
            </a:endParaRPr>
          </a:p>
        </p:txBody>
      </p:sp>
      <p:pic>
        <p:nvPicPr>
          <p:cNvPr id="9" name="Picture 8" descr="A colorful square with numbers&#10;&#10;AI-generated content may be incorrect.">
            <a:extLst>
              <a:ext uri="{FF2B5EF4-FFF2-40B4-BE49-F238E27FC236}">
                <a16:creationId xmlns:a16="http://schemas.microsoft.com/office/drawing/2014/main" id="{D1FDB396-C61F-DFD4-8FE8-FB96EEB89D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102" y="1283536"/>
            <a:ext cx="5337677" cy="5337677"/>
          </a:xfrm>
          <a:prstGeom prst="rect">
            <a:avLst/>
          </a:prstGeom>
        </p:spPr>
      </p:pic>
      <p:pic>
        <p:nvPicPr>
          <p:cNvPr id="11" name="Picture 10" descr="A colorful grid with numbers&#10;&#10;AI-generated content may be incorrect.">
            <a:extLst>
              <a:ext uri="{FF2B5EF4-FFF2-40B4-BE49-F238E27FC236}">
                <a16:creationId xmlns:a16="http://schemas.microsoft.com/office/drawing/2014/main" id="{9EB1AFBA-E6FD-E3AD-215A-12B1C99C71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4362" y="1283536"/>
            <a:ext cx="5337677" cy="533767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55EDA15-F2D2-D4B3-36B9-F9A970DECC54}"/>
              </a:ext>
            </a:extLst>
          </p:cNvPr>
          <p:cNvSpPr txBox="1"/>
          <p:nvPr/>
        </p:nvSpPr>
        <p:spPr>
          <a:xfrm>
            <a:off x="6234362" y="255675"/>
            <a:ext cx="5261811" cy="8438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2000"/>
              </a:lnSpc>
              <a:buNone/>
            </a:pPr>
            <a:r>
              <a:rPr lang="en-GB" sz="14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 10100110101─11110101011010100101010100─01 </a:t>
            </a:r>
          </a:p>
          <a:p>
            <a:pPr>
              <a:lnSpc>
                <a:spcPts val="2000"/>
              </a:lnSpc>
            </a:pPr>
            <a:r>
              <a:rPr lang="en-GB" sz="14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      ████</a:t>
            </a:r>
            <a:r>
              <a:rPr lang="en-GB" sz="1400" dirty="0">
                <a:solidFill>
                  <a:srgbClr val="505050"/>
                </a:solidFill>
                <a:latin typeface="Consolas" panose="020B0609020204030204" pitchFamily="49" charset="0"/>
              </a:rPr>
              <a:t>█</a:t>
            </a:r>
            <a:r>
              <a:rPr lang="en-GB" sz="14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█ █  ██████ ████ ███████████ ██</a:t>
            </a:r>
          </a:p>
          <a:p>
            <a:pPr algn="l">
              <a:lnSpc>
                <a:spcPts val="2000"/>
              </a:lnSpc>
              <a:buNone/>
            </a:pPr>
            <a:r>
              <a:rPr lang="en-GB" sz="14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      1101010100101010─1010─0010101010010111111</a:t>
            </a:r>
          </a:p>
        </p:txBody>
      </p:sp>
    </p:spTree>
    <p:extLst>
      <p:ext uri="{BB962C8B-B14F-4D97-AF65-F5344CB8AC3E}">
        <p14:creationId xmlns:p14="http://schemas.microsoft.com/office/powerpoint/2010/main" val="14989600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DE0CC09A-D64E-F213-BCF9-BE3E1941FB6D}"/>
              </a:ext>
            </a:extLst>
          </p:cNvPr>
          <p:cNvSpPr/>
          <p:nvPr/>
        </p:nvSpPr>
        <p:spPr>
          <a:xfrm>
            <a:off x="175846" y="56271"/>
            <a:ext cx="4883433" cy="6714732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5" name="Picture 4" descr="A colorful squares with numbers&#10;&#10;AI-generated content may be incorrect.">
            <a:extLst>
              <a:ext uri="{FF2B5EF4-FFF2-40B4-BE49-F238E27FC236}">
                <a16:creationId xmlns:a16="http://schemas.microsoft.com/office/drawing/2014/main" id="{5B75657B-6F32-7FD4-0C5D-2682F0DD99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4133" y="163431"/>
            <a:ext cx="6523120" cy="65231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CF5C34B-00BB-08C3-3DF8-95465A990534}"/>
              </a:ext>
            </a:extLst>
          </p:cNvPr>
          <p:cNvSpPr txBox="1"/>
          <p:nvPr/>
        </p:nvSpPr>
        <p:spPr>
          <a:xfrm>
            <a:off x="-20388" y="442285"/>
            <a:ext cx="5508793" cy="59734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4000"/>
              </a:lnSpc>
              <a:buNone/>
            </a:pPr>
            <a:r>
              <a:rPr lang="en-GB" sz="32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 01─01111101010110   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  █ █████ █████ ██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 11001111001010─10</a:t>
            </a:r>
            <a:endParaRPr lang="en-GB" sz="3200" dirty="0">
              <a:solidFill>
                <a:srgbClr val="505050"/>
              </a:solidFill>
              <a:latin typeface="Consolas" panose="020B0609020204030204" pitchFamily="49" charset="0"/>
            </a:endParaRPr>
          </a:p>
          <a:p>
            <a:pPr algn="l">
              <a:lnSpc>
                <a:spcPts val="4000"/>
              </a:lnSpc>
              <a:buNone/>
            </a:pPr>
            <a:endParaRPr lang="en-GB" sz="3200" dirty="0">
              <a:solidFill>
                <a:srgbClr val="505050"/>
              </a:solidFill>
              <a:latin typeface="Consolas" panose="020B0609020204030204" pitchFamily="49" charset="0"/>
            </a:endParaRP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S1=0101111101010110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S2=1100111100101010</a:t>
            </a:r>
          </a:p>
          <a:p>
            <a:pPr algn="l">
              <a:lnSpc>
                <a:spcPts val="4000"/>
              </a:lnSpc>
              <a:buNone/>
            </a:pPr>
            <a:endParaRPr lang="en-GB" sz="3200" dirty="0">
              <a:solidFill>
                <a:srgbClr val="505050"/>
              </a:solidFill>
              <a:latin typeface="Consolas" panose="020B0609020204030204" pitchFamily="49" charset="0"/>
            </a:endParaRPr>
          </a:p>
          <a:p>
            <a:pPr algn="l">
              <a:lnSpc>
                <a:spcPts val="4000"/>
              </a:lnSpc>
              <a:buNone/>
            </a:pPr>
            <a:endParaRPr lang="en-GB" sz="3200" dirty="0">
              <a:solidFill>
                <a:srgbClr val="505050"/>
              </a:solidFill>
              <a:latin typeface="Consolas" panose="020B0609020204030204" pitchFamily="49" charset="0"/>
            </a:endParaRP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░▒▓ Match= 10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░▒▓ Mismatch= -5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░▒▓ Gap= -7</a:t>
            </a:r>
          </a:p>
          <a:p>
            <a:pPr algn="l">
              <a:lnSpc>
                <a:spcPts val="2000"/>
              </a:lnSpc>
              <a:buNone/>
            </a:pPr>
            <a:endParaRPr lang="en-GB" sz="1400" dirty="0">
              <a:latin typeface="Consolas" panose="020B0609020204030204" pitchFamily="49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6A86610-604C-A8D9-974C-8A74D4A34848}"/>
              </a:ext>
            </a:extLst>
          </p:cNvPr>
          <p:cNvSpPr txBox="1"/>
          <p:nvPr/>
        </p:nvSpPr>
        <p:spPr>
          <a:xfrm>
            <a:off x="4156237" y="5954049"/>
            <a:ext cx="893472" cy="46166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algn="ctr"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pPr algn="l"/>
            <a:r>
              <a:rPr lang="en-GB" sz="44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(A)</a:t>
            </a:r>
          </a:p>
        </p:txBody>
      </p:sp>
    </p:spTree>
    <p:extLst>
      <p:ext uri="{BB962C8B-B14F-4D97-AF65-F5344CB8AC3E}">
        <p14:creationId xmlns:p14="http://schemas.microsoft.com/office/powerpoint/2010/main" val="33377568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DF3EC1-7B73-E9C6-EE70-FA3FCC6F76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93DB2E1-9BD9-FDA4-0F90-EA8F0377F9AD}"/>
              </a:ext>
            </a:extLst>
          </p:cNvPr>
          <p:cNvSpPr/>
          <p:nvPr/>
        </p:nvSpPr>
        <p:spPr>
          <a:xfrm>
            <a:off x="175847" y="54393"/>
            <a:ext cx="5525723" cy="6716610"/>
          </a:xfrm>
          <a:custGeom>
            <a:avLst/>
            <a:gdLst>
              <a:gd name="csX0" fmla="*/ 0 w 4991717"/>
              <a:gd name="csY0" fmla="*/ 0 h 6714732"/>
              <a:gd name="csX1" fmla="*/ 4991717 w 4991717"/>
              <a:gd name="csY1" fmla="*/ 0 h 6714732"/>
              <a:gd name="csX2" fmla="*/ 4991717 w 4991717"/>
              <a:gd name="csY2" fmla="*/ 6714732 h 6714732"/>
              <a:gd name="csX3" fmla="*/ 0 w 4991717"/>
              <a:gd name="csY3" fmla="*/ 6714732 h 6714732"/>
              <a:gd name="csX4" fmla="*/ 0 w 4991717"/>
              <a:gd name="csY4" fmla="*/ 0 h 6714732"/>
              <a:gd name="csX0" fmla="*/ 0 w 4991717"/>
              <a:gd name="csY0" fmla="*/ 0 h 6714732"/>
              <a:gd name="csX1" fmla="*/ 4991717 w 4991717"/>
              <a:gd name="csY1" fmla="*/ 0 h 6714732"/>
              <a:gd name="csX2" fmla="*/ 4985701 w 4991717"/>
              <a:gd name="csY2" fmla="*/ 659608 h 6714732"/>
              <a:gd name="csX3" fmla="*/ 4991717 w 4991717"/>
              <a:gd name="csY3" fmla="*/ 6714732 h 6714732"/>
              <a:gd name="csX4" fmla="*/ 0 w 4991717"/>
              <a:gd name="csY4" fmla="*/ 6714732 h 6714732"/>
              <a:gd name="csX5" fmla="*/ 0 w 4991717"/>
              <a:gd name="csY5" fmla="*/ 0 h 6714732"/>
              <a:gd name="csX0" fmla="*/ 0 w 5308552"/>
              <a:gd name="csY0" fmla="*/ 0 h 6714732"/>
              <a:gd name="csX1" fmla="*/ 4991717 w 5308552"/>
              <a:gd name="csY1" fmla="*/ 0 h 6714732"/>
              <a:gd name="csX2" fmla="*/ 4985701 w 5308552"/>
              <a:gd name="csY2" fmla="*/ 659608 h 6714732"/>
              <a:gd name="csX3" fmla="*/ 4991717 w 5308552"/>
              <a:gd name="csY3" fmla="*/ 6714732 h 6714732"/>
              <a:gd name="csX4" fmla="*/ 0 w 5308552"/>
              <a:gd name="csY4" fmla="*/ 6714732 h 6714732"/>
              <a:gd name="csX5" fmla="*/ 0 w 5308552"/>
              <a:gd name="csY5" fmla="*/ 0 h 6714732"/>
              <a:gd name="csX0" fmla="*/ 0 w 5525619"/>
              <a:gd name="csY0" fmla="*/ 0 h 6714732"/>
              <a:gd name="csX1" fmla="*/ 4991717 w 5525619"/>
              <a:gd name="csY1" fmla="*/ 0 h 6714732"/>
              <a:gd name="csX2" fmla="*/ 4985701 w 5525619"/>
              <a:gd name="csY2" fmla="*/ 659608 h 6714732"/>
              <a:gd name="csX3" fmla="*/ 4991717 w 5525619"/>
              <a:gd name="csY3" fmla="*/ 6714732 h 6714732"/>
              <a:gd name="csX4" fmla="*/ 0 w 5525619"/>
              <a:gd name="csY4" fmla="*/ 6714732 h 6714732"/>
              <a:gd name="csX5" fmla="*/ 0 w 5525619"/>
              <a:gd name="csY5" fmla="*/ 0 h 6714732"/>
              <a:gd name="csX0" fmla="*/ 0 w 5512151"/>
              <a:gd name="csY0" fmla="*/ 0 h 6714732"/>
              <a:gd name="csX1" fmla="*/ 4991717 w 5512151"/>
              <a:gd name="csY1" fmla="*/ 0 h 6714732"/>
              <a:gd name="csX2" fmla="*/ 4985701 w 5512151"/>
              <a:gd name="csY2" fmla="*/ 659608 h 6714732"/>
              <a:gd name="csX3" fmla="*/ 4991717 w 5512151"/>
              <a:gd name="csY3" fmla="*/ 6714732 h 6714732"/>
              <a:gd name="csX4" fmla="*/ 0 w 5512151"/>
              <a:gd name="csY4" fmla="*/ 6714732 h 6714732"/>
              <a:gd name="csX5" fmla="*/ 0 w 5512151"/>
              <a:gd name="csY5" fmla="*/ 0 h 6714732"/>
              <a:gd name="csX0" fmla="*/ 0 w 5516724"/>
              <a:gd name="csY0" fmla="*/ 239 h 6714971"/>
              <a:gd name="csX1" fmla="*/ 4991717 w 5516724"/>
              <a:gd name="csY1" fmla="*/ 239 h 6714971"/>
              <a:gd name="csX2" fmla="*/ 4985701 w 5516724"/>
              <a:gd name="csY2" fmla="*/ 659847 h 6714971"/>
              <a:gd name="csX3" fmla="*/ 4991717 w 5516724"/>
              <a:gd name="csY3" fmla="*/ 6714971 h 6714971"/>
              <a:gd name="csX4" fmla="*/ 0 w 5516724"/>
              <a:gd name="csY4" fmla="*/ 6714971 h 6714971"/>
              <a:gd name="csX5" fmla="*/ 0 w 5516724"/>
              <a:gd name="csY5" fmla="*/ 239 h 6714971"/>
              <a:gd name="csX0" fmla="*/ 0 w 5536904"/>
              <a:gd name="csY0" fmla="*/ 222 h 6714954"/>
              <a:gd name="csX1" fmla="*/ 4991717 w 5536904"/>
              <a:gd name="csY1" fmla="*/ 222 h 6714954"/>
              <a:gd name="csX2" fmla="*/ 4985701 w 5536904"/>
              <a:gd name="csY2" fmla="*/ 659830 h 6714954"/>
              <a:gd name="csX3" fmla="*/ 4991717 w 5536904"/>
              <a:gd name="csY3" fmla="*/ 6714954 h 6714954"/>
              <a:gd name="csX4" fmla="*/ 0 w 5536904"/>
              <a:gd name="csY4" fmla="*/ 6714954 h 6714954"/>
              <a:gd name="csX5" fmla="*/ 0 w 5536904"/>
              <a:gd name="csY5" fmla="*/ 222 h 6714954"/>
              <a:gd name="csX0" fmla="*/ 0 w 5525723"/>
              <a:gd name="csY0" fmla="*/ 1920 h 6716652"/>
              <a:gd name="csX1" fmla="*/ 4991717 w 5525723"/>
              <a:gd name="csY1" fmla="*/ 1920 h 6716652"/>
              <a:gd name="csX2" fmla="*/ 4985701 w 5525723"/>
              <a:gd name="csY2" fmla="*/ 661528 h 6716652"/>
              <a:gd name="csX3" fmla="*/ 4991717 w 5525723"/>
              <a:gd name="csY3" fmla="*/ 6716652 h 6716652"/>
              <a:gd name="csX4" fmla="*/ 0 w 5525723"/>
              <a:gd name="csY4" fmla="*/ 6716652 h 6716652"/>
              <a:gd name="csX5" fmla="*/ 0 w 5525723"/>
              <a:gd name="csY5" fmla="*/ 1920 h 6716652"/>
              <a:gd name="csX0" fmla="*/ 0 w 5525723"/>
              <a:gd name="csY0" fmla="*/ 1878 h 6716610"/>
              <a:gd name="csX1" fmla="*/ 4991717 w 5525723"/>
              <a:gd name="csY1" fmla="*/ 1878 h 6716610"/>
              <a:gd name="csX2" fmla="*/ 4985701 w 5525723"/>
              <a:gd name="csY2" fmla="*/ 679534 h 6716610"/>
              <a:gd name="csX3" fmla="*/ 4991717 w 5525723"/>
              <a:gd name="csY3" fmla="*/ 6716610 h 6716610"/>
              <a:gd name="csX4" fmla="*/ 0 w 5525723"/>
              <a:gd name="csY4" fmla="*/ 6716610 h 6716610"/>
              <a:gd name="csX5" fmla="*/ 0 w 5525723"/>
              <a:gd name="csY5" fmla="*/ 1878 h 6716610"/>
            </a:gdLst>
            <a:ahLst/>
            <a:cxnLst>
              <a:cxn ang="0">
                <a:pos x="csX0" y="csY0"/>
              </a:cxn>
              <a:cxn ang="0">
                <a:pos x="csX1" y="csY1"/>
              </a:cxn>
              <a:cxn ang="0">
                <a:pos x="csX2" y="csY2"/>
              </a:cxn>
              <a:cxn ang="0">
                <a:pos x="csX3" y="csY3"/>
              </a:cxn>
              <a:cxn ang="0">
                <a:pos x="csX4" y="csY4"/>
              </a:cxn>
              <a:cxn ang="0">
                <a:pos x="csX5" y="csY5"/>
              </a:cxn>
            </a:cxnLst>
            <a:rect l="l" t="t" r="r" b="b"/>
            <a:pathLst>
              <a:path w="5525723" h="6716610">
                <a:moveTo>
                  <a:pt x="0" y="1878"/>
                </a:moveTo>
                <a:lnTo>
                  <a:pt x="4991717" y="1878"/>
                </a:lnTo>
                <a:cubicBezTo>
                  <a:pt x="5681528" y="-42948"/>
                  <a:pt x="5727648" y="730375"/>
                  <a:pt x="4985701" y="679534"/>
                </a:cubicBezTo>
                <a:cubicBezTo>
                  <a:pt x="4987706" y="2697909"/>
                  <a:pt x="4989712" y="4698235"/>
                  <a:pt x="4991717" y="6716610"/>
                </a:cubicBezTo>
                <a:lnTo>
                  <a:pt x="0" y="6716610"/>
                </a:lnTo>
                <a:lnTo>
                  <a:pt x="0" y="1878"/>
                </a:lnTo>
                <a:close/>
              </a:path>
            </a:pathLst>
          </a:cu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4609B65-2D66-FF10-FA3F-A52FFD43385E}"/>
              </a:ext>
            </a:extLst>
          </p:cNvPr>
          <p:cNvSpPr txBox="1"/>
          <p:nvPr/>
        </p:nvSpPr>
        <p:spPr>
          <a:xfrm>
            <a:off x="136023" y="164431"/>
            <a:ext cx="5508793" cy="59734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4000"/>
              </a:lnSpc>
              <a:buNone/>
            </a:pPr>
            <a:r>
              <a:rPr lang="en-GB" sz="32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 01─0─111──1─101─010110   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 █ █ ███  █ ███ 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 1100111100101010 </a:t>
            </a:r>
          </a:p>
          <a:p>
            <a:pPr algn="l">
              <a:lnSpc>
                <a:spcPts val="4000"/>
              </a:lnSpc>
              <a:buNone/>
            </a:pPr>
            <a:endParaRPr lang="en-GB" sz="3200" dirty="0">
              <a:solidFill>
                <a:srgbClr val="505050"/>
              </a:solidFill>
              <a:latin typeface="Consolas" panose="020B0609020204030204" pitchFamily="49" charset="0"/>
            </a:endParaRP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S1=0101111101010110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S2=1100111100101010</a:t>
            </a:r>
          </a:p>
          <a:p>
            <a:pPr algn="l">
              <a:lnSpc>
                <a:spcPts val="4000"/>
              </a:lnSpc>
              <a:buNone/>
            </a:pPr>
            <a:endParaRPr lang="en-GB" sz="3200" dirty="0">
              <a:solidFill>
                <a:srgbClr val="505050"/>
              </a:solidFill>
              <a:latin typeface="Consolas" panose="020B0609020204030204" pitchFamily="49" charset="0"/>
            </a:endParaRPr>
          </a:p>
          <a:p>
            <a:pPr algn="l">
              <a:lnSpc>
                <a:spcPts val="4000"/>
              </a:lnSpc>
              <a:buNone/>
            </a:pPr>
            <a:endParaRPr lang="en-GB" sz="3200" dirty="0">
              <a:solidFill>
                <a:srgbClr val="505050"/>
              </a:solidFill>
              <a:latin typeface="Consolas" panose="020B0609020204030204" pitchFamily="49" charset="0"/>
            </a:endParaRP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░▒▓ Match= 10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░▒▓ Mismatch= -5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dirty="0">
                <a:solidFill>
                  <a:srgbClr val="505050"/>
                </a:solidFill>
                <a:latin typeface="Consolas" panose="020B0609020204030204" pitchFamily="49" charset="0"/>
              </a:rPr>
              <a:t>  ░▒▓ Gap= -7</a:t>
            </a:r>
          </a:p>
          <a:p>
            <a:pPr algn="l">
              <a:lnSpc>
                <a:spcPts val="2000"/>
              </a:lnSpc>
              <a:buNone/>
            </a:pPr>
            <a:endParaRPr lang="en-GB" sz="1400" dirty="0">
              <a:latin typeface="Consolas" panose="020B0609020204030204" pitchFamily="49" charset="0"/>
            </a:endParaRPr>
          </a:p>
        </p:txBody>
      </p:sp>
      <p:pic>
        <p:nvPicPr>
          <p:cNvPr id="3" name="Picture 2" descr="A colorful squares with numbers&#10;&#10;AI-generated content may be incorrect.">
            <a:extLst>
              <a:ext uri="{FF2B5EF4-FFF2-40B4-BE49-F238E27FC236}">
                <a16:creationId xmlns:a16="http://schemas.microsoft.com/office/drawing/2014/main" id="{985123DB-4574-0789-27AA-2773395697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0149" y="212559"/>
            <a:ext cx="6529137" cy="652913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BF57BB5-DF5C-3248-FC0B-8F3E88827C38}"/>
              </a:ext>
            </a:extLst>
          </p:cNvPr>
          <p:cNvSpPr txBox="1"/>
          <p:nvPr/>
        </p:nvSpPr>
        <p:spPr>
          <a:xfrm>
            <a:off x="4156237" y="5954049"/>
            <a:ext cx="893472" cy="46166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algn="ctr"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pPr algn="l"/>
            <a:r>
              <a:rPr lang="en-GB" sz="44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22302648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1BA0E9-50FE-9449-8985-490780AEF2E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8E582C0-8797-7790-F1D5-10DCF51FF611}"/>
              </a:ext>
            </a:extLst>
          </p:cNvPr>
          <p:cNvSpPr txBox="1"/>
          <p:nvPr/>
        </p:nvSpPr>
        <p:spPr>
          <a:xfrm>
            <a:off x="378995" y="442285"/>
            <a:ext cx="11683975" cy="39215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4000"/>
              </a:lnSpc>
              <a:buNone/>
            </a:pPr>
            <a:r>
              <a:rPr lang="en-GB" sz="28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S1=CCUGCAACUUAGGCAGG</a:t>
            </a:r>
          </a:p>
          <a:p>
            <a:pPr algn="l">
              <a:lnSpc>
                <a:spcPts val="4000"/>
              </a:lnSpc>
              <a:buNone/>
            </a:pPr>
            <a:r>
              <a:rPr lang="en-GB" sz="28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S2=AAGCCAAGCCAAGCCAAGCCGGACGUUGAAUCCGUCCCCCCCAA</a:t>
            </a:r>
          </a:p>
          <a:p>
            <a:pPr algn="l">
              <a:lnSpc>
                <a:spcPts val="4000"/>
              </a:lnSpc>
              <a:buNone/>
            </a:pPr>
            <a:endParaRPr lang="en-GB" sz="3200" b="0" i="0" dirty="0">
              <a:solidFill>
                <a:srgbClr val="505050"/>
              </a:solidFill>
              <a:effectLst/>
              <a:latin typeface="Consolas" panose="020B0609020204030204" pitchFamily="49" charset="0"/>
            </a:endParaRPr>
          </a:p>
          <a:p>
            <a:pPr algn="l">
              <a:lnSpc>
                <a:spcPts val="4000"/>
              </a:lnSpc>
              <a:buNone/>
            </a:pPr>
            <a:endParaRPr lang="en-GB" sz="3200" b="0" i="0" dirty="0">
              <a:solidFill>
                <a:srgbClr val="505050"/>
              </a:solidFill>
              <a:effectLst/>
              <a:latin typeface="Consolas" panose="020B0609020204030204" pitchFamily="49" charset="0"/>
            </a:endParaRPr>
          </a:p>
          <a:p>
            <a:pPr algn="l">
              <a:lnSpc>
                <a:spcPts val="4000"/>
              </a:lnSpc>
              <a:buNone/>
            </a:pPr>
            <a:r>
              <a:rPr lang="en-GB" sz="32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                                 ░▒▓ Match    = +2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                                 ░▒▓ Mismatch = -1</a:t>
            </a:r>
          </a:p>
          <a:p>
            <a:pPr algn="l">
              <a:lnSpc>
                <a:spcPts val="4000"/>
              </a:lnSpc>
              <a:buNone/>
            </a:pPr>
            <a:r>
              <a:rPr lang="en-GB" sz="3200" b="0" i="0" dirty="0">
                <a:solidFill>
                  <a:srgbClr val="505050"/>
                </a:solidFill>
                <a:effectLst/>
                <a:latin typeface="Consolas" panose="020B0609020204030204" pitchFamily="49" charset="0"/>
              </a:rPr>
              <a:t>                                 ░▒▓ Gap      = -2</a:t>
            </a:r>
          </a:p>
          <a:p>
            <a:pPr algn="l">
              <a:lnSpc>
                <a:spcPts val="2000"/>
              </a:lnSpc>
              <a:buNone/>
            </a:pPr>
            <a:endParaRPr lang="en-GB" sz="1400" dirty="0">
              <a:latin typeface="Consolas" panose="020B0609020204030204" pitchFamily="49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2702D6C-675F-F97D-A8FA-B5AD330D92CD}"/>
              </a:ext>
            </a:extLst>
          </p:cNvPr>
          <p:cNvSpPr/>
          <p:nvPr/>
        </p:nvSpPr>
        <p:spPr>
          <a:xfrm>
            <a:off x="7421479" y="1903368"/>
            <a:ext cx="4641491" cy="2731932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E84D9D0-C1FA-CA9B-7C2A-F2415146E316}"/>
              </a:ext>
            </a:extLst>
          </p:cNvPr>
          <p:cNvSpPr/>
          <p:nvPr/>
        </p:nvSpPr>
        <p:spPr>
          <a:xfrm>
            <a:off x="129030" y="277479"/>
            <a:ext cx="11933940" cy="1461083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3F52C45-0C06-1E43-B851-153AAE71BF56}"/>
              </a:ext>
            </a:extLst>
          </p:cNvPr>
          <p:cNvSpPr txBox="1"/>
          <p:nvPr/>
        </p:nvSpPr>
        <p:spPr>
          <a:xfrm>
            <a:off x="10572117" y="623299"/>
            <a:ext cx="933952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4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65000"/>
                    <a:lumOff val="35000"/>
                  </a:prst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(A)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pic>
        <p:nvPicPr>
          <p:cNvPr id="11" name="Picture 10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FC328140-3A9F-30BC-DF0E-28514C1971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854" y="2064855"/>
            <a:ext cx="6867014" cy="283801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8C5AF54-750F-54C0-7C36-1F7308E11B80}"/>
              </a:ext>
            </a:extLst>
          </p:cNvPr>
          <p:cNvSpPr txBox="1"/>
          <p:nvPr/>
        </p:nvSpPr>
        <p:spPr>
          <a:xfrm>
            <a:off x="6413021" y="2884613"/>
            <a:ext cx="933952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4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65000"/>
                    <a:lumOff val="35000"/>
                  </a:prst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(B)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E96B2F29-06B3-DC0B-9B48-A0AB3B16BF9C}"/>
              </a:ext>
            </a:extLst>
          </p:cNvPr>
          <p:cNvSpPr/>
          <p:nvPr/>
        </p:nvSpPr>
        <p:spPr>
          <a:xfrm>
            <a:off x="113253" y="1903368"/>
            <a:ext cx="6049803" cy="2731932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6994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9263AF-E68C-92DB-F00F-2A2F79486D2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BC04CCF0-CDB1-EA6D-8731-508262C8F8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4828" y="1457106"/>
            <a:ext cx="11209759" cy="4632798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5484C38F-F575-74E0-9189-87C54C2578AF}"/>
              </a:ext>
            </a:extLst>
          </p:cNvPr>
          <p:cNvSpPr/>
          <p:nvPr/>
        </p:nvSpPr>
        <p:spPr>
          <a:xfrm>
            <a:off x="699271" y="1244036"/>
            <a:ext cx="9828521" cy="4309419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25941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6879FAA-6263-24B8-61B4-C2F598830EE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7D548ED2-F86F-C384-0269-EBCF5FE639AA}"/>
              </a:ext>
            </a:extLst>
          </p:cNvPr>
          <p:cNvSpPr/>
          <p:nvPr/>
        </p:nvSpPr>
        <p:spPr>
          <a:xfrm>
            <a:off x="193892" y="2443307"/>
            <a:ext cx="10436007" cy="1691548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91774F8-5098-28E4-6F36-C8EE02C59A1D}"/>
              </a:ext>
            </a:extLst>
          </p:cNvPr>
          <p:cNvSpPr/>
          <p:nvPr/>
        </p:nvSpPr>
        <p:spPr>
          <a:xfrm>
            <a:off x="193893" y="438044"/>
            <a:ext cx="10436007" cy="1691548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BCF4A20-22B8-6131-94E6-88A5BA126F6A}"/>
              </a:ext>
            </a:extLst>
          </p:cNvPr>
          <p:cNvSpPr txBox="1"/>
          <p:nvPr/>
        </p:nvSpPr>
        <p:spPr>
          <a:xfrm>
            <a:off x="11076187" y="899097"/>
            <a:ext cx="933952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4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65000"/>
                    <a:lumOff val="35000"/>
                  </a:prst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(C)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8251F4-46ED-5CE6-719B-909853C62A99}"/>
              </a:ext>
            </a:extLst>
          </p:cNvPr>
          <p:cNvSpPr txBox="1"/>
          <p:nvPr/>
        </p:nvSpPr>
        <p:spPr>
          <a:xfrm>
            <a:off x="11076187" y="2943747"/>
            <a:ext cx="933952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4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65000"/>
                    <a:lumOff val="35000"/>
                  </a:prst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(D)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677FCF7A-3312-A2DC-897E-38F58F5E94BE}"/>
              </a:ext>
            </a:extLst>
          </p:cNvPr>
          <p:cNvSpPr/>
          <p:nvPr/>
        </p:nvSpPr>
        <p:spPr>
          <a:xfrm>
            <a:off x="193892" y="4492975"/>
            <a:ext cx="10436007" cy="1691548"/>
          </a:xfrm>
          <a:prstGeom prst="rect">
            <a:avLst/>
          </a:prstGeom>
          <a:solidFill>
            <a:schemeClr val="accent3">
              <a:alpha val="10000"/>
            </a:schemeClr>
          </a:solidFill>
          <a:ln w="38100">
            <a:solidFill>
              <a:schemeClr val="tx1">
                <a:lumMod val="65000"/>
                <a:lumOff val="35000"/>
              </a:schemeClr>
            </a:solidFill>
            <a:prstDash val="sysDash"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2080C9F-A66C-F265-AEB2-A7AA8CFAED60}"/>
              </a:ext>
            </a:extLst>
          </p:cNvPr>
          <p:cNvSpPr txBox="1"/>
          <p:nvPr/>
        </p:nvSpPr>
        <p:spPr>
          <a:xfrm>
            <a:off x="11076187" y="4954028"/>
            <a:ext cx="933952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4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65000"/>
                    <a:lumOff val="35000"/>
                  </a:prst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(E)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F479E41-BC9E-A67D-5425-E30729411A7F}"/>
              </a:ext>
            </a:extLst>
          </p:cNvPr>
          <p:cNvSpPr txBox="1"/>
          <p:nvPr/>
        </p:nvSpPr>
        <p:spPr>
          <a:xfrm>
            <a:off x="391027" y="472366"/>
            <a:ext cx="11291637" cy="57122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3200" b="0" i="0" u="none" strike="noStrike" kern="1200" cap="none" spc="0" normalizeH="0" baseline="0" noProof="0" dirty="0">
                <a:ln>
                  <a:noFill/>
                </a:ln>
                <a:solidFill>
                  <a:srgbClr val="505050"/>
                </a:solidFill>
                <a:effectLst/>
                <a:uLnTx/>
                <a:uFillTx/>
                <a:latin typeface="Consolas" panose="020B0609020204030204" pitchFamily="49" charset="0"/>
                <a:ea typeface="+mn-ea"/>
                <a:cs typeface="+mn-cs"/>
              </a:rPr>
              <a:t>---CC-UG-CAA-CUUA---GG-C-----A---G---------G</a:t>
            </a: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3200" b="0" i="0" u="none" strike="noStrike" kern="1200" cap="none" spc="0" normalizeH="0" baseline="0" noProof="0" dirty="0">
                <a:ln>
                  <a:noFill/>
                </a:ln>
                <a:solidFill>
                  <a:srgbClr val="505050"/>
                </a:solidFill>
                <a:effectLst/>
                <a:uLnTx/>
                <a:uFillTx/>
                <a:latin typeface="Consolas" panose="020B0609020204030204" pitchFamily="49" charset="0"/>
                <a:ea typeface="+mn-ea"/>
                <a:cs typeface="+mn-cs"/>
              </a:rPr>
              <a:t>   ||  | ||| |  |   || |     |   |          </a:t>
            </a: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3200" b="0" i="0" u="none" strike="noStrike" kern="1200" cap="none" spc="0" normalizeH="0" baseline="0" noProof="0" dirty="0">
                <a:ln>
                  <a:noFill/>
                </a:ln>
                <a:solidFill>
                  <a:srgbClr val="505050"/>
                </a:solidFill>
                <a:effectLst/>
                <a:uLnTx/>
                <a:uFillTx/>
                <a:latin typeface="Consolas" panose="020B0609020204030204" pitchFamily="49" charset="0"/>
                <a:ea typeface="+mn-ea"/>
                <a:cs typeface="+mn-cs"/>
              </a:rPr>
              <a:t>AAGCCAAGCCAAGCCAAGCCGGACGUUGAAUCCGUCCCCCCCAA</a:t>
            </a: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3200" dirty="0">
              <a:solidFill>
                <a:srgbClr val="505050"/>
              </a:solidFill>
              <a:latin typeface="Consolas" panose="020B06090202040302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3200" b="0" i="0" u="none" strike="noStrike" kern="1200" cap="none" spc="0" normalizeH="0" baseline="0" noProof="0" dirty="0">
                <a:ln>
                  <a:noFill/>
                </a:ln>
                <a:solidFill>
                  <a:srgbClr val="505050"/>
                </a:solidFill>
                <a:effectLst/>
                <a:uLnTx/>
                <a:uFillTx/>
                <a:latin typeface="Consolas" panose="020B0609020204030204" pitchFamily="49" charset="0"/>
                <a:ea typeface="+mn-ea"/>
                <a:cs typeface="+mn-cs"/>
              </a:rPr>
              <a:t>CCUGCAA─CUUAGGCAGG   </a:t>
            </a: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3200" b="0" i="0" u="none" strike="noStrike" kern="1200" cap="none" spc="0" normalizeH="0" baseline="0" noProof="0" dirty="0">
                <a:ln>
                  <a:noFill/>
                </a:ln>
                <a:solidFill>
                  <a:srgbClr val="505050"/>
                </a:solidFill>
                <a:effectLst/>
                <a:uLnTx/>
                <a:uFillTx/>
                <a:latin typeface="Consolas" panose="020B0609020204030204" pitchFamily="49" charset="0"/>
                <a:ea typeface="+mn-ea"/>
                <a:cs typeface="+mn-cs"/>
              </a:rPr>
              <a:t>    ||| |  || || |</a:t>
            </a: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3200" b="0" i="0" u="none" strike="noStrike" kern="1200" cap="none" spc="0" normalizeH="0" baseline="0" noProof="0" dirty="0">
                <a:ln>
                  <a:noFill/>
                </a:ln>
                <a:solidFill>
                  <a:srgbClr val="505050"/>
                </a:solidFill>
                <a:effectLst/>
                <a:uLnTx/>
                <a:uFillTx/>
                <a:latin typeface="Consolas" panose="020B0609020204030204" pitchFamily="49" charset="0"/>
                <a:ea typeface="+mn-ea"/>
                <a:cs typeface="+mn-cs"/>
              </a:rPr>
              <a:t>AAGCCAAGCCAAGCCAAGCCGGACGUUGAAUCCGUCCCCCCCAA</a:t>
            </a: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3200" dirty="0">
              <a:solidFill>
                <a:srgbClr val="505050"/>
              </a:solidFill>
              <a:latin typeface="Consolas" panose="020B0609020204030204" pitchFamily="49" charset="0"/>
            </a:endParaRP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3200" b="0" i="0" u="none" strike="noStrike" kern="1200" cap="none" spc="0" normalizeH="0" baseline="0" noProof="0" dirty="0">
                <a:ln>
                  <a:noFill/>
                </a:ln>
                <a:solidFill>
                  <a:srgbClr val="505050"/>
                </a:solidFill>
                <a:effectLst/>
                <a:uLnTx/>
                <a:uFillTx/>
                <a:latin typeface="Consolas" panose="020B0609020204030204" pitchFamily="49" charset="0"/>
                <a:ea typeface="+mn-ea"/>
                <a:cs typeface="+mn-cs"/>
              </a:rPr>
              <a:t>                    CCUGCAACUUAGGCAGG</a:t>
            </a: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3200" b="0" i="0" u="none" strike="noStrike" kern="1200" cap="none" spc="0" normalizeH="0" baseline="0" noProof="0" dirty="0">
                <a:ln>
                  <a:noFill/>
                </a:ln>
                <a:solidFill>
                  <a:srgbClr val="505050"/>
                </a:solidFill>
                <a:effectLst/>
                <a:uLnTx/>
                <a:uFillTx/>
                <a:latin typeface="Consolas" panose="020B0609020204030204" pitchFamily="49" charset="0"/>
                <a:ea typeface="+mn-ea"/>
                <a:cs typeface="+mn-cs"/>
              </a:rPr>
              <a:t>                    |||||||||||||||||</a:t>
            </a:r>
          </a:p>
          <a:p>
            <a:pPr marL="0" marR="0" lvl="0" indent="0" algn="l" defTabSz="914400" rtl="0" eaLnBrk="1" fontAlgn="auto" latinLnBrk="0" hangingPunct="1">
              <a:lnSpc>
                <a:spcPts val="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3200" b="0" i="0" u="none" strike="noStrike" kern="1200" cap="none" spc="0" normalizeH="0" baseline="0" noProof="0" dirty="0">
                <a:ln>
                  <a:noFill/>
                </a:ln>
                <a:solidFill>
                  <a:srgbClr val="505050"/>
                </a:solidFill>
                <a:effectLst/>
                <a:uLnTx/>
                <a:uFillTx/>
                <a:latin typeface="Consolas" panose="020B0609020204030204" pitchFamily="49" charset="0"/>
                <a:ea typeface="+mn-ea"/>
                <a:cs typeface="+mn-cs"/>
              </a:rPr>
              <a:t>AAGCCAAGCCAAGCCAAGCCGGACGUUGAAUCCGUCCCCCCCAA</a:t>
            </a:r>
          </a:p>
        </p:txBody>
      </p:sp>
    </p:spTree>
    <p:extLst>
      <p:ext uri="{BB962C8B-B14F-4D97-AF65-F5344CB8AC3E}">
        <p14:creationId xmlns:p14="http://schemas.microsoft.com/office/powerpoint/2010/main" val="12871272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40224148-873F-C8AD-B746-62A880001BF6}"/>
              </a:ext>
            </a:extLst>
          </p:cNvPr>
          <p:cNvGraphicFramePr/>
          <p:nvPr/>
        </p:nvGraphicFramePr>
        <p:xfrm>
          <a:off x="2032000" y="719666"/>
          <a:ext cx="8128000" cy="541866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42666774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A39EBE9-FB2C-39B0-B3BB-A60F0DAB803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C05A02C3-658D-D35E-4E31-DF85442DE444}"/>
              </a:ext>
            </a:extLst>
          </p:cNvPr>
          <p:cNvGraphicFramePr/>
          <p:nvPr/>
        </p:nvGraphicFramePr>
        <p:xfrm>
          <a:off x="2032000" y="719666"/>
          <a:ext cx="8128000" cy="541866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8735276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5C443E-54AB-835C-43B4-BA5513F9EB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C3D209D4-EF47-EC45-3FA8-D51EF9FD0746}"/>
              </a:ext>
            </a:extLst>
          </p:cNvPr>
          <p:cNvGraphicFramePr/>
          <p:nvPr/>
        </p:nvGraphicFramePr>
        <p:xfrm>
          <a:off x="2032000" y="719666"/>
          <a:ext cx="8128000" cy="541866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066156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308</Words>
  <Application>Microsoft Office PowerPoint</Application>
  <PresentationFormat>Widescreen</PresentationFormat>
  <Paragraphs>87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Consola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ul Gagniuc</dc:creator>
  <cp:lastModifiedBy>Paul Gagniuc</cp:lastModifiedBy>
  <cp:revision>21</cp:revision>
  <dcterms:created xsi:type="dcterms:W3CDTF">2025-12-17T23:24:05Z</dcterms:created>
  <dcterms:modified xsi:type="dcterms:W3CDTF">2026-02-22T20:39:43Z</dcterms:modified>
</cp:coreProperties>
</file>